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2"/>
  </p:notesMasterIdLst>
  <p:sldIdLst>
    <p:sldId id="257" r:id="rId2"/>
    <p:sldId id="268" r:id="rId3"/>
    <p:sldId id="270" r:id="rId4"/>
    <p:sldId id="293" r:id="rId5"/>
    <p:sldId id="259" r:id="rId6"/>
    <p:sldId id="291" r:id="rId7"/>
    <p:sldId id="273" r:id="rId8"/>
    <p:sldId id="292" r:id="rId9"/>
    <p:sldId id="304" r:id="rId10"/>
    <p:sldId id="305" r:id="rId11"/>
    <p:sldId id="306" r:id="rId12"/>
    <p:sldId id="262" r:id="rId13"/>
    <p:sldId id="314" r:id="rId14"/>
    <p:sldId id="315" r:id="rId15"/>
    <p:sldId id="316" r:id="rId16"/>
    <p:sldId id="317" r:id="rId17"/>
    <p:sldId id="321" r:id="rId18"/>
    <p:sldId id="322" r:id="rId19"/>
    <p:sldId id="323" r:id="rId20"/>
    <p:sldId id="324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10"/>
  </p:normalViewPr>
  <p:slideViewPr>
    <p:cSldViewPr snapToGrid="0" snapToObjects="1">
      <p:cViewPr varScale="1">
        <p:scale>
          <a:sx n="65" d="100"/>
          <a:sy n="65" d="100"/>
        </p:scale>
        <p:origin x="78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2B0BF4-CE15-0C43-A32F-E5AB905177D7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9847A8-6FBF-FB47-AFEE-2D8FD9D2D9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0302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00569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25440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310991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l Fig 6. </a:t>
            </a:r>
            <a:r>
              <a:rPr lang="en-US" b="0" dirty="0"/>
              <a:t>Combined</a:t>
            </a:r>
            <a:r>
              <a:rPr lang="en-US" b="1" dirty="0"/>
              <a:t> </a:t>
            </a:r>
            <a:r>
              <a:rPr lang="en-US" b="0" dirty="0" err="1"/>
              <a:t>tSNE</a:t>
            </a:r>
            <a:r>
              <a:rPr lang="en-US" b="0" dirty="0"/>
              <a:t> maps for </a:t>
            </a:r>
            <a:r>
              <a:rPr lang="en-US" b="1" dirty="0"/>
              <a:t>A</a:t>
            </a:r>
            <a:r>
              <a:rPr lang="en-US" b="0" dirty="0"/>
              <a:t>. CD8+CD69+ TEM and </a:t>
            </a:r>
            <a:r>
              <a:rPr lang="en-US" b="1" dirty="0"/>
              <a:t>B. </a:t>
            </a:r>
            <a:r>
              <a:rPr lang="en-US" b="0" dirty="0"/>
              <a:t>CD8+CD69+ TEMRA generated from thirty-one Ty21a recipients, pre- and post-vaccination, following unsupervised clustering with </a:t>
            </a:r>
            <a:r>
              <a:rPr lang="en-US" b="0" dirty="0" err="1"/>
              <a:t>ClusterX</a:t>
            </a:r>
            <a:r>
              <a:rPr lang="en-US" b="0" dirty="0"/>
              <a:t>. </a:t>
            </a:r>
            <a:r>
              <a:rPr lang="en-US" b="0" dirty="0" err="1"/>
              <a:t>tSNE</a:t>
            </a:r>
            <a:r>
              <a:rPr lang="en-US" b="0" dirty="0"/>
              <a:t> and clustering algorithms were run using </a:t>
            </a:r>
            <a:r>
              <a:rPr lang="en-US" b="0" dirty="0" err="1"/>
              <a:t>Cytofkit</a:t>
            </a:r>
            <a:r>
              <a:rPr lang="en-US" b="0" dirty="0"/>
              <a:t> (Chen 2016). 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777075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 4: </a:t>
            </a:r>
            <a:r>
              <a:rPr lang="en-US" dirty="0" err="1"/>
              <a:t>tSNE</a:t>
            </a:r>
            <a:r>
              <a:rPr lang="en-US" baseline="0" dirty="0"/>
              <a:t> Overview separated by age and pre/post-</a:t>
            </a:r>
            <a:r>
              <a:rPr lang="en-US" baseline="0" dirty="0" err="1"/>
              <a:t>vacc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344730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 4: </a:t>
            </a:r>
            <a:r>
              <a:rPr lang="en-US" dirty="0" err="1"/>
              <a:t>tSNE</a:t>
            </a:r>
            <a:r>
              <a:rPr lang="en-US" baseline="0" dirty="0"/>
              <a:t> Overview separated by age and pre/post-</a:t>
            </a:r>
            <a:r>
              <a:rPr lang="en-US" baseline="0" dirty="0" err="1"/>
              <a:t>vacc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301967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842625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 4: </a:t>
            </a:r>
            <a:r>
              <a:rPr lang="en-US" dirty="0" err="1"/>
              <a:t>tSNE</a:t>
            </a:r>
            <a:r>
              <a:rPr lang="en-US" baseline="0" dirty="0"/>
              <a:t> Overview separated by age and pre/post-</a:t>
            </a:r>
            <a:r>
              <a:rPr lang="en-US" baseline="0" dirty="0" err="1"/>
              <a:t>vacc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1695736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 4: </a:t>
            </a:r>
            <a:r>
              <a:rPr lang="en-US" dirty="0" err="1"/>
              <a:t>tSNE</a:t>
            </a:r>
            <a:r>
              <a:rPr lang="en-US" baseline="0" dirty="0"/>
              <a:t> Overview separated by age and pre/post-</a:t>
            </a:r>
            <a:r>
              <a:rPr lang="en-US" baseline="0" dirty="0" err="1"/>
              <a:t>vacc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4591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7590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88347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2349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Supplemental Fig 3. CD8+ T Effector Memory Response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Scatter plots showing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A+D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the response over baseline percentages of CD8+ TEM producing MIP1β, CD107a, TNFα, IL-2, IL-17A, IFN𝛾, and Granzyme B (</a:t>
            </a:r>
            <a:r>
              <a:rPr lang="en-US" sz="1200" baseline="0" dirty="0" err="1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);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B+E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CD8+ TEM observed mono-, bi-, tri-, and &gt;3-functional populations, and;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C+F. </a:t>
            </a:r>
            <a:r>
              <a:rPr lang="en-US" sz="1200" b="0" baseline="0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CD8+CD69+ TEM multifunctional responses, shown in a previous </a:t>
            </a:r>
            <a:r>
              <a:rPr lang="en-US" sz="1200" i="1" baseline="0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. Typhi challenge study (</a:t>
            </a:r>
            <a:r>
              <a:rPr lang="en-US" sz="1200" baseline="0" dirty="0" err="1">
                <a:latin typeface="Arial" charset="0"/>
                <a:ea typeface="Arial" charset="0"/>
                <a:cs typeface="Arial" charset="0"/>
              </a:rPr>
              <a:t>Fresnay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 2016) to be associated with protection from developing disease, following co-culture with HLA-E restricted </a:t>
            </a:r>
            <a:r>
              <a:rPr lang="en-US" sz="1200" i="1" baseline="0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. Typhi infected antigen presenting targets. Bars represent medians with whiskers indicating interquartile ranges. Data divided among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(A-D)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(E-H)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 HLA-E*01:01 (n=10), HLA-E*01:03 (n=6), and HLA-E heterozygous (n=12)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participants. Scatter plot statistics were analyzed by unpaired t-test. * p &lt; 0.05; ** p &lt; 0.01 </a:t>
            </a:r>
            <a:endParaRPr lang="en-US" b="1" baseline="0" dirty="0">
              <a:solidFill>
                <a:srgbClr val="C00000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44335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Supplemental Fig 3. CD8+ T Effector Memory Response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Scatter plots showing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A+D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the response over baseline percentages of CD8+ TEM producing MIP1β, CD107a, TNFα, IL-2, IL-17A, IFN𝛾, and Granzyme B (</a:t>
            </a:r>
            <a:r>
              <a:rPr lang="en-US" sz="1200" baseline="0" dirty="0" err="1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);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B+E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CD8+ TEM observed mono-, bi-, tri-, and &gt;3-functional populations, and;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C+F. </a:t>
            </a:r>
            <a:r>
              <a:rPr lang="en-US" sz="1200" b="0" baseline="0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CD8+CD69+ TEM multifunctional responses, shown in a previous </a:t>
            </a:r>
            <a:r>
              <a:rPr lang="en-US" sz="1200" i="1" baseline="0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. Typhi challenge study (</a:t>
            </a:r>
            <a:r>
              <a:rPr lang="en-US" sz="1200" baseline="0" dirty="0" err="1">
                <a:latin typeface="Arial" charset="0"/>
                <a:ea typeface="Arial" charset="0"/>
                <a:cs typeface="Arial" charset="0"/>
              </a:rPr>
              <a:t>Fresnay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 2016) to be associated with protection from developing disease, following co-culture with HLA-E restricted </a:t>
            </a:r>
            <a:r>
              <a:rPr lang="en-US" sz="1200" i="1" baseline="0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. Typhi infected antigen presenting targets. Bars represent medians with whiskers indicating interquartile ranges. Data divided among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(A-D)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(E-H)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 HLA-E*01:01 (n=10), HLA-E*01:03 (n=6), and HLA-E heterozygous (n=12)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participants. Scatter plot statistics were analyzed by unpaired t-test. * p &lt; 0.05; ** p &lt; 0.01 </a:t>
            </a:r>
            <a:endParaRPr lang="en-US" b="1" baseline="0" dirty="0">
              <a:solidFill>
                <a:srgbClr val="C00000"/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20890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Supplemental Fig 4. CD8+ T Effector Memory RA Response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Scatter plots showing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A+D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the response over baseline percentages of CD8+ TEMRA producing MIP1β, CD107a, TNFα, IL-2, IL-17A, IFN𝛾, and Granzyme B (</a:t>
            </a:r>
            <a:r>
              <a:rPr lang="en-US" sz="1200" baseline="0" dirty="0" err="1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);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B+E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CD8+ TEMRA observed mono-, bi-, tri-, and &gt;3-functional populations, and;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C+F. </a:t>
            </a:r>
            <a:r>
              <a:rPr lang="en-US" sz="1200" b="0" baseline="0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CD8+CD69+ TEMRA multifunctional responses, shown in a previous </a:t>
            </a:r>
            <a:r>
              <a:rPr lang="en-US" sz="1200" i="1" baseline="0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. Typhi challenge study (</a:t>
            </a:r>
            <a:r>
              <a:rPr lang="en-US" sz="1200" baseline="0" dirty="0" err="1">
                <a:latin typeface="Arial" charset="0"/>
                <a:ea typeface="Arial" charset="0"/>
                <a:cs typeface="Arial" charset="0"/>
              </a:rPr>
              <a:t>Fresnay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 2016) to be associated with protection from developing disease, following co-culture with HLA-E restricted </a:t>
            </a:r>
            <a:r>
              <a:rPr lang="en-US" sz="1200" i="1" baseline="0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. Typhi infected antigen presenting targets. Bars represent medians with whiskers indicating interquartile ranges. Data divided among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(A-D)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(E-H)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 HLA-E*01:01 (n=10), HLA-E*01:03 (n=6), and HLA-E heterozygous (n=12)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participants. Scatter plot statistics were analyzed by unpaired t-test. * p &lt; 0.05; ** p &lt; 0.01 </a:t>
            </a:r>
            <a:endParaRPr lang="en-US" b="1" baseline="0" dirty="0">
              <a:solidFill>
                <a:srgbClr val="C00000"/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73686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Supplemental Fig 4. CD8+ T Effector Memory RA Response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Scatter plots showing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A+D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the response over baseline percentages of CD8+ TEMRA producing MIP1β, CD107a, TNFα, IL-2, IL-17A, IFN𝛾, and Granzyme B (</a:t>
            </a:r>
            <a:r>
              <a:rPr lang="en-US" sz="1200" baseline="0" dirty="0" err="1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);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B+E.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CD8+ TEMRA observed mono-, bi-, tri-, and &gt;3-functional populations, and;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C+F. </a:t>
            </a:r>
            <a:r>
              <a:rPr lang="en-US" sz="1200" b="0" baseline="0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CD8+CD69+ TEMRA multifunctional responses, shown in a previous </a:t>
            </a:r>
            <a:r>
              <a:rPr lang="en-US" sz="1200" i="1" baseline="0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. Typhi challenge study (</a:t>
            </a:r>
            <a:r>
              <a:rPr lang="en-US" sz="1200" baseline="0" dirty="0" err="1">
                <a:latin typeface="Arial" charset="0"/>
                <a:ea typeface="Arial" charset="0"/>
                <a:cs typeface="Arial" charset="0"/>
              </a:rPr>
              <a:t>Fresnay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 2016) to be associated with protection from developing disease, following co-culture with HLA-E restricted </a:t>
            </a:r>
            <a:r>
              <a:rPr lang="en-US" sz="1200" i="1" baseline="0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. Typhi infected antigen presenting targets. Bars represent medians with whiskers indicating interquartile ranges. Data divided among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(A-D)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(E-H)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 HLA-E*01:01 (n=10), HLA-E*01:03 (n=6), and HLA-E heterozygous (n=12)</a:t>
            </a:r>
            <a:r>
              <a:rPr lang="en-US" sz="1200" b="1" baseline="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baseline="0" dirty="0">
                <a:latin typeface="Arial" charset="0"/>
                <a:ea typeface="Arial" charset="0"/>
                <a:cs typeface="Arial" charset="0"/>
              </a:rPr>
              <a:t>participants. Scatter plot statistics were analyzed by unpaired t-test. * p &lt; 0.05; ** p &lt; 0.01 </a:t>
            </a:r>
            <a:endParaRPr lang="en-US" b="1" baseline="0" dirty="0">
              <a:solidFill>
                <a:srgbClr val="C00000"/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95182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590344-78D3-BD45-AB05-3F20EAC48829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7448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B840CC-3B74-6741-9A5E-E6EDBEDA63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39D45F5-4794-F84B-904A-BC17FE1660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A8FB25-AF48-9D4C-AF29-D40D9F085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6A7398-E719-AA4D-809C-589CED998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1D27AE-DFE9-0144-A36B-3FC81B8A2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774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8FD346-5C79-CC4A-B698-9393894103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7180A6-3EC5-9445-9E67-6FF9578FA3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E146C6-01B7-EC49-A95E-7F04379F8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6FAE0D-30C7-2448-82F9-89301EC445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4D87F3-3DFD-C541-BCB8-34C04246A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41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13F42E2-E359-0642-BDAD-E1CD425DF1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038D50-36BB-CC44-BF71-2712C62C51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02EC4D-0848-F143-BF34-D7FF0AD4D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2DCBE0-6AC8-8F4C-9DF9-9734C23788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6554CF-4B01-0E4E-B4AC-72C0C28671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846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A665F6-1E16-2845-AA04-AEC06E76F9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7FDB3C-D142-6241-BD4B-36B69C4F4E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80E501-3D6B-4C43-A6DA-1D1FCC0DF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309A93-8837-1342-9AAB-A0727C2528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3B4FE-3C9F-C54C-B438-B370A580F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6135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32D37E-52D2-C34B-9421-B90C0D0E1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4E9CD9-D8A1-BE46-B25D-4B0EA7F0CD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CF10B4-85C3-E74F-87C7-0D5DD412F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179DFC-00C9-D04C-825A-C4FFC5ABF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87255D-DA6A-7748-86E9-C5236ADBE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679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E1C21A-9DCD-A344-81A1-FA308B22F8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DFF6FF-E1C1-6140-899A-B8163EFAAA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284FDF-87D9-1049-8F4F-A57CB54D9C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9D1B4D-030F-FC41-BDBA-BDFCBF862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BBD895-300B-2840-A9A8-FEA17D8FC0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B8439-5C19-934C-AD48-0ABFFA536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128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A9D9BE-B7E4-DD42-886E-93FD098E6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0F59DF-066A-D14B-B05D-D45CE8C9D0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EA4680-0E0C-2147-A910-451355A5AF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FD9155F-29C7-CC4A-8124-120752CE32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5838AAF-F49D-9B45-BB8F-564699F859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68F2E32-4330-3748-BC7C-FD39865974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3AC2573-42E2-D144-881F-84D433FAE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D77266-77EA-D949-8919-80EF9E5C0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5949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D4DD9E-CEAB-8844-B0B0-186289AD64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7C7FAE8-1F17-5E47-82B4-67E5F9618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F839C3-1A89-7B4C-83A1-3FE03A1ED3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239E167-1BB2-9E46-83C4-A4DD79147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4853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48F6A5D-BB30-1D4E-8645-F6E2119419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7CF9F3-5AE2-3D44-94C2-3A42BE4C6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60CF7F-D74B-1946-A21A-0B75D73DB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022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E427C8-0DF5-074D-B09A-250900B15E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E724BA-6E41-884C-97E7-7025B5BC3F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3E6877-200D-BB49-BCF4-4D4DE5B594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3C4ED6-616E-D442-A9C0-707CF58E41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16F3EB-4E4F-3E4C-B8E7-567E9E9646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B0BFCC-E90A-6E49-B4FA-C354EA8E3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986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594B91-16A7-B243-8C4A-5C2EF69424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5260181-6A48-6C47-B0C0-C4A7DE8998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A2D6BA-3E91-5B4E-BE63-0587FC9E5A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590EE7-6FF5-D240-A6B5-E424AC66DA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9D620F-FBB3-9B4D-9D09-EC0C9A73A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DF86B0-E5A5-C146-85D1-1924C9494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0890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8C518D1-B517-6044-837C-D4950CFB4D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93FEBC-A92D-DD4A-8C1E-24E49DD0A2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4BCBD7-D5A5-404D-B72F-C90A45C82D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405F63-84C7-314C-A047-7300A36138C2}" type="datetimeFigureOut">
              <a:rPr lang="en-US" smtClean="0"/>
              <a:t>2/1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399E9B-806A-3848-B31C-0A4908A3B0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F64240-ECE7-8F4C-8097-91DE875A62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8D086D-3CA4-8C4F-936B-8C5049F5B6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2802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5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f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7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emf"/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7" Type="http://schemas.openxmlformats.org/officeDocument/2006/relationships/image" Target="../media/image45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3" Type="http://schemas.openxmlformats.org/officeDocument/2006/relationships/image" Target="../media/image46.png"/><Relationship Id="rId7" Type="http://schemas.openxmlformats.org/officeDocument/2006/relationships/image" Target="../media/image50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png"/><Relationship Id="rId5" Type="http://schemas.openxmlformats.org/officeDocument/2006/relationships/image" Target="../media/image48.png"/><Relationship Id="rId4" Type="http://schemas.openxmlformats.org/officeDocument/2006/relationships/image" Target="../media/image47.png"/><Relationship Id="rId9" Type="http://schemas.openxmlformats.org/officeDocument/2006/relationships/image" Target="../media/image52.em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emf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4.emf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7" Type="http://schemas.openxmlformats.org/officeDocument/2006/relationships/image" Target="../media/image60.pn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png"/><Relationship Id="rId5" Type="http://schemas.openxmlformats.org/officeDocument/2006/relationships/image" Target="../media/image58.png"/><Relationship Id="rId4" Type="http://schemas.openxmlformats.org/officeDocument/2006/relationships/image" Target="../media/image5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emf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png"/><Relationship Id="rId3" Type="http://schemas.openxmlformats.org/officeDocument/2006/relationships/image" Target="../media/image61.png"/><Relationship Id="rId7" Type="http://schemas.openxmlformats.org/officeDocument/2006/relationships/image" Target="../media/image65.pn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4.png"/><Relationship Id="rId5" Type="http://schemas.openxmlformats.org/officeDocument/2006/relationships/image" Target="../media/image63.png"/><Relationship Id="rId4" Type="http://schemas.openxmlformats.org/officeDocument/2006/relationships/image" Target="../media/image62.png"/><Relationship Id="rId9" Type="http://schemas.openxmlformats.org/officeDocument/2006/relationships/image" Target="../media/image6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emf"/><Relationship Id="rId4" Type="http://schemas.openxmlformats.org/officeDocument/2006/relationships/image" Target="../media/image28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0B11B5F0-0CCC-464C-BB58-47D5A894BB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3892" y="3296150"/>
            <a:ext cx="3011107" cy="209748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87B11F9-5B20-3D43-AADC-71B96F9E316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13892" y="525511"/>
            <a:ext cx="3011107" cy="209748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9583748-C561-2E45-A0C9-BA827A77B72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52425" y="3280655"/>
            <a:ext cx="3033893" cy="211335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D2CA3741-61A1-3049-98EA-9BFB5537DC1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17501" y="538752"/>
            <a:ext cx="3068817" cy="2084239"/>
          </a:xfrm>
          <a:prstGeom prst="rect">
            <a:avLst/>
          </a:prstGeom>
        </p:spPr>
      </p:pic>
      <p:sp>
        <p:nvSpPr>
          <p:cNvPr id="3" name="Shape 148"/>
          <p:cNvSpPr/>
          <p:nvPr/>
        </p:nvSpPr>
        <p:spPr>
          <a:xfrm>
            <a:off x="1546149" y="5675687"/>
            <a:ext cx="8843519" cy="11182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just" defTabSz="457200">
              <a:lnSpc>
                <a:spcPct val="117999"/>
              </a:lnSpc>
              <a:defRPr sz="1800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pPr>
              <a:lnSpc>
                <a:spcPct val="100000"/>
              </a:lnSpc>
            </a:pP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Supplemental </a:t>
            </a:r>
            <a:r>
              <a:rPr sz="1100" b="1" dirty="0">
                <a:latin typeface="Arial" charset="0"/>
                <a:ea typeface="Arial" charset="0"/>
                <a:cs typeface="Arial" charset="0"/>
              </a:rPr>
              <a:t>Fig 1.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Change in CD8 T cell Populations Following Ty21a Vaccination</a:t>
            </a:r>
            <a:r>
              <a:rPr sz="1100" b="1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catter plots showing the percentages of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A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e- and post-vaccination CD3+ T cells,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B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otal T cells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, C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8+ 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(CD45RA- CD62L-), and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D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8+ 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(CD45RA+ CD62L-) populations among male pediatric (ages 6-17; n=10), female pediatric (ages 11-17; n=8), male adult (n=7), and female adult (n=6) participants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 (media)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catter plots showing the percentages of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E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8+ 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(CD45RA- CD62L-), and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F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8+ 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(CD45RA+ CD62L-) populations among HLA-E*01:01 (n=10), HLA-E*01:03 (n=6), and HLA-E*01:01/03 heterozygotes (n=12) (media). 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Bar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represent 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medians with whisker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indicating 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interquartile range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. Statistic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were analyzed by unpaired t-test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(* p&lt;0.05; ** p&lt;0.01) </a:t>
            </a:r>
            <a:endParaRPr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749339" y="285857"/>
            <a:ext cx="203302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otal CD3+ in PBMC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046885" y="276999"/>
            <a:ext cx="196396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otal CD8+ T Cells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551570" y="442498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5838701" y="435666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834800" y="2907303"/>
            <a:ext cx="212494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T</a:t>
            </a:r>
            <a:r>
              <a:rPr lang="en-US" baseline="-25000" dirty="0"/>
              <a:t>EM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546149" y="3015171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5838700" y="3015171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D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6910331" y="2973429"/>
            <a:ext cx="223706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T</a:t>
            </a:r>
            <a:r>
              <a:rPr lang="en-US" baseline="-25000" dirty="0"/>
              <a:t>EMRA</a:t>
            </a:r>
          </a:p>
        </p:txBody>
      </p:sp>
      <p:sp>
        <p:nvSpPr>
          <p:cNvPr id="41" name="TextBox 40"/>
          <p:cNvSpPr txBox="1"/>
          <p:nvPr/>
        </p:nvSpPr>
        <p:spPr>
          <a:xfrm rot="16200000">
            <a:off x="1001680" y="4119205"/>
            <a:ext cx="1919732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8+ CD62L- CD45RA- T Cells (%)</a:t>
            </a:r>
          </a:p>
        </p:txBody>
      </p:sp>
      <p:sp>
        <p:nvSpPr>
          <p:cNvPr id="42" name="TextBox 41"/>
          <p:cNvSpPr txBox="1"/>
          <p:nvPr/>
        </p:nvSpPr>
        <p:spPr>
          <a:xfrm rot="16200000">
            <a:off x="5373538" y="1447988"/>
            <a:ext cx="186349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8+ CD3+ T cells (%)</a:t>
            </a:r>
          </a:p>
        </p:txBody>
      </p:sp>
      <p:sp>
        <p:nvSpPr>
          <p:cNvPr id="43" name="TextBox 42"/>
          <p:cNvSpPr txBox="1"/>
          <p:nvPr/>
        </p:nvSpPr>
        <p:spPr>
          <a:xfrm rot="16200000">
            <a:off x="1171716" y="1446260"/>
            <a:ext cx="186349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3+ PBMC (%)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FF60187-8D36-714A-B0E3-F8B184F8E44F}"/>
              </a:ext>
            </a:extLst>
          </p:cNvPr>
          <p:cNvSpPr txBox="1"/>
          <p:nvPr/>
        </p:nvSpPr>
        <p:spPr>
          <a:xfrm rot="16200000">
            <a:off x="5273491" y="4119206"/>
            <a:ext cx="1957584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8+ CD62L- CD45RA+ T Cells (%)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CC12FBF1-9885-CB4E-AFD9-ACCFB29D173D}"/>
              </a:ext>
            </a:extLst>
          </p:cNvPr>
          <p:cNvCxnSpPr>
            <a:cxnSpLocks/>
          </p:cNvCxnSpPr>
          <p:nvPr/>
        </p:nvCxnSpPr>
        <p:spPr>
          <a:xfrm>
            <a:off x="2834800" y="3390657"/>
            <a:ext cx="4550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055EA8DB-728D-444D-854A-6941746F6949}"/>
              </a:ext>
            </a:extLst>
          </p:cNvPr>
          <p:cNvCxnSpPr>
            <a:cxnSpLocks/>
          </p:cNvCxnSpPr>
          <p:nvPr/>
        </p:nvCxnSpPr>
        <p:spPr>
          <a:xfrm>
            <a:off x="4327311" y="3592755"/>
            <a:ext cx="4550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790B3D78-26FD-B142-A9D6-04CBBA8A5A8A}"/>
              </a:ext>
            </a:extLst>
          </p:cNvPr>
          <p:cNvSpPr txBox="1"/>
          <p:nvPr/>
        </p:nvSpPr>
        <p:spPr>
          <a:xfrm>
            <a:off x="2918174" y="3167811"/>
            <a:ext cx="288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1CBF764-052E-4349-9511-532F3598AB92}"/>
              </a:ext>
            </a:extLst>
          </p:cNvPr>
          <p:cNvSpPr txBox="1"/>
          <p:nvPr/>
        </p:nvSpPr>
        <p:spPr>
          <a:xfrm>
            <a:off x="4411263" y="3373010"/>
            <a:ext cx="2883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E26320AA-B452-3648-9197-E728C1083A2F}"/>
              </a:ext>
            </a:extLst>
          </p:cNvPr>
          <p:cNvCxnSpPr>
            <a:cxnSpLocks/>
          </p:cNvCxnSpPr>
          <p:nvPr/>
        </p:nvCxnSpPr>
        <p:spPr>
          <a:xfrm>
            <a:off x="2555190" y="3550101"/>
            <a:ext cx="7346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87E0C94A-C812-8D4E-BE5E-A5F072DB3719}"/>
              </a:ext>
            </a:extLst>
          </p:cNvPr>
          <p:cNvSpPr txBox="1"/>
          <p:nvPr/>
        </p:nvSpPr>
        <p:spPr>
          <a:xfrm>
            <a:off x="2703553" y="3340658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*</a:t>
            </a: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2B5D278E-04EF-B241-BD82-979475E32A1E}"/>
              </a:ext>
            </a:extLst>
          </p:cNvPr>
          <p:cNvCxnSpPr>
            <a:cxnSpLocks/>
          </p:cNvCxnSpPr>
          <p:nvPr/>
        </p:nvCxnSpPr>
        <p:spPr>
          <a:xfrm>
            <a:off x="4049620" y="3747725"/>
            <a:ext cx="73466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2DA65C7C-EDA4-A643-ADFA-8B0C4B6E2468}"/>
              </a:ext>
            </a:extLst>
          </p:cNvPr>
          <p:cNvSpPr txBox="1"/>
          <p:nvPr/>
        </p:nvSpPr>
        <p:spPr>
          <a:xfrm>
            <a:off x="4197983" y="3538282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*</a:t>
            </a:r>
          </a:p>
        </p:txBody>
      </p:sp>
      <p:grpSp>
        <p:nvGrpSpPr>
          <p:cNvPr id="62" name="Group 61">
            <a:extLst>
              <a:ext uri="{FF2B5EF4-FFF2-40B4-BE49-F238E27FC236}">
                <a16:creationId xmlns:a16="http://schemas.microsoft.com/office/drawing/2014/main" id="{7A73F086-B815-9149-A422-9E83C3D059F3}"/>
              </a:ext>
            </a:extLst>
          </p:cNvPr>
          <p:cNvGrpSpPr/>
          <p:nvPr/>
        </p:nvGrpSpPr>
        <p:grpSpPr>
          <a:xfrm>
            <a:off x="9222241" y="2893643"/>
            <a:ext cx="1875744" cy="794966"/>
            <a:chOff x="10279866" y="1001743"/>
            <a:chExt cx="1793913" cy="794966"/>
          </a:xfrm>
        </p:grpSpPr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A3278256-D719-1441-8AB2-E914BE2AA3D6}"/>
                </a:ext>
              </a:extLst>
            </p:cNvPr>
            <p:cNvGrpSpPr/>
            <p:nvPr/>
          </p:nvGrpSpPr>
          <p:grpSpPr>
            <a:xfrm>
              <a:off x="10279866" y="1001743"/>
              <a:ext cx="1793913" cy="794966"/>
              <a:chOff x="10072002" y="392204"/>
              <a:chExt cx="1673319" cy="794966"/>
            </a:xfrm>
          </p:grpSpPr>
          <p:sp>
            <p:nvSpPr>
              <p:cNvPr id="71" name="Oval 70">
                <a:extLst>
                  <a:ext uri="{FF2B5EF4-FFF2-40B4-BE49-F238E27FC236}">
                    <a16:creationId xmlns:a16="http://schemas.microsoft.com/office/drawing/2014/main" id="{3BF8468C-13A6-1F45-B586-C82CA82CE46F}"/>
                  </a:ext>
                </a:extLst>
              </p:cNvPr>
              <p:cNvSpPr/>
              <p:nvPr/>
            </p:nvSpPr>
            <p:spPr>
              <a:xfrm>
                <a:off x="10072002" y="487297"/>
                <a:ext cx="81572" cy="91440"/>
              </a:xfrm>
              <a:prstGeom prst="ellipse">
                <a:avLst/>
              </a:prstGeom>
              <a:solidFill>
                <a:srgbClr val="76D6FF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" name="Oval 75">
                <a:extLst>
                  <a:ext uri="{FF2B5EF4-FFF2-40B4-BE49-F238E27FC236}">
                    <a16:creationId xmlns:a16="http://schemas.microsoft.com/office/drawing/2014/main" id="{449A32FF-3F62-4B40-959F-C38455E1A746}"/>
                  </a:ext>
                </a:extLst>
              </p:cNvPr>
              <p:cNvSpPr/>
              <p:nvPr/>
            </p:nvSpPr>
            <p:spPr>
              <a:xfrm>
                <a:off x="10072002" y="656264"/>
                <a:ext cx="81572" cy="91440"/>
              </a:xfrm>
              <a:prstGeom prst="ellipse">
                <a:avLst/>
              </a:prstGeom>
              <a:solidFill>
                <a:srgbClr val="FF7E79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F6802CBB-A04E-0B48-8E99-68C924DD19E6}"/>
                  </a:ext>
                </a:extLst>
              </p:cNvPr>
              <p:cNvSpPr txBox="1"/>
              <p:nvPr/>
            </p:nvSpPr>
            <p:spPr>
              <a:xfrm>
                <a:off x="10163442" y="574706"/>
                <a:ext cx="158187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ed Female (n=8; 11-17 </a:t>
                </a:r>
                <a:r>
                  <a:rPr lang="en-US" sz="1050" dirty="0" err="1"/>
                  <a:t>yrs</a:t>
                </a:r>
                <a:r>
                  <a:rPr lang="en-US" sz="1050" dirty="0"/>
                  <a:t>)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B6D0A624-A7E4-F043-A3C6-01830744E0DA}"/>
                  </a:ext>
                </a:extLst>
              </p:cNvPr>
              <p:cNvSpPr txBox="1"/>
              <p:nvPr/>
            </p:nvSpPr>
            <p:spPr>
              <a:xfrm>
                <a:off x="10163442" y="392204"/>
                <a:ext cx="147319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ed Male (n=10; 6-17 </a:t>
                </a:r>
                <a:r>
                  <a:rPr lang="en-US" sz="1050" dirty="0" err="1"/>
                  <a:t>yrs</a:t>
                </a:r>
                <a:r>
                  <a:rPr lang="en-US" sz="1050" dirty="0"/>
                  <a:t>)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E77D7C27-B4DE-EC46-B4AC-801CFC80E31B}"/>
                  </a:ext>
                </a:extLst>
              </p:cNvPr>
              <p:cNvSpPr txBox="1"/>
              <p:nvPr/>
            </p:nvSpPr>
            <p:spPr>
              <a:xfrm>
                <a:off x="10163442" y="933254"/>
                <a:ext cx="109424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Adult Female (n=6)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A8E60E10-E4A6-C44B-B7C7-62292A3CF507}"/>
                  </a:ext>
                </a:extLst>
              </p:cNvPr>
              <p:cNvSpPr txBox="1"/>
              <p:nvPr/>
            </p:nvSpPr>
            <p:spPr>
              <a:xfrm>
                <a:off x="10163442" y="745241"/>
                <a:ext cx="98556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Adult Male (n=7)</a:t>
                </a:r>
              </a:p>
            </p:txBody>
          </p:sp>
        </p:grp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612A8DBC-D425-B544-AEE6-AB60E5A47742}"/>
                </a:ext>
              </a:extLst>
            </p:cNvPr>
            <p:cNvSpPr/>
            <p:nvPr/>
          </p:nvSpPr>
          <p:spPr>
            <a:xfrm>
              <a:off x="10285381" y="1619243"/>
              <a:ext cx="87451" cy="91440"/>
            </a:xfrm>
            <a:prstGeom prst="rect">
              <a:avLst/>
            </a:prstGeom>
            <a:solidFill>
              <a:srgbClr val="9411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9" name="Rectangle 68">
              <a:extLst>
                <a:ext uri="{FF2B5EF4-FFF2-40B4-BE49-F238E27FC236}">
                  <a16:creationId xmlns:a16="http://schemas.microsoft.com/office/drawing/2014/main" id="{15591816-9550-F347-837C-53CAE7C0CB2C}"/>
                </a:ext>
              </a:extLst>
            </p:cNvPr>
            <p:cNvSpPr/>
            <p:nvPr/>
          </p:nvSpPr>
          <p:spPr>
            <a:xfrm>
              <a:off x="10285381" y="1448374"/>
              <a:ext cx="88700" cy="90757"/>
            </a:xfrm>
            <a:prstGeom prst="rect">
              <a:avLst/>
            </a:prstGeom>
            <a:solidFill>
              <a:srgbClr val="01189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0" name="TextBox 49">
            <a:extLst>
              <a:ext uri="{FF2B5EF4-FFF2-40B4-BE49-F238E27FC236}">
                <a16:creationId xmlns:a16="http://schemas.microsoft.com/office/drawing/2014/main" id="{9CE230CF-7309-C244-BB15-C913F747557A}"/>
              </a:ext>
            </a:extLst>
          </p:cNvPr>
          <p:cNvSpPr txBox="1"/>
          <p:nvPr/>
        </p:nvSpPr>
        <p:spPr>
          <a:xfrm>
            <a:off x="2547758" y="2582718"/>
            <a:ext cx="123216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re-Vaccination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75B8750-9AFE-CC44-B861-13AEE5C09B37}"/>
              </a:ext>
            </a:extLst>
          </p:cNvPr>
          <p:cNvSpPr txBox="1"/>
          <p:nvPr/>
        </p:nvSpPr>
        <p:spPr>
          <a:xfrm>
            <a:off x="3925859" y="2592785"/>
            <a:ext cx="130084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ost- Vaccinatio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8A100DE-C2DF-9A41-8257-AE262E653A49}"/>
              </a:ext>
            </a:extLst>
          </p:cNvPr>
          <p:cNvSpPr txBox="1"/>
          <p:nvPr/>
        </p:nvSpPr>
        <p:spPr>
          <a:xfrm>
            <a:off x="6766014" y="2577170"/>
            <a:ext cx="123216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re-Vaccination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C721B4D-FD48-A842-A308-13B5D781B266}"/>
              </a:ext>
            </a:extLst>
          </p:cNvPr>
          <p:cNvSpPr txBox="1"/>
          <p:nvPr/>
        </p:nvSpPr>
        <p:spPr>
          <a:xfrm>
            <a:off x="8180211" y="2587237"/>
            <a:ext cx="130084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ost- Vaccinatio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088BD4D-6376-F243-97F7-560D864B309D}"/>
              </a:ext>
            </a:extLst>
          </p:cNvPr>
          <p:cNvSpPr txBox="1"/>
          <p:nvPr/>
        </p:nvSpPr>
        <p:spPr>
          <a:xfrm>
            <a:off x="2505757" y="5359891"/>
            <a:ext cx="123216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re-Vaccination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2FA4872-C7BC-4E43-AEFD-E4AED2D9B9F1}"/>
              </a:ext>
            </a:extLst>
          </p:cNvPr>
          <p:cNvSpPr txBox="1"/>
          <p:nvPr/>
        </p:nvSpPr>
        <p:spPr>
          <a:xfrm>
            <a:off x="3931986" y="5369958"/>
            <a:ext cx="130084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ost- Vaccination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68B9119-A28C-D147-A659-4C7448A59CCF}"/>
              </a:ext>
            </a:extLst>
          </p:cNvPr>
          <p:cNvSpPr txBox="1"/>
          <p:nvPr/>
        </p:nvSpPr>
        <p:spPr>
          <a:xfrm>
            <a:off x="6760109" y="5354343"/>
            <a:ext cx="123216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re-Vaccination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2451AD5-38DA-6C4D-9CFC-F406AED781DC}"/>
              </a:ext>
            </a:extLst>
          </p:cNvPr>
          <p:cNvSpPr txBox="1"/>
          <p:nvPr/>
        </p:nvSpPr>
        <p:spPr>
          <a:xfrm>
            <a:off x="8174306" y="5364410"/>
            <a:ext cx="130084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ost- Vaccination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6DFD213-4AAC-2142-94B3-CF19365E3168}"/>
              </a:ext>
            </a:extLst>
          </p:cNvPr>
          <p:cNvSpPr txBox="1"/>
          <p:nvPr/>
        </p:nvSpPr>
        <p:spPr>
          <a:xfrm>
            <a:off x="12021" y="0"/>
            <a:ext cx="1539819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</p:spTree>
    <p:extLst>
      <p:ext uri="{BB962C8B-B14F-4D97-AF65-F5344CB8AC3E}">
        <p14:creationId xmlns:p14="http://schemas.microsoft.com/office/powerpoint/2010/main" val="359816040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BEB3E36-F797-5D49-AC1D-35F6459CB7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368238"/>
              </p:ext>
            </p:extLst>
          </p:nvPr>
        </p:nvGraphicFramePr>
        <p:xfrm>
          <a:off x="533789" y="3872433"/>
          <a:ext cx="5276243" cy="1828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3749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NFα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IP-1β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D107a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FN𝛾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L-2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/>
                        <a:t>GzmB</a:t>
                      </a:r>
                      <a:endParaRPr lang="en-US" sz="1400" dirty="0"/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62922051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37AC471-715A-E24C-857E-E0CF853D84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5481869"/>
              </p:ext>
            </p:extLst>
          </p:nvPr>
        </p:nvGraphicFramePr>
        <p:xfrm>
          <a:off x="6401189" y="3868183"/>
          <a:ext cx="5276243" cy="1828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3749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NFα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IP-1β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D107a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FN𝛾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L-2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/>
                        <a:t>GzmB</a:t>
                      </a:r>
                      <a:endParaRPr lang="en-US" sz="1400" dirty="0"/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62922051"/>
                  </a:ext>
                </a:extLst>
              </a:tr>
            </a:tbl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0BE45B91-18B6-E14C-A937-C7BF86FA7E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3973" y="1140611"/>
            <a:ext cx="4861100" cy="2727571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7B2E29B-470C-4C45-B3B4-3DF3788CD96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39858" y="1121635"/>
            <a:ext cx="4837574" cy="274654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C9D99EC-940B-0342-8119-B95E2F60400F}"/>
              </a:ext>
            </a:extLst>
          </p:cNvPr>
          <p:cNvSpPr txBox="1"/>
          <p:nvPr/>
        </p:nvSpPr>
        <p:spPr>
          <a:xfrm>
            <a:off x="7946779" y="803484"/>
            <a:ext cx="262373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RA</a:t>
            </a:r>
            <a:r>
              <a:rPr lang="en-US" dirty="0"/>
              <a:t> cell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ED6E08E-D01B-FE4A-877A-F1774B5A61DB}"/>
              </a:ext>
            </a:extLst>
          </p:cNvPr>
          <p:cNvSpPr txBox="1"/>
          <p:nvPr/>
        </p:nvSpPr>
        <p:spPr>
          <a:xfrm>
            <a:off x="2210594" y="803484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</a:t>
            </a:r>
            <a:r>
              <a:rPr lang="en-US" dirty="0"/>
              <a:t> cells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C7D28C3-8154-4B4D-AF61-36DD0A3B51DA}"/>
              </a:ext>
            </a:extLst>
          </p:cNvPr>
          <p:cNvCxnSpPr>
            <a:cxnSpLocks/>
          </p:cNvCxnSpPr>
          <p:nvPr/>
        </p:nvCxnSpPr>
        <p:spPr>
          <a:xfrm>
            <a:off x="1366609" y="2485161"/>
            <a:ext cx="38267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127E1F5C-7234-DE4D-9FFA-285E89DFABFE}"/>
              </a:ext>
            </a:extLst>
          </p:cNvPr>
          <p:cNvSpPr txBox="1"/>
          <p:nvPr/>
        </p:nvSpPr>
        <p:spPr>
          <a:xfrm>
            <a:off x="1472681" y="2260310"/>
            <a:ext cx="170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5F053CA-7B2E-B24F-9F46-0149345ECE7E}"/>
              </a:ext>
            </a:extLst>
          </p:cNvPr>
          <p:cNvCxnSpPr>
            <a:cxnSpLocks/>
          </p:cNvCxnSpPr>
          <p:nvPr/>
        </p:nvCxnSpPr>
        <p:spPr>
          <a:xfrm>
            <a:off x="1518191" y="2241750"/>
            <a:ext cx="2094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E162FB2-18B1-684D-AA97-5C7558AFF1B3}"/>
              </a:ext>
            </a:extLst>
          </p:cNvPr>
          <p:cNvCxnSpPr>
            <a:cxnSpLocks/>
          </p:cNvCxnSpPr>
          <p:nvPr/>
        </p:nvCxnSpPr>
        <p:spPr>
          <a:xfrm>
            <a:off x="4538430" y="2662507"/>
            <a:ext cx="2094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11A172ED-5E76-EB47-90AF-37F807A3E0C7}"/>
              </a:ext>
            </a:extLst>
          </p:cNvPr>
          <p:cNvSpPr txBox="1"/>
          <p:nvPr/>
        </p:nvSpPr>
        <p:spPr>
          <a:xfrm>
            <a:off x="4557912" y="2435037"/>
            <a:ext cx="170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F3025FC-AEED-6644-95FC-0B9C4199776E}"/>
              </a:ext>
            </a:extLst>
          </p:cNvPr>
          <p:cNvSpPr txBox="1"/>
          <p:nvPr/>
        </p:nvSpPr>
        <p:spPr>
          <a:xfrm>
            <a:off x="1537673" y="2023954"/>
            <a:ext cx="170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FCC307DB-B1A3-234A-9807-7979810EEA44}"/>
              </a:ext>
            </a:extLst>
          </p:cNvPr>
          <p:cNvCxnSpPr>
            <a:cxnSpLocks/>
          </p:cNvCxnSpPr>
          <p:nvPr/>
        </p:nvCxnSpPr>
        <p:spPr>
          <a:xfrm>
            <a:off x="7374114" y="1318555"/>
            <a:ext cx="2094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27BDFD6A-EE6C-E444-87BE-74870DCE009A}"/>
              </a:ext>
            </a:extLst>
          </p:cNvPr>
          <p:cNvSpPr txBox="1"/>
          <p:nvPr/>
        </p:nvSpPr>
        <p:spPr>
          <a:xfrm>
            <a:off x="7402305" y="1092049"/>
            <a:ext cx="170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50D6752C-F7B9-1C4B-BF70-EF4DE291103D}"/>
              </a:ext>
            </a:extLst>
          </p:cNvPr>
          <p:cNvSpPr txBox="1"/>
          <p:nvPr/>
        </p:nvSpPr>
        <p:spPr>
          <a:xfrm>
            <a:off x="161964" y="728730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A73AF5E-69E2-2049-B888-A79418A15D55}"/>
              </a:ext>
            </a:extLst>
          </p:cNvPr>
          <p:cNvSpPr txBox="1"/>
          <p:nvPr/>
        </p:nvSpPr>
        <p:spPr>
          <a:xfrm>
            <a:off x="6033878" y="731273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D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D57D0D5-5ECB-834A-999A-356DF9AC8EAA}"/>
              </a:ext>
            </a:extLst>
          </p:cNvPr>
          <p:cNvSpPr txBox="1"/>
          <p:nvPr/>
        </p:nvSpPr>
        <p:spPr>
          <a:xfrm>
            <a:off x="0" y="34461"/>
            <a:ext cx="245929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5</a:t>
            </a:r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4B0B2E68-72ED-8747-A534-68E66118E6F6}"/>
              </a:ext>
            </a:extLst>
          </p:cNvPr>
          <p:cNvGrpSpPr/>
          <p:nvPr/>
        </p:nvGrpSpPr>
        <p:grpSpPr>
          <a:xfrm>
            <a:off x="10240357" y="1172816"/>
            <a:ext cx="1875744" cy="794966"/>
            <a:chOff x="10279866" y="1001743"/>
            <a:chExt cx="1793913" cy="794966"/>
          </a:xfrm>
        </p:grpSpPr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3237C80B-CB75-C944-94BE-3637FFEB2E64}"/>
                </a:ext>
              </a:extLst>
            </p:cNvPr>
            <p:cNvGrpSpPr/>
            <p:nvPr/>
          </p:nvGrpSpPr>
          <p:grpSpPr>
            <a:xfrm>
              <a:off x="10279866" y="1001743"/>
              <a:ext cx="1793913" cy="794966"/>
              <a:chOff x="10072002" y="392204"/>
              <a:chExt cx="1673319" cy="794966"/>
            </a:xfrm>
          </p:grpSpPr>
          <p:sp>
            <p:nvSpPr>
              <p:cNvPr id="49" name="Oval 48">
                <a:extLst>
                  <a:ext uri="{FF2B5EF4-FFF2-40B4-BE49-F238E27FC236}">
                    <a16:creationId xmlns:a16="http://schemas.microsoft.com/office/drawing/2014/main" id="{BFC2F86C-DF30-BE4E-B79D-1E82C5A5DA37}"/>
                  </a:ext>
                </a:extLst>
              </p:cNvPr>
              <p:cNvSpPr/>
              <p:nvPr/>
            </p:nvSpPr>
            <p:spPr>
              <a:xfrm>
                <a:off x="10072002" y="487297"/>
                <a:ext cx="81572" cy="91440"/>
              </a:xfrm>
              <a:prstGeom prst="ellipse">
                <a:avLst/>
              </a:prstGeom>
              <a:solidFill>
                <a:srgbClr val="76D6FF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0" name="Oval 49">
                <a:extLst>
                  <a:ext uri="{FF2B5EF4-FFF2-40B4-BE49-F238E27FC236}">
                    <a16:creationId xmlns:a16="http://schemas.microsoft.com/office/drawing/2014/main" id="{430AB73E-F560-9F4B-B681-12338A79E3CF}"/>
                  </a:ext>
                </a:extLst>
              </p:cNvPr>
              <p:cNvSpPr/>
              <p:nvPr/>
            </p:nvSpPr>
            <p:spPr>
              <a:xfrm>
                <a:off x="10072002" y="656264"/>
                <a:ext cx="81572" cy="91440"/>
              </a:xfrm>
              <a:prstGeom prst="ellipse">
                <a:avLst/>
              </a:prstGeom>
              <a:solidFill>
                <a:srgbClr val="FF7E79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E1E5F9F4-B6E1-A14B-BD58-962E2D7AC4F0}"/>
                  </a:ext>
                </a:extLst>
              </p:cNvPr>
              <p:cNvSpPr txBox="1"/>
              <p:nvPr/>
            </p:nvSpPr>
            <p:spPr>
              <a:xfrm>
                <a:off x="10163442" y="574706"/>
                <a:ext cx="158187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ed Female (n=8; 11-17 </a:t>
                </a:r>
                <a:r>
                  <a:rPr lang="en-US" sz="1050" dirty="0" err="1"/>
                  <a:t>yrs</a:t>
                </a:r>
                <a:r>
                  <a:rPr lang="en-US" sz="1050" dirty="0"/>
                  <a:t>)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58CC5E31-991A-4143-8053-E287C1FF992F}"/>
                  </a:ext>
                </a:extLst>
              </p:cNvPr>
              <p:cNvSpPr txBox="1"/>
              <p:nvPr/>
            </p:nvSpPr>
            <p:spPr>
              <a:xfrm>
                <a:off x="10163442" y="392204"/>
                <a:ext cx="147319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ed Male (n=10; 6-17 </a:t>
                </a:r>
                <a:r>
                  <a:rPr lang="en-US" sz="1050" dirty="0" err="1"/>
                  <a:t>yrs</a:t>
                </a:r>
                <a:r>
                  <a:rPr lang="en-US" sz="1050" dirty="0"/>
                  <a:t>)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22D53E55-798D-8744-B10B-6E3E82AF6940}"/>
                  </a:ext>
                </a:extLst>
              </p:cNvPr>
              <p:cNvSpPr txBox="1"/>
              <p:nvPr/>
            </p:nvSpPr>
            <p:spPr>
              <a:xfrm>
                <a:off x="10163442" y="933254"/>
                <a:ext cx="109424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Adult Female (n=6)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CF164F11-34E9-B34E-AC1A-209571369627}"/>
                  </a:ext>
                </a:extLst>
              </p:cNvPr>
              <p:cNvSpPr txBox="1"/>
              <p:nvPr/>
            </p:nvSpPr>
            <p:spPr>
              <a:xfrm>
                <a:off x="10163442" y="745241"/>
                <a:ext cx="98556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Adult Male (n=7)</a:t>
                </a:r>
              </a:p>
            </p:txBody>
          </p:sp>
        </p:grp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2DFE1E23-6D57-474C-AADF-105C3A751A11}"/>
                </a:ext>
              </a:extLst>
            </p:cNvPr>
            <p:cNvSpPr/>
            <p:nvPr/>
          </p:nvSpPr>
          <p:spPr>
            <a:xfrm>
              <a:off x="10285381" y="1619243"/>
              <a:ext cx="87451" cy="91440"/>
            </a:xfrm>
            <a:prstGeom prst="rect">
              <a:avLst/>
            </a:prstGeom>
            <a:solidFill>
              <a:srgbClr val="9411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D7C6FA8F-065D-8E41-A385-68061DA9E8D8}"/>
                </a:ext>
              </a:extLst>
            </p:cNvPr>
            <p:cNvSpPr/>
            <p:nvPr/>
          </p:nvSpPr>
          <p:spPr>
            <a:xfrm>
              <a:off x="10285381" y="1448374"/>
              <a:ext cx="88700" cy="90757"/>
            </a:xfrm>
            <a:prstGeom prst="rect">
              <a:avLst/>
            </a:prstGeom>
            <a:solidFill>
              <a:srgbClr val="01189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52E51C3D-84CE-584B-B81D-A4E2D8605225}"/>
              </a:ext>
            </a:extLst>
          </p:cNvPr>
          <p:cNvSpPr txBox="1"/>
          <p:nvPr/>
        </p:nvSpPr>
        <p:spPr>
          <a:xfrm rot="16200000">
            <a:off x="-655656" y="2240102"/>
            <a:ext cx="26053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431AB7A-4BFB-2C4E-B718-71AAE5659389}"/>
              </a:ext>
            </a:extLst>
          </p:cNvPr>
          <p:cNvSpPr txBox="1"/>
          <p:nvPr/>
        </p:nvSpPr>
        <p:spPr>
          <a:xfrm rot="16200000">
            <a:off x="5251110" y="2240103"/>
            <a:ext cx="26053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B7218F3F-E623-744D-9E94-D22D1FCE42EC}"/>
              </a:ext>
            </a:extLst>
          </p:cNvPr>
          <p:cNvSpPr/>
          <p:nvPr/>
        </p:nvSpPr>
        <p:spPr>
          <a:xfrm>
            <a:off x="0" y="5772968"/>
            <a:ext cx="1219200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l Fig 5. Protection associated multifunctional populations plus Granzyme B. A-F. </a:t>
            </a:r>
            <a:r>
              <a:rPr lang="en-US" sz="110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nlist</a:t>
            </a:r>
            <a:r>
              <a:rPr lang="en-US" sz="1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FCOM identified selected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multifunctional increases over baseline following co-culture with HLA-E restricted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yphi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infected antigen presenting targets. These MF populations were selected based on those shown in a previous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.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yphi challenge study to be associated with protection from developing disease (10,11), plus Granzyme B expression following co-culture with HLA-E restricted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. Typhi infected antigen presenting targets. Results are shown for the following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A, C, E)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B, D, F)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populations: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A+B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6-15 year-old pediatric (n=10), 16-17 year-old pediatric (n=8) and adult participants;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C+D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F-E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HLA-E*01:01 (n=10), HLA-E*01:03 (n=6), and HLA-E heterozygous (n=12)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articipants. Bars represent medians with whiskers indicating interquartile ranges. Scatter plot statistics were analyzed by unpaired t-test. (* p&lt;0.05) </a:t>
            </a:r>
          </a:p>
        </p:txBody>
      </p:sp>
    </p:spTree>
    <p:extLst>
      <p:ext uri="{BB962C8B-B14F-4D97-AF65-F5344CB8AC3E}">
        <p14:creationId xmlns:p14="http://schemas.microsoft.com/office/powerpoint/2010/main" val="41542784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BEB3E36-F797-5D49-AC1D-35F6459CB7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99912799"/>
              </p:ext>
            </p:extLst>
          </p:nvPr>
        </p:nvGraphicFramePr>
        <p:xfrm>
          <a:off x="533789" y="3854943"/>
          <a:ext cx="5276243" cy="1828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3749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NFα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IP-1β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D107a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FN𝛾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L-2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/>
                        <a:t>GzmB</a:t>
                      </a:r>
                      <a:endParaRPr lang="en-US" sz="1400" dirty="0"/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62922051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37AC471-715A-E24C-857E-E0CF853D84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89879700"/>
              </p:ext>
            </p:extLst>
          </p:nvPr>
        </p:nvGraphicFramePr>
        <p:xfrm>
          <a:off x="6401189" y="3850693"/>
          <a:ext cx="5276243" cy="1828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3749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NFα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IP-1β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D107a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FN𝛾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L-2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/>
                        <a:t>GzmB</a:t>
                      </a:r>
                      <a:endParaRPr lang="en-US" sz="1400" dirty="0"/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62922051"/>
                  </a:ext>
                </a:extLst>
              </a:tr>
            </a:tbl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E7CCE307-849B-1447-AE1A-7B562C63AE1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1111" y="1093304"/>
            <a:ext cx="4896529" cy="274745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D9FFBD2-3CAF-5A4D-B79B-324B7EB0CD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40640" y="1083365"/>
            <a:ext cx="4856670" cy="275738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8A12980-6981-4947-8C83-25885D2E609A}"/>
              </a:ext>
            </a:extLst>
          </p:cNvPr>
          <p:cNvSpPr txBox="1"/>
          <p:nvPr/>
        </p:nvSpPr>
        <p:spPr>
          <a:xfrm>
            <a:off x="7957109" y="714033"/>
            <a:ext cx="262373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RA</a:t>
            </a:r>
            <a:r>
              <a:rPr lang="en-US" dirty="0"/>
              <a:t> cell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E542619-F6D4-8F42-B22C-CF80FC054B02}"/>
              </a:ext>
            </a:extLst>
          </p:cNvPr>
          <p:cNvSpPr txBox="1"/>
          <p:nvPr/>
        </p:nvSpPr>
        <p:spPr>
          <a:xfrm>
            <a:off x="2190716" y="714033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</a:t>
            </a:r>
            <a:r>
              <a:rPr lang="en-US" dirty="0"/>
              <a:t> cel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E39689-BCC5-954A-A1E9-087E25CE8FA7}"/>
              </a:ext>
            </a:extLst>
          </p:cNvPr>
          <p:cNvSpPr txBox="1"/>
          <p:nvPr/>
        </p:nvSpPr>
        <p:spPr>
          <a:xfrm>
            <a:off x="9682774" y="2422127"/>
            <a:ext cx="170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F1B9800D-A60D-C24E-B78B-CDD78E428963}"/>
              </a:ext>
            </a:extLst>
          </p:cNvPr>
          <p:cNvCxnSpPr>
            <a:cxnSpLocks/>
          </p:cNvCxnSpPr>
          <p:nvPr/>
        </p:nvCxnSpPr>
        <p:spPr>
          <a:xfrm flipV="1">
            <a:off x="9529502" y="2665964"/>
            <a:ext cx="477078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CD28AA49-D38E-7746-B16F-02D81C632D59}"/>
              </a:ext>
            </a:extLst>
          </p:cNvPr>
          <p:cNvSpPr txBox="1"/>
          <p:nvPr/>
        </p:nvSpPr>
        <p:spPr>
          <a:xfrm>
            <a:off x="161964" y="639279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06F7568-38A9-8C49-AE3D-E1140A9EDE35}"/>
              </a:ext>
            </a:extLst>
          </p:cNvPr>
          <p:cNvSpPr txBox="1"/>
          <p:nvPr/>
        </p:nvSpPr>
        <p:spPr>
          <a:xfrm>
            <a:off x="6033878" y="641822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4730B7F-4C78-654B-9726-DD8ADE6B6772}"/>
              </a:ext>
            </a:extLst>
          </p:cNvPr>
          <p:cNvSpPr txBox="1"/>
          <p:nvPr/>
        </p:nvSpPr>
        <p:spPr>
          <a:xfrm>
            <a:off x="0" y="34461"/>
            <a:ext cx="245929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5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DA3EF404-2375-1947-BB9D-64E37B7E6DA6}"/>
              </a:ext>
            </a:extLst>
          </p:cNvPr>
          <p:cNvGrpSpPr/>
          <p:nvPr/>
        </p:nvGrpSpPr>
        <p:grpSpPr>
          <a:xfrm>
            <a:off x="10580841" y="1262200"/>
            <a:ext cx="1421348" cy="612464"/>
            <a:chOff x="7355021" y="1783844"/>
            <a:chExt cx="1421348" cy="612464"/>
          </a:xfrm>
        </p:grpSpPr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D81850B0-3EC1-6E4F-B3C2-12B02EF98222}"/>
                </a:ext>
              </a:extLst>
            </p:cNvPr>
            <p:cNvGrpSpPr/>
            <p:nvPr/>
          </p:nvGrpSpPr>
          <p:grpSpPr>
            <a:xfrm>
              <a:off x="7362131" y="1783844"/>
              <a:ext cx="1414238" cy="612464"/>
              <a:chOff x="7437119" y="1671362"/>
              <a:chExt cx="1414238" cy="612464"/>
            </a:xfrm>
          </p:grpSpPr>
          <p:sp>
            <p:nvSpPr>
              <p:cNvPr id="32" name="Oval 31">
                <a:extLst>
                  <a:ext uri="{FF2B5EF4-FFF2-40B4-BE49-F238E27FC236}">
                    <a16:creationId xmlns:a16="http://schemas.microsoft.com/office/drawing/2014/main" id="{504E4FEF-5F18-5C43-BB86-8B9F7C06E82E}"/>
                  </a:ext>
                </a:extLst>
              </p:cNvPr>
              <p:cNvSpPr/>
              <p:nvPr/>
            </p:nvSpPr>
            <p:spPr>
              <a:xfrm>
                <a:off x="7437119" y="1752600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rgbClr val="009193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Oval 32">
                <a:extLst>
                  <a:ext uri="{FF2B5EF4-FFF2-40B4-BE49-F238E27FC236}">
                    <a16:creationId xmlns:a16="http://schemas.microsoft.com/office/drawing/2014/main" id="{60C11FC3-B2E0-5C42-8D7E-F4C9BA558FE2}"/>
                  </a:ext>
                </a:extLst>
              </p:cNvPr>
              <p:cNvSpPr/>
              <p:nvPr/>
            </p:nvSpPr>
            <p:spPr>
              <a:xfrm>
                <a:off x="7437119" y="1933647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rgbClr val="D883FF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ECA51AD4-C297-674A-977B-ECAF0CB4D111}"/>
                  </a:ext>
                </a:extLst>
              </p:cNvPr>
              <p:cNvSpPr txBox="1"/>
              <p:nvPr/>
            </p:nvSpPr>
            <p:spPr>
              <a:xfrm>
                <a:off x="7528559" y="1671362"/>
                <a:ext cx="127470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LA-E*01:01 (n=10)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02621B26-FCD5-A140-A746-E414BB19D5D5}"/>
                  </a:ext>
                </a:extLst>
              </p:cNvPr>
              <p:cNvSpPr txBox="1"/>
              <p:nvPr/>
            </p:nvSpPr>
            <p:spPr>
              <a:xfrm>
                <a:off x="7528559" y="1852409"/>
                <a:ext cx="120577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LA-E*01:03 (n=6)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370C5F68-19D8-2940-B8E9-8FE40FB80034}"/>
                  </a:ext>
                </a:extLst>
              </p:cNvPr>
              <p:cNvSpPr txBox="1"/>
              <p:nvPr/>
            </p:nvSpPr>
            <p:spPr>
              <a:xfrm>
                <a:off x="7528559" y="2029910"/>
                <a:ext cx="132279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eterozygous (n=12)</a:t>
                </a:r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E4A02A7C-0CB3-EE4F-9912-375CAD73476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355021" y="2225593"/>
              <a:ext cx="107572" cy="100584"/>
              <a:chOff x="6717066" y="5643716"/>
              <a:chExt cx="743963" cy="685800"/>
            </a:xfrm>
          </p:grpSpPr>
          <p:sp>
            <p:nvSpPr>
              <p:cNvPr id="30" name="Chord 29">
                <a:extLst>
                  <a:ext uri="{FF2B5EF4-FFF2-40B4-BE49-F238E27FC236}">
                    <a16:creationId xmlns:a16="http://schemas.microsoft.com/office/drawing/2014/main" id="{EA7E0211-4719-BC47-9C6C-07F8407174F8}"/>
                  </a:ext>
                </a:extLst>
              </p:cNvPr>
              <p:cNvSpPr/>
              <p:nvPr/>
            </p:nvSpPr>
            <p:spPr>
              <a:xfrm>
                <a:off x="6717066" y="5643716"/>
                <a:ext cx="685800" cy="685800"/>
              </a:xfrm>
              <a:prstGeom prst="chord">
                <a:avLst>
                  <a:gd name="adj1" fmla="val 5438129"/>
                  <a:gd name="adj2" fmla="val 16148966"/>
                </a:avLst>
              </a:prstGeom>
              <a:solidFill>
                <a:srgbClr val="D883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" name="Chord 30">
                <a:extLst>
                  <a:ext uri="{FF2B5EF4-FFF2-40B4-BE49-F238E27FC236}">
                    <a16:creationId xmlns:a16="http://schemas.microsoft.com/office/drawing/2014/main" id="{07150FFD-A8E6-FA4F-874F-8E67CD72348E}"/>
                  </a:ext>
                </a:extLst>
              </p:cNvPr>
              <p:cNvSpPr/>
              <p:nvPr/>
            </p:nvSpPr>
            <p:spPr>
              <a:xfrm rot="10800000">
                <a:off x="6775231" y="5643716"/>
                <a:ext cx="685798" cy="685800"/>
              </a:xfrm>
              <a:prstGeom prst="chord">
                <a:avLst>
                  <a:gd name="adj1" fmla="val 5438129"/>
                  <a:gd name="adj2" fmla="val 16148966"/>
                </a:avLst>
              </a:prstGeom>
              <a:solidFill>
                <a:srgbClr val="00919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38" name="TextBox 37">
            <a:extLst>
              <a:ext uri="{FF2B5EF4-FFF2-40B4-BE49-F238E27FC236}">
                <a16:creationId xmlns:a16="http://schemas.microsoft.com/office/drawing/2014/main" id="{A0240332-DE9E-BE45-94EB-61B58C01CD87}"/>
              </a:ext>
            </a:extLst>
          </p:cNvPr>
          <p:cNvSpPr txBox="1"/>
          <p:nvPr/>
        </p:nvSpPr>
        <p:spPr>
          <a:xfrm rot="16200000">
            <a:off x="-655656" y="2240102"/>
            <a:ext cx="26053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E38A59C-C667-5F4C-8225-45D800473849}"/>
              </a:ext>
            </a:extLst>
          </p:cNvPr>
          <p:cNvSpPr txBox="1"/>
          <p:nvPr/>
        </p:nvSpPr>
        <p:spPr>
          <a:xfrm rot="16200000">
            <a:off x="5251110" y="2240103"/>
            <a:ext cx="26053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E18E7D24-3778-D64A-9005-F1EB3FB07D65}"/>
              </a:ext>
            </a:extLst>
          </p:cNvPr>
          <p:cNvSpPr/>
          <p:nvPr/>
        </p:nvSpPr>
        <p:spPr>
          <a:xfrm>
            <a:off x="0" y="5772968"/>
            <a:ext cx="1219200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l Fig 5. Protection associated multifunctional populations plus Granzyme B. A-F. </a:t>
            </a:r>
            <a:r>
              <a:rPr lang="en-US" sz="110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nlist</a:t>
            </a:r>
            <a:r>
              <a:rPr lang="en-US" sz="1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FCOM identified selected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multifunctional increases over baseline following co-culture with HLA-E restricted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yphi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infected antigen presenting targets. These MF populations were selected based on those shown in a previous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.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yphi challenge study to be associated with protection from developing disease (10,11), plus Granzyme B expression following co-culture with HLA-E restricted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. Typhi infected antigen presenting targets. Results are shown for the following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A, C, E)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B, D, F)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populations: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A+B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6-15 year-old pediatric (n=10), 16-17 year-old pediatric (n=8) and adult participants;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C+D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F-E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HLA-E*01:01 (n=10), HLA-E*01:03 (n=6), and HLA-E heterozygous (n=12)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articipants. Bars represent medians with whiskers indicating interquartile ranges. Scatter plot statistics were analyzed by unpaired t-test. (* p&lt;0.05) </a:t>
            </a:r>
          </a:p>
        </p:txBody>
      </p:sp>
    </p:spTree>
    <p:extLst>
      <p:ext uri="{BB962C8B-B14F-4D97-AF65-F5344CB8AC3E}">
        <p14:creationId xmlns:p14="http://schemas.microsoft.com/office/powerpoint/2010/main" val="106089184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4016" y="922901"/>
            <a:ext cx="5725359" cy="512573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2FF6DC7-031A-834F-9E65-B81B9DECF1D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353" b="6078"/>
          <a:stretch/>
        </p:blipFill>
        <p:spPr>
          <a:xfrm>
            <a:off x="6161454" y="927695"/>
            <a:ext cx="5903159" cy="512094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CD5F8FE-043B-8843-905D-3DF16CBC149B}"/>
              </a:ext>
            </a:extLst>
          </p:cNvPr>
          <p:cNvSpPr txBox="1"/>
          <p:nvPr/>
        </p:nvSpPr>
        <p:spPr>
          <a:xfrm>
            <a:off x="13713" y="572299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F75F4AB-8BE9-B34A-BFE6-9235D412D504}"/>
              </a:ext>
            </a:extLst>
          </p:cNvPr>
          <p:cNvSpPr txBox="1"/>
          <p:nvPr/>
        </p:nvSpPr>
        <p:spPr>
          <a:xfrm>
            <a:off x="6161454" y="572299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29FE731-E7E5-674A-A3FD-A191907B8617}"/>
              </a:ext>
            </a:extLst>
          </p:cNvPr>
          <p:cNvSpPr txBox="1"/>
          <p:nvPr/>
        </p:nvSpPr>
        <p:spPr>
          <a:xfrm>
            <a:off x="1991964" y="459170"/>
            <a:ext cx="265112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</a:t>
            </a:r>
            <a:r>
              <a:rPr lang="en-US" dirty="0"/>
              <a:t> cell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BCC7CB5-A872-FF41-87D9-B1C1DB908DE6}"/>
              </a:ext>
            </a:extLst>
          </p:cNvPr>
          <p:cNvSpPr txBox="1"/>
          <p:nvPr/>
        </p:nvSpPr>
        <p:spPr>
          <a:xfrm>
            <a:off x="7475838" y="459170"/>
            <a:ext cx="296275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RA</a:t>
            </a:r>
            <a:r>
              <a:rPr lang="en-US" dirty="0"/>
              <a:t> cells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8FBF39B7-71D4-AA4B-A39D-6D0E9F3E7D7C}"/>
              </a:ext>
            </a:extLst>
          </p:cNvPr>
          <p:cNvSpPr/>
          <p:nvPr/>
        </p:nvSpPr>
        <p:spPr>
          <a:xfrm>
            <a:off x="1881921" y="6263310"/>
            <a:ext cx="901895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200" b="1" dirty="0"/>
              <a:t>Supplemental Fig 6. </a:t>
            </a:r>
            <a:r>
              <a:rPr lang="en-US" sz="1200" dirty="0"/>
              <a:t>Combined</a:t>
            </a:r>
            <a:r>
              <a:rPr lang="en-US" sz="1200" b="1" dirty="0"/>
              <a:t> </a:t>
            </a:r>
            <a:r>
              <a:rPr lang="en-US" sz="1200" dirty="0" err="1"/>
              <a:t>tSNE</a:t>
            </a:r>
            <a:r>
              <a:rPr lang="en-US" sz="1200" dirty="0"/>
              <a:t> maps for </a:t>
            </a:r>
            <a:r>
              <a:rPr lang="en-US" sz="1200" b="1" dirty="0"/>
              <a:t>A</a:t>
            </a:r>
            <a:r>
              <a:rPr lang="en-US" sz="1200" dirty="0"/>
              <a:t>. CD8+ CD69+ T</a:t>
            </a:r>
            <a:r>
              <a:rPr lang="en-US" sz="1200" baseline="-25000" dirty="0"/>
              <a:t>EM</a:t>
            </a:r>
            <a:r>
              <a:rPr lang="en-US" sz="1200" dirty="0"/>
              <a:t> and </a:t>
            </a:r>
            <a:r>
              <a:rPr lang="en-US" sz="1200" b="1" dirty="0"/>
              <a:t>B. </a:t>
            </a:r>
            <a:r>
              <a:rPr lang="en-US" sz="1200" dirty="0"/>
              <a:t>CD8+ CD69+ T</a:t>
            </a:r>
            <a:r>
              <a:rPr lang="en-US" sz="1200" baseline="-25000" dirty="0"/>
              <a:t>EMRA</a:t>
            </a:r>
            <a:r>
              <a:rPr lang="en-US" sz="1200" dirty="0"/>
              <a:t> generated from thirty-one Ty21a recipients, pre- and post-vaccination, following unsupervised clustering with </a:t>
            </a:r>
            <a:r>
              <a:rPr lang="en-US" sz="1200" dirty="0" err="1"/>
              <a:t>ClusterX</a:t>
            </a:r>
            <a:r>
              <a:rPr lang="en-US" sz="1200" dirty="0"/>
              <a:t>. </a:t>
            </a:r>
            <a:r>
              <a:rPr lang="en-US" sz="1200" dirty="0" err="1"/>
              <a:t>tSNE</a:t>
            </a:r>
            <a:r>
              <a:rPr lang="en-US" sz="1200" dirty="0"/>
              <a:t> and clustering algorithms were run using </a:t>
            </a:r>
            <a:r>
              <a:rPr lang="en-US" sz="1200" dirty="0" err="1"/>
              <a:t>Cytofkit</a:t>
            </a:r>
            <a:r>
              <a:rPr lang="en-US" sz="1200" dirty="0"/>
              <a:t> (38). </a:t>
            </a:r>
            <a:endParaRPr lang="en-US" sz="12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1D8A2AF-15FD-3E47-90CF-E3599FFB28CE}"/>
              </a:ext>
            </a:extLst>
          </p:cNvPr>
          <p:cNvSpPr txBox="1"/>
          <p:nvPr/>
        </p:nvSpPr>
        <p:spPr>
          <a:xfrm>
            <a:off x="-10489" y="-5126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b="1" dirty="0"/>
              <a:t>6</a:t>
            </a:r>
          </a:p>
        </p:txBody>
      </p:sp>
    </p:spTree>
    <p:extLst>
      <p:ext uri="{BB962C8B-B14F-4D97-AF65-F5344CB8AC3E}">
        <p14:creationId xmlns:p14="http://schemas.microsoft.com/office/powerpoint/2010/main" val="284217140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8CAB015-20AE-7546-BB0F-589EADD6EC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2189244"/>
              </p:ext>
            </p:extLst>
          </p:nvPr>
        </p:nvGraphicFramePr>
        <p:xfrm>
          <a:off x="1626172" y="3645637"/>
          <a:ext cx="3957184" cy="13487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5312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TNFα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MIP-1β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CD107a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IFN𝛾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IL-2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ADB4728D-BFAF-0F44-829D-0C619F0CAB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399588"/>
              </p:ext>
            </p:extLst>
          </p:nvPr>
        </p:nvGraphicFramePr>
        <p:xfrm>
          <a:off x="6061509" y="3645637"/>
          <a:ext cx="3957184" cy="15849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5312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TNFα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MIP-1β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CD107a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IFN𝛾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IL-2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err="1"/>
                        <a:t>GzmB</a:t>
                      </a:r>
                      <a:endParaRPr lang="en-US" sz="1100" dirty="0"/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1362922051"/>
                  </a:ext>
                </a:extLst>
              </a:tr>
            </a:tbl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4FD9C038-6415-D74C-9AF3-375A4A8188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6098" y="1453916"/>
            <a:ext cx="3543458" cy="217240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ACD68A9-0B75-A040-B0A4-F2423BFB62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84238" y="1483940"/>
            <a:ext cx="4196798" cy="214237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7571334-E867-4642-9FAC-373C670D6D3C}"/>
              </a:ext>
            </a:extLst>
          </p:cNvPr>
          <p:cNvSpPr txBox="1"/>
          <p:nvPr/>
        </p:nvSpPr>
        <p:spPr>
          <a:xfrm>
            <a:off x="1481485" y="1172642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30415F8-C449-2247-9E26-675EDC8597DE}"/>
              </a:ext>
            </a:extLst>
          </p:cNvPr>
          <p:cNvSpPr txBox="1"/>
          <p:nvPr/>
        </p:nvSpPr>
        <p:spPr>
          <a:xfrm>
            <a:off x="5716593" y="1159757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C94FDA9-8556-834D-9B86-A7AB529D5D9A}"/>
              </a:ext>
            </a:extLst>
          </p:cNvPr>
          <p:cNvSpPr txBox="1"/>
          <p:nvPr/>
        </p:nvSpPr>
        <p:spPr>
          <a:xfrm>
            <a:off x="2279208" y="1172741"/>
            <a:ext cx="3179377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8+ CD69+ T</a:t>
            </a:r>
            <a:r>
              <a:rPr lang="en-US" sz="1200" baseline="-25000" dirty="0"/>
              <a:t>EM</a:t>
            </a:r>
            <a:r>
              <a:rPr lang="en-US" sz="1200" dirty="0"/>
              <a:t> – protection associated multifunctional population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16C2BC3-33E2-4D49-8D26-67D5164381EE}"/>
              </a:ext>
            </a:extLst>
          </p:cNvPr>
          <p:cNvSpPr txBox="1"/>
          <p:nvPr/>
        </p:nvSpPr>
        <p:spPr>
          <a:xfrm>
            <a:off x="6694666" y="1172741"/>
            <a:ext cx="3179377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8+ CD69+ T</a:t>
            </a:r>
            <a:r>
              <a:rPr lang="en-US" sz="1200" baseline="-25000" dirty="0"/>
              <a:t>EM</a:t>
            </a:r>
            <a:r>
              <a:rPr lang="en-US" sz="1200" dirty="0"/>
              <a:t> – protection associated multifunctional populations plus Granzyme 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F0AF83E-9281-D946-90A7-14D4AA8E7A51}"/>
              </a:ext>
            </a:extLst>
          </p:cNvPr>
          <p:cNvSpPr txBox="1"/>
          <p:nvPr/>
        </p:nvSpPr>
        <p:spPr>
          <a:xfrm rot="16200000">
            <a:off x="766614" y="2318965"/>
            <a:ext cx="22913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ultifunctional Population (%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7EB98CE-EB72-4042-87EB-4FF5A14D1464}"/>
              </a:ext>
            </a:extLst>
          </p:cNvPr>
          <p:cNvSpPr txBox="1"/>
          <p:nvPr/>
        </p:nvSpPr>
        <p:spPr>
          <a:xfrm rot="16200000">
            <a:off x="4984670" y="2249430"/>
            <a:ext cx="24303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ultifunctional Population (%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6E78CBA-63E4-1B45-8CE1-79F43FC49929}"/>
              </a:ext>
            </a:extLst>
          </p:cNvPr>
          <p:cNvSpPr/>
          <p:nvPr/>
        </p:nvSpPr>
        <p:spPr>
          <a:xfrm>
            <a:off x="1551683" y="5385076"/>
            <a:ext cx="9057035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l Fig 7. Additional </a:t>
            </a:r>
            <a:r>
              <a:rPr lang="en-US" sz="825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alysis of CD8+ CD69+ T effector memory populations. A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nlist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FCOM identified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multifunctional responses, shown in a previous </a:t>
            </a:r>
            <a:r>
              <a:rPr lang="en-US" sz="825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. Typhi challenge study (10,11) to be associated with protection from developing disease, as well as from those same populations plus Granzyme B expression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B)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from the most multifunctional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A+B)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825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 clusters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.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pression of non-conventional CD8 markers ICOS, CD154 (CD40L), and CXCR5, as well as exhaustion/activation marker PD-1 among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</a:t>
            </a:r>
            <a:r>
              <a:rPr lang="en-US" sz="825" baseline="-25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M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lusters.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D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female (n=14) and male (n=17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E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gender/age group and vaccination status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</a:t>
            </a:r>
            <a:r>
              <a:rPr lang="en-US" sz="825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HLA-E*01:01 (n=10), HLA-E*01:03 (n=6), and HLA-E heterozygous (n=12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G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HLA-E haplotype and vaccination status. </a:t>
            </a:r>
            <a:endParaRPr lang="en-US" sz="8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138E864-E2AA-C54B-A0AA-3F7C2D76E8D9}"/>
              </a:ext>
            </a:extLst>
          </p:cNvPr>
          <p:cNvSpPr txBox="1"/>
          <p:nvPr/>
        </p:nvSpPr>
        <p:spPr>
          <a:xfrm>
            <a:off x="282780" y="378272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b="1" dirty="0"/>
              <a:t>7</a:t>
            </a:r>
          </a:p>
        </p:txBody>
      </p:sp>
    </p:spTree>
    <p:extLst>
      <p:ext uri="{BB962C8B-B14F-4D97-AF65-F5344CB8AC3E}">
        <p14:creationId xmlns:p14="http://schemas.microsoft.com/office/powerpoint/2010/main" val="284648323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>
            <a:extLst>
              <a:ext uri="{FF2B5EF4-FFF2-40B4-BE49-F238E27FC236}">
                <a16:creationId xmlns:a16="http://schemas.microsoft.com/office/drawing/2014/main" id="{FE2B0B90-FA88-374C-8540-7F8CEB5BF9B3}"/>
              </a:ext>
            </a:extLst>
          </p:cNvPr>
          <p:cNvSpPr txBox="1"/>
          <p:nvPr/>
        </p:nvSpPr>
        <p:spPr>
          <a:xfrm>
            <a:off x="4123205" y="1743819"/>
            <a:ext cx="405364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8+ CD69+ T</a:t>
            </a:r>
            <a:r>
              <a:rPr lang="en-US" sz="1200" baseline="-25000" dirty="0"/>
              <a:t>EM</a:t>
            </a:r>
            <a:r>
              <a:rPr lang="en-US" sz="1200" dirty="0"/>
              <a:t> – additional expressio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0DC3BC3-9867-2F4D-B092-7730739E1543}"/>
              </a:ext>
            </a:extLst>
          </p:cNvPr>
          <p:cNvSpPr txBox="1"/>
          <p:nvPr/>
        </p:nvSpPr>
        <p:spPr>
          <a:xfrm>
            <a:off x="1533017" y="857250"/>
            <a:ext cx="2027603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350" dirty="0"/>
              <a:t>Supplemental Figure 7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7BFB9C-8518-384E-A02D-B30E7C2A6E79}"/>
              </a:ext>
            </a:extLst>
          </p:cNvPr>
          <p:cNvSpPr txBox="1"/>
          <p:nvPr/>
        </p:nvSpPr>
        <p:spPr>
          <a:xfrm>
            <a:off x="3905248" y="1526806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201FE8C-CEDD-4543-9C87-F44F8003CCA6}"/>
              </a:ext>
            </a:extLst>
          </p:cNvPr>
          <p:cNvSpPr txBox="1"/>
          <p:nvPr/>
        </p:nvSpPr>
        <p:spPr>
          <a:xfrm rot="16200000">
            <a:off x="3079526" y="2963313"/>
            <a:ext cx="2087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edian Expressio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8718E97-72A5-E148-9ACD-77564BBBE93B}"/>
              </a:ext>
            </a:extLst>
          </p:cNvPr>
          <p:cNvSpPr txBox="1"/>
          <p:nvPr/>
        </p:nvSpPr>
        <p:spPr>
          <a:xfrm>
            <a:off x="5434061" y="4403790"/>
            <a:ext cx="1505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luster (#)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515C6312-C5B2-C141-ADE0-6A188E2BA766}"/>
              </a:ext>
            </a:extLst>
          </p:cNvPr>
          <p:cNvSpPr/>
          <p:nvPr/>
        </p:nvSpPr>
        <p:spPr>
          <a:xfrm>
            <a:off x="1561995" y="5083636"/>
            <a:ext cx="9057035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l Fig 7. Additional </a:t>
            </a:r>
            <a:r>
              <a:rPr lang="en-US" sz="825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alysis of CD8+CD69+ T effector memory populations. A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nlist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FCOM identified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multifunctional responses, shown in a previous </a:t>
            </a:r>
            <a:r>
              <a:rPr lang="en-US" sz="825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. Typhi challenge study (10,11) to be associated with protection from developing disease, as well as from those same populations plus Granzyme B expression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B)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from the most multifunctional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A+B)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825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 clusters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.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pression of non-conventional CD8 markers ICOS, CD154 (CD40L), and CXCR5, as well as exhaustion/activation marker PD-1 and TNF-receptor super-family member CD27, among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</a:t>
            </a:r>
            <a:r>
              <a:rPr lang="en-US" sz="825" baseline="-25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M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lusters.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D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female (n=14) and male (n=17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E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gender/age group and vaccination status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</a:t>
            </a:r>
            <a:r>
              <a:rPr lang="en-US" sz="825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HLA-E*01:01 (n=10), HLA-E*01:03 (n=6), and HLA-E heterozygous (n=12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G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HLA-E haplotype and vaccination status. </a:t>
            </a:r>
            <a:endParaRPr lang="en-US" sz="8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24D7442-487A-C44C-9A52-4104399998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89685" y="2020817"/>
            <a:ext cx="3720684" cy="24760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999234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14A081A-A865-B448-9B57-967DA9E6A3E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08022" y="1396165"/>
            <a:ext cx="3454822" cy="218110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078" b="6494"/>
          <a:stretch/>
        </p:blipFill>
        <p:spPr>
          <a:xfrm>
            <a:off x="2236546" y="1711196"/>
            <a:ext cx="1802845" cy="156156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078" b="6494"/>
          <a:stretch/>
        </p:blipFill>
        <p:spPr>
          <a:xfrm>
            <a:off x="2236546" y="3316388"/>
            <a:ext cx="1802845" cy="156156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904" b="6666"/>
          <a:stretch/>
        </p:blipFill>
        <p:spPr>
          <a:xfrm>
            <a:off x="4125324" y="1711197"/>
            <a:ext cx="1790697" cy="155104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905" b="6319"/>
          <a:stretch/>
        </p:blipFill>
        <p:spPr>
          <a:xfrm>
            <a:off x="4125323" y="3316388"/>
            <a:ext cx="1796041" cy="156156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385367" y="1455182"/>
            <a:ext cx="1505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re-Vaccination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1371444" y="2284821"/>
            <a:ext cx="1428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Female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1371444" y="3958671"/>
            <a:ext cx="1428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ale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533016" y="857250"/>
            <a:ext cx="2028506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350" dirty="0"/>
              <a:t>Supplemental Figure 7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644092" y="1232866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200420" y="1276816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144DF7D-D470-144B-9791-51FC71307FE9}"/>
              </a:ext>
            </a:extLst>
          </p:cNvPr>
          <p:cNvSpPr txBox="1"/>
          <p:nvPr/>
        </p:nvSpPr>
        <p:spPr>
          <a:xfrm>
            <a:off x="2350735" y="2982950"/>
            <a:ext cx="9129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4 (all ages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A58FBDE-2BB0-F443-9F64-1C35143A123C}"/>
              </a:ext>
            </a:extLst>
          </p:cNvPr>
          <p:cNvSpPr txBox="1"/>
          <p:nvPr/>
        </p:nvSpPr>
        <p:spPr>
          <a:xfrm>
            <a:off x="4218766" y="2977688"/>
            <a:ext cx="9129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4 (all ages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C0D0108-12F4-3047-8BB2-B8997CF51490}"/>
              </a:ext>
            </a:extLst>
          </p:cNvPr>
          <p:cNvSpPr txBox="1"/>
          <p:nvPr/>
        </p:nvSpPr>
        <p:spPr>
          <a:xfrm>
            <a:off x="2339899" y="4607234"/>
            <a:ext cx="9129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7 (all ages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BBB795B-1753-F041-9AD1-2B16BE81BC6B}"/>
              </a:ext>
            </a:extLst>
          </p:cNvPr>
          <p:cNvSpPr txBox="1"/>
          <p:nvPr/>
        </p:nvSpPr>
        <p:spPr>
          <a:xfrm>
            <a:off x="4207930" y="4601972"/>
            <a:ext cx="9129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7 (all ages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16B2EFA-DA03-8A4F-968B-BFA8313B7A52}"/>
              </a:ext>
            </a:extLst>
          </p:cNvPr>
          <p:cNvSpPr txBox="1"/>
          <p:nvPr/>
        </p:nvSpPr>
        <p:spPr>
          <a:xfrm>
            <a:off x="7487405" y="1229137"/>
            <a:ext cx="179805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D8+ CD69+ T</a:t>
            </a:r>
            <a:r>
              <a:rPr lang="en-US" sz="1350" baseline="-25000" dirty="0"/>
              <a:t>EM</a:t>
            </a:r>
            <a:r>
              <a:rPr lang="en-US" sz="1350" dirty="0"/>
              <a:t> cells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B53D171-9F97-DE4D-AEEB-84D008DD0A88}"/>
              </a:ext>
            </a:extLst>
          </p:cNvPr>
          <p:cNvSpPr txBox="1"/>
          <p:nvPr/>
        </p:nvSpPr>
        <p:spPr>
          <a:xfrm>
            <a:off x="7742630" y="3539049"/>
            <a:ext cx="1505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luster (#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CA76455-EE4E-2945-A6F7-1BA8A7CEB91B}"/>
              </a:ext>
            </a:extLst>
          </p:cNvPr>
          <p:cNvSpPr txBox="1"/>
          <p:nvPr/>
        </p:nvSpPr>
        <p:spPr>
          <a:xfrm rot="16200000">
            <a:off x="5330315" y="2337045"/>
            <a:ext cx="25370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Averaged # Cells Per Volunteer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934DA9EE-CBFD-2E4A-AE61-7BF90F604399}"/>
              </a:ext>
            </a:extLst>
          </p:cNvPr>
          <p:cNvSpPr/>
          <p:nvPr/>
        </p:nvSpPr>
        <p:spPr>
          <a:xfrm>
            <a:off x="1561995" y="5083636"/>
            <a:ext cx="9057035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l Fig 7. Additional </a:t>
            </a:r>
            <a:r>
              <a:rPr lang="en-US" sz="825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alysis of CD8+CD69+ T effector memory populations. A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nlist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FCOM identified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multifunctional responses, shown in a previous </a:t>
            </a:r>
            <a:r>
              <a:rPr lang="en-US" sz="825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. Typhi challenge study (10,11) to be associated with protection from developing disease, as well as from those same populations plus Granzyme B expression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B)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from the most multifunctional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A+B)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825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 clusters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.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pression of non-conventional CD8 markers ICOS, CD154 (CD40L), and CXCR5, as well as exhaustion/activation marker PD-1 among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</a:t>
            </a:r>
            <a:r>
              <a:rPr lang="en-US" sz="825" baseline="-25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M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lusters.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D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female (n=14) and male (n=17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E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gender/age group and vaccination status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</a:t>
            </a:r>
            <a:r>
              <a:rPr lang="en-US" sz="825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HLA-E*01:01 (n=10), HLA-E*01:03 (n=6), and HLA-E heterozygous (n=12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G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HLA-E haplotype and vaccination status. </a:t>
            </a:r>
            <a:endParaRPr lang="en-US" sz="8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3096ABB-1A08-3D4D-8898-98A1DC3DDDC5}"/>
              </a:ext>
            </a:extLst>
          </p:cNvPr>
          <p:cNvSpPr txBox="1"/>
          <p:nvPr/>
        </p:nvSpPr>
        <p:spPr>
          <a:xfrm>
            <a:off x="4370711" y="1455181"/>
            <a:ext cx="13863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ost-Vaccination</a:t>
            </a:r>
          </a:p>
        </p:txBody>
      </p:sp>
    </p:spTree>
    <p:extLst>
      <p:ext uri="{BB962C8B-B14F-4D97-AF65-F5344CB8AC3E}">
        <p14:creationId xmlns:p14="http://schemas.microsoft.com/office/powerpoint/2010/main" val="252604695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00245" y="1080839"/>
            <a:ext cx="1644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re-Vaccination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2011548" y="1866813"/>
            <a:ext cx="1428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HLA-E*01:01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2011547" y="3419952"/>
            <a:ext cx="1428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HLA-E*01:03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1774542" y="4930398"/>
            <a:ext cx="18976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HLA-E Heterozygous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078" b="6494"/>
          <a:stretch/>
        </p:blipFill>
        <p:spPr>
          <a:xfrm>
            <a:off x="2921915" y="1326713"/>
            <a:ext cx="1717206" cy="1487384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905" b="6493"/>
          <a:stretch/>
        </p:blipFill>
        <p:spPr>
          <a:xfrm>
            <a:off x="2921915" y="2879853"/>
            <a:ext cx="1713960" cy="148738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905" b="6493"/>
          <a:stretch/>
        </p:blipFill>
        <p:spPr>
          <a:xfrm>
            <a:off x="2921915" y="4385710"/>
            <a:ext cx="1713960" cy="1487384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078" b="6494"/>
          <a:stretch/>
        </p:blipFill>
        <p:spPr>
          <a:xfrm>
            <a:off x="4695057" y="1326713"/>
            <a:ext cx="1717207" cy="1487384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078" b="6666"/>
          <a:stretch/>
        </p:blipFill>
        <p:spPr>
          <a:xfrm>
            <a:off x="4695057" y="2879853"/>
            <a:ext cx="1720465" cy="1487384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905" b="6319"/>
          <a:stretch/>
        </p:blipFill>
        <p:spPr>
          <a:xfrm>
            <a:off x="4698302" y="4382897"/>
            <a:ext cx="1713960" cy="1490196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533016" y="857250"/>
            <a:ext cx="2647922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350" dirty="0"/>
              <a:t>Supplemental Figure 7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D63F890-EB12-674B-8A98-B6579BC619C8}"/>
              </a:ext>
            </a:extLst>
          </p:cNvPr>
          <p:cNvSpPr txBox="1"/>
          <p:nvPr/>
        </p:nvSpPr>
        <p:spPr>
          <a:xfrm>
            <a:off x="6412264" y="1320296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G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A7BE24B-0FB7-DA4D-A8C0-C0BB088778E0}"/>
              </a:ext>
            </a:extLst>
          </p:cNvPr>
          <p:cNvSpPr txBox="1"/>
          <p:nvPr/>
        </p:nvSpPr>
        <p:spPr>
          <a:xfrm>
            <a:off x="1979848" y="1317896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F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03DCE31-42C8-0148-A7B9-233A0A5DB9F5}"/>
              </a:ext>
            </a:extLst>
          </p:cNvPr>
          <p:cNvSpPr txBox="1"/>
          <p:nvPr/>
        </p:nvSpPr>
        <p:spPr>
          <a:xfrm>
            <a:off x="3055532" y="2541234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0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D273E03-72A8-0C46-8DA9-F1E38F91DE00}"/>
              </a:ext>
            </a:extLst>
          </p:cNvPr>
          <p:cNvSpPr txBox="1"/>
          <p:nvPr/>
        </p:nvSpPr>
        <p:spPr>
          <a:xfrm>
            <a:off x="4843391" y="2541234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0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9804B0E-BBA4-B449-B8FD-E26522C306DF}"/>
              </a:ext>
            </a:extLst>
          </p:cNvPr>
          <p:cNvSpPr txBox="1"/>
          <p:nvPr/>
        </p:nvSpPr>
        <p:spPr>
          <a:xfrm>
            <a:off x="3055532" y="4064849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6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6B65EBF-A283-A24C-A30A-3C45C996F802}"/>
              </a:ext>
            </a:extLst>
          </p:cNvPr>
          <p:cNvSpPr txBox="1"/>
          <p:nvPr/>
        </p:nvSpPr>
        <p:spPr>
          <a:xfrm>
            <a:off x="4866473" y="4064849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6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604512F-E2E9-1149-B623-6EADE50BBB78}"/>
              </a:ext>
            </a:extLst>
          </p:cNvPr>
          <p:cNvSpPr txBox="1"/>
          <p:nvPr/>
        </p:nvSpPr>
        <p:spPr>
          <a:xfrm>
            <a:off x="3055532" y="5600251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B5E24ED-66E9-9A4B-8596-3EF3036F6BBA}"/>
              </a:ext>
            </a:extLst>
          </p:cNvPr>
          <p:cNvSpPr txBox="1"/>
          <p:nvPr/>
        </p:nvSpPr>
        <p:spPr>
          <a:xfrm>
            <a:off x="4840745" y="5600250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53F3FDE-18E3-024F-A62C-0329F436E7AD}"/>
              </a:ext>
            </a:extLst>
          </p:cNvPr>
          <p:cNvSpPr txBox="1"/>
          <p:nvPr/>
        </p:nvSpPr>
        <p:spPr>
          <a:xfrm>
            <a:off x="7542390" y="1208608"/>
            <a:ext cx="2221539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D8+ CD69+ T</a:t>
            </a:r>
            <a:r>
              <a:rPr lang="en-US" sz="1350" baseline="-25000" dirty="0"/>
              <a:t>EM</a:t>
            </a:r>
            <a:r>
              <a:rPr lang="en-US" sz="1350" dirty="0"/>
              <a:t> cells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2E39846-76BC-AA4E-82C5-FEA7AF15ADAF}"/>
              </a:ext>
            </a:extLst>
          </p:cNvPr>
          <p:cNvSpPr txBox="1"/>
          <p:nvPr/>
        </p:nvSpPr>
        <p:spPr>
          <a:xfrm>
            <a:off x="7894198" y="3593001"/>
            <a:ext cx="1505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luster (#)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56EDABA5-B384-214A-BBB0-07AFAE912C4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54456" y="1440145"/>
            <a:ext cx="3217876" cy="2165771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57BBBD97-669E-044C-8A16-9B44C1710985}"/>
              </a:ext>
            </a:extLst>
          </p:cNvPr>
          <p:cNvSpPr txBox="1"/>
          <p:nvPr/>
        </p:nvSpPr>
        <p:spPr>
          <a:xfrm rot="16200000">
            <a:off x="5581716" y="2338914"/>
            <a:ext cx="24340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Averaged # Cells Per Volunteer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49A4DBF9-2C7D-FC43-AF13-533B32D81788}"/>
              </a:ext>
            </a:extLst>
          </p:cNvPr>
          <p:cNvSpPr/>
          <p:nvPr/>
        </p:nvSpPr>
        <p:spPr>
          <a:xfrm>
            <a:off x="6676495" y="3902190"/>
            <a:ext cx="3838376" cy="19967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l Fig 7. Additional </a:t>
            </a:r>
            <a:r>
              <a:rPr lang="en-US" sz="825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alysis of CD8+CD69+ T effector memory populations. A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nlist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FCOM identified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multifunctional responses, shown in a previous </a:t>
            </a:r>
            <a:r>
              <a:rPr lang="en-US" sz="825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. Typhi challenge study (10,11) to be associated with protection from developing disease, as well as from those same populations plus Granzyme B expression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B)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from the most multifunctional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A+B)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825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 clusters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.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pression of non-conventional CD8 markers ICOS, CD154 (CD40L), and CXCR5, as well as exhaustion/activation marker PD-1 among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</a:t>
            </a:r>
            <a:r>
              <a:rPr lang="en-US" sz="825" baseline="-25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M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lusters.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D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female (n=14) and male (n=17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E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gender/age group and vaccination status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</a:t>
            </a:r>
            <a:r>
              <a:rPr lang="en-US" sz="825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HLA-E*01:01 (n=10), HLA-E*01:03 (n=6), and HLA-E heterozygous (n=12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G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HLA-E haplotype and vaccination status. </a:t>
            </a:r>
            <a:endParaRPr lang="en-US" sz="8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869E7CC-D849-6A46-A127-60C0D7D04C67}"/>
              </a:ext>
            </a:extLst>
          </p:cNvPr>
          <p:cNvSpPr txBox="1"/>
          <p:nvPr/>
        </p:nvSpPr>
        <p:spPr>
          <a:xfrm>
            <a:off x="4756418" y="1074989"/>
            <a:ext cx="1533436" cy="2828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ost-Vaccination</a:t>
            </a:r>
          </a:p>
        </p:txBody>
      </p:sp>
    </p:spTree>
    <p:extLst>
      <p:ext uri="{BB962C8B-B14F-4D97-AF65-F5344CB8AC3E}">
        <p14:creationId xmlns:p14="http://schemas.microsoft.com/office/powerpoint/2010/main" val="202750838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51F0CDA1-81BC-A64B-83CC-2C66C6F62B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0551074"/>
              </p:ext>
            </p:extLst>
          </p:nvPr>
        </p:nvGraphicFramePr>
        <p:xfrm>
          <a:off x="1745438" y="3715452"/>
          <a:ext cx="3957184" cy="13487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5312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TNFα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MIP-1β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CD107a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IFN𝛾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IL-2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</a:tbl>
          </a:graphicData>
        </a:graphic>
      </p:graphicFrame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F235226F-1923-DF43-8BA6-F7D663497E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8233807"/>
              </p:ext>
            </p:extLst>
          </p:nvPr>
        </p:nvGraphicFramePr>
        <p:xfrm>
          <a:off x="6180775" y="3715452"/>
          <a:ext cx="3957184" cy="158496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65312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565312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TNFα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MIP-1β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CD107a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IFN𝛾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IL-2</a:t>
                      </a:r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100" b="1" dirty="0"/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err="1"/>
                        <a:t>GzmB</a:t>
                      </a:r>
                      <a:endParaRPr lang="en-US" sz="1100" dirty="0"/>
                    </a:p>
                  </a:txBody>
                  <a:tcPr marL="68580" marR="68580" marT="34290" marB="3429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/>
                        <a:t>✓</a:t>
                      </a:r>
                    </a:p>
                  </a:txBody>
                  <a:tcPr marL="68580" marR="68580" marT="34290" marB="34290" anchor="ctr"/>
                </a:tc>
                <a:extLst>
                  <a:ext uri="{0D108BD9-81ED-4DB2-BD59-A6C34878D82A}">
                    <a16:rowId xmlns:a16="http://schemas.microsoft.com/office/drawing/2014/main" val="1362922051"/>
                  </a:ext>
                </a:extLst>
              </a:tr>
            </a:tbl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E5000CDA-4962-5849-9A80-616B55FC36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88762" y="1540815"/>
            <a:ext cx="3532036" cy="2165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0D90FE9-A048-DF4F-97D6-B11A3C2EB8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89708" y="1536198"/>
            <a:ext cx="3719247" cy="21654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3010E58-03C4-9D4B-8394-46A70C8DD4BA}"/>
              </a:ext>
            </a:extLst>
          </p:cNvPr>
          <p:cNvSpPr txBox="1"/>
          <p:nvPr/>
        </p:nvSpPr>
        <p:spPr>
          <a:xfrm>
            <a:off x="1676284" y="1237031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F42E1E8-BD30-0048-BB5E-2267C57638F2}"/>
              </a:ext>
            </a:extLst>
          </p:cNvPr>
          <p:cNvSpPr txBox="1"/>
          <p:nvPr/>
        </p:nvSpPr>
        <p:spPr>
          <a:xfrm>
            <a:off x="5716593" y="1237031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82B5E61-1BC7-FA49-A958-559F3E8DF27C}"/>
              </a:ext>
            </a:extLst>
          </p:cNvPr>
          <p:cNvSpPr txBox="1"/>
          <p:nvPr/>
        </p:nvSpPr>
        <p:spPr>
          <a:xfrm>
            <a:off x="2279208" y="1250015"/>
            <a:ext cx="31793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8+ CD69+ T</a:t>
            </a:r>
            <a:r>
              <a:rPr lang="en-US" sz="1200" baseline="-25000" dirty="0"/>
              <a:t>EMRA</a:t>
            </a:r>
            <a:r>
              <a:rPr lang="en-US" sz="1200" dirty="0"/>
              <a:t> – protection associated multifunctional population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BC5A243-8647-C648-B049-446D65465A2A}"/>
              </a:ext>
            </a:extLst>
          </p:cNvPr>
          <p:cNvSpPr txBox="1"/>
          <p:nvPr/>
        </p:nvSpPr>
        <p:spPr>
          <a:xfrm>
            <a:off x="6545177" y="1251370"/>
            <a:ext cx="37962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8+ CD69+ T</a:t>
            </a:r>
            <a:r>
              <a:rPr lang="en-US" sz="1200" baseline="-25000" dirty="0"/>
              <a:t>EMRA</a:t>
            </a:r>
            <a:r>
              <a:rPr lang="en-US" sz="1200" dirty="0"/>
              <a:t> – protection associated multifunctional populations plus Granzyme 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B922CC-7297-8D4B-A02E-40A2904D2C3D}"/>
              </a:ext>
            </a:extLst>
          </p:cNvPr>
          <p:cNvSpPr txBox="1"/>
          <p:nvPr/>
        </p:nvSpPr>
        <p:spPr>
          <a:xfrm rot="16200000">
            <a:off x="939068" y="2423783"/>
            <a:ext cx="2228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ultifunctional Population (%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770940B-BF84-0841-9EDC-584D331E29BA}"/>
              </a:ext>
            </a:extLst>
          </p:cNvPr>
          <p:cNvSpPr txBox="1"/>
          <p:nvPr/>
        </p:nvSpPr>
        <p:spPr>
          <a:xfrm rot="16200000">
            <a:off x="5133876" y="2320603"/>
            <a:ext cx="2426421" cy="2852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ultifunctional Population (%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4C9CFABE-A776-3349-9EF0-FDCE180620CF}"/>
              </a:ext>
            </a:extLst>
          </p:cNvPr>
          <p:cNvSpPr/>
          <p:nvPr/>
        </p:nvSpPr>
        <p:spPr>
          <a:xfrm>
            <a:off x="1535182" y="5452897"/>
            <a:ext cx="9057035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l Fig 8. Additional </a:t>
            </a:r>
            <a:r>
              <a:rPr lang="en-US" sz="825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alysis of CD8+CD69+ T effector memory RA populations. A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nlist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FCOM identified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multifunctional responses, shown in a previous </a:t>
            </a:r>
            <a:r>
              <a:rPr lang="en-US" sz="825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. Typhi challenge study (10,11) to be associated with protection from developing disease, as well as from those same populations plus Granzyme B expression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B)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from the most multifunctional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A+B)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825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 clusters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.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pression of non-conventional CD8 markers ICOS, CD154 (CD40L), and CXCR5, as well as exhaustion/activation marker PD-1 among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</a:t>
            </a:r>
            <a:r>
              <a:rPr lang="en-US" sz="825" baseline="-25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MRA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lusters.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D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female (n=14) and male (n=17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E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gender/age group and vaccination status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</a:t>
            </a:r>
            <a:r>
              <a:rPr lang="en-US" sz="825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HLA-E*01:01 (n=10), HLA-E*01:03 (n=6), and HLA-E heterozygous (n=12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G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HLA-E haplotype and vaccination status. </a:t>
            </a:r>
            <a:endParaRPr lang="en-US" sz="8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C696330-ABC1-374E-864E-36F03C451349}"/>
              </a:ext>
            </a:extLst>
          </p:cNvPr>
          <p:cNvSpPr txBox="1"/>
          <p:nvPr/>
        </p:nvSpPr>
        <p:spPr>
          <a:xfrm>
            <a:off x="336477" y="480500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b="1" dirty="0"/>
              <a:t>8</a:t>
            </a:r>
          </a:p>
        </p:txBody>
      </p:sp>
    </p:spTree>
    <p:extLst>
      <p:ext uri="{BB962C8B-B14F-4D97-AF65-F5344CB8AC3E}">
        <p14:creationId xmlns:p14="http://schemas.microsoft.com/office/powerpoint/2010/main" val="100432118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2DB98226-864F-0B47-BDB2-216AD4C58D53}"/>
              </a:ext>
            </a:extLst>
          </p:cNvPr>
          <p:cNvSpPr txBox="1"/>
          <p:nvPr/>
        </p:nvSpPr>
        <p:spPr>
          <a:xfrm>
            <a:off x="4158655" y="1644549"/>
            <a:ext cx="419393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8+ CD69+ T</a:t>
            </a:r>
            <a:r>
              <a:rPr lang="en-US" sz="1200" baseline="-25000" dirty="0"/>
              <a:t>EMRA</a:t>
            </a:r>
            <a:r>
              <a:rPr lang="en-US" sz="1200" dirty="0"/>
              <a:t> – additional expressio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0DC3BC3-9867-2F4D-B092-7730739E1543}"/>
              </a:ext>
            </a:extLst>
          </p:cNvPr>
          <p:cNvSpPr txBox="1"/>
          <p:nvPr/>
        </p:nvSpPr>
        <p:spPr>
          <a:xfrm>
            <a:off x="796225" y="604648"/>
            <a:ext cx="2027603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350" dirty="0"/>
              <a:t>Supplemental Figure 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8033C27-AE59-754E-825D-407F37E253B4}"/>
              </a:ext>
            </a:extLst>
          </p:cNvPr>
          <p:cNvSpPr txBox="1"/>
          <p:nvPr/>
        </p:nvSpPr>
        <p:spPr>
          <a:xfrm>
            <a:off x="3813739" y="1427536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C48B7A9-3829-E042-A6A9-85756F173945}"/>
              </a:ext>
            </a:extLst>
          </p:cNvPr>
          <p:cNvSpPr txBox="1"/>
          <p:nvPr/>
        </p:nvSpPr>
        <p:spPr>
          <a:xfrm rot="16200000">
            <a:off x="3128309" y="2803647"/>
            <a:ext cx="2087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edian Expressio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DACD4AF-F730-5349-BBC1-C8007D97D7EF}"/>
              </a:ext>
            </a:extLst>
          </p:cNvPr>
          <p:cNvSpPr txBox="1"/>
          <p:nvPr/>
        </p:nvSpPr>
        <p:spPr>
          <a:xfrm>
            <a:off x="5503024" y="4296589"/>
            <a:ext cx="1505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luster (#)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77454FB-1A79-5A40-9277-BBDA4C2384FC}"/>
              </a:ext>
            </a:extLst>
          </p:cNvPr>
          <p:cNvSpPr/>
          <p:nvPr/>
        </p:nvSpPr>
        <p:spPr>
          <a:xfrm>
            <a:off x="1561995" y="5122273"/>
            <a:ext cx="9057035" cy="9810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l Fig 8. Additional </a:t>
            </a:r>
            <a:r>
              <a:rPr lang="en-US" sz="825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alysis of CD8+CD69+ T effector memory RA populations. A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nlist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FCOM identified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multifunctional responses, shown in a previous </a:t>
            </a:r>
            <a:r>
              <a:rPr lang="en-US" sz="825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. Typhi challenge study (10,11) to be associated with protection from developing disease, as well as from those same populations plus Granzyme B expression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B)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from the most multifunctional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A+B)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825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 clusters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.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pression of non-conventional CD8 markers ICOS, CD154 (CD40L), and CXCR5, as well as exhaustion/activation marker PD-1 and TNF-receptor super-family member CD27, among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</a:t>
            </a:r>
            <a:r>
              <a:rPr lang="en-US" sz="825" baseline="-25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MRA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lusters.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D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female (n=14) and male (n=17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E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gender/age group and vaccination status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</a:t>
            </a:r>
            <a:r>
              <a:rPr lang="en-US" sz="825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HLA-E*01:01 (n=10), HLA-E*01:03 (n=6), and HLA-E heterozygous (n=12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G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HLA-E haplotype and vaccination status. </a:t>
            </a:r>
            <a:endParaRPr lang="en-US" sz="8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F20B302-3C02-C042-A0B0-A992787634C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17576" y="1885872"/>
            <a:ext cx="3676095" cy="24463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141860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7618482-C291-BA43-BBFE-D7A70F4659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66103" y="1339982"/>
            <a:ext cx="3430154" cy="216553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644861" y="1692983"/>
            <a:ext cx="1505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re-Vaccination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1630937" y="2522622"/>
            <a:ext cx="1428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Female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1630938" y="4196471"/>
            <a:ext cx="1428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ale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57" b="6274"/>
          <a:stretch/>
        </p:blipFill>
        <p:spPr>
          <a:xfrm>
            <a:off x="2472119" y="1995247"/>
            <a:ext cx="1732349" cy="150279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52" b="6274"/>
          <a:stretch/>
        </p:blipFill>
        <p:spPr>
          <a:xfrm>
            <a:off x="2472118" y="3620745"/>
            <a:ext cx="1736726" cy="150337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57" b="6079"/>
          <a:stretch/>
        </p:blipFill>
        <p:spPr>
          <a:xfrm>
            <a:off x="4410821" y="1995247"/>
            <a:ext cx="1728647" cy="150279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57" b="6470"/>
          <a:stretch/>
        </p:blipFill>
        <p:spPr>
          <a:xfrm>
            <a:off x="4410820" y="3620745"/>
            <a:ext cx="1736726" cy="150337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533017" y="857250"/>
            <a:ext cx="1923631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350" dirty="0"/>
              <a:t>Supplemental Figure 8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034991" y="1608547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1A8C1E6-B13D-7B47-9816-46F3FEC9312A}"/>
              </a:ext>
            </a:extLst>
          </p:cNvPr>
          <p:cNvSpPr txBox="1"/>
          <p:nvPr/>
        </p:nvSpPr>
        <p:spPr>
          <a:xfrm>
            <a:off x="2543690" y="3246977"/>
            <a:ext cx="11119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4 (all ages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5D9367A-45DD-4144-BAAF-9AFF65887706}"/>
              </a:ext>
            </a:extLst>
          </p:cNvPr>
          <p:cNvSpPr txBox="1"/>
          <p:nvPr/>
        </p:nvSpPr>
        <p:spPr>
          <a:xfrm>
            <a:off x="4471354" y="3241715"/>
            <a:ext cx="1150969" cy="236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4 (all ages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36EB314-C6A0-A642-BEED-933AABFCD958}"/>
              </a:ext>
            </a:extLst>
          </p:cNvPr>
          <p:cNvSpPr txBox="1"/>
          <p:nvPr/>
        </p:nvSpPr>
        <p:spPr>
          <a:xfrm>
            <a:off x="2532854" y="4871261"/>
            <a:ext cx="1150969" cy="236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7 (all ages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57B724B-E609-8B43-A253-984EA1D68FB2}"/>
              </a:ext>
            </a:extLst>
          </p:cNvPr>
          <p:cNvSpPr txBox="1"/>
          <p:nvPr/>
        </p:nvSpPr>
        <p:spPr>
          <a:xfrm>
            <a:off x="4460518" y="4865999"/>
            <a:ext cx="1150969" cy="2360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7 (all ages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30864C0-1BD6-4D46-B596-746F3EA0555B}"/>
              </a:ext>
            </a:extLst>
          </p:cNvPr>
          <p:cNvSpPr txBox="1"/>
          <p:nvPr/>
        </p:nvSpPr>
        <p:spPr>
          <a:xfrm>
            <a:off x="6200420" y="1276816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2603870-8CF2-3142-B413-8B26553EC8C8}"/>
              </a:ext>
            </a:extLst>
          </p:cNvPr>
          <p:cNvSpPr txBox="1"/>
          <p:nvPr/>
        </p:nvSpPr>
        <p:spPr>
          <a:xfrm>
            <a:off x="7337848" y="1134248"/>
            <a:ext cx="2386918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D8+ CD69+ T</a:t>
            </a:r>
            <a:r>
              <a:rPr lang="en-US" sz="1350" baseline="-25000" dirty="0"/>
              <a:t>EMRA</a:t>
            </a:r>
            <a:r>
              <a:rPr lang="en-US" sz="1350" dirty="0"/>
              <a:t> cell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E690E61-FC04-4A41-8A1A-C8435B9FD2EE}"/>
              </a:ext>
            </a:extLst>
          </p:cNvPr>
          <p:cNvSpPr txBox="1"/>
          <p:nvPr/>
        </p:nvSpPr>
        <p:spPr>
          <a:xfrm>
            <a:off x="7728580" y="3498046"/>
            <a:ext cx="1505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luster (#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F13C02F-14D9-E845-BC34-A68BE3979526}"/>
              </a:ext>
            </a:extLst>
          </p:cNvPr>
          <p:cNvSpPr txBox="1"/>
          <p:nvPr/>
        </p:nvSpPr>
        <p:spPr>
          <a:xfrm rot="16200000">
            <a:off x="5374496" y="2184233"/>
            <a:ext cx="24350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Averaged # Cells Per Volunteer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229C4588-7EB6-D84E-AE2B-0AB9A8687F08}"/>
              </a:ext>
            </a:extLst>
          </p:cNvPr>
          <p:cNvSpPr/>
          <p:nvPr/>
        </p:nvSpPr>
        <p:spPr>
          <a:xfrm>
            <a:off x="1574542" y="5440368"/>
            <a:ext cx="9057035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l Fig 8. Additional </a:t>
            </a:r>
            <a:r>
              <a:rPr lang="en-US" sz="825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alysis of CD8+CD69+ T effector memory RA populations. A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nlist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FCOM identified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multifunctional responses, shown in a previous </a:t>
            </a:r>
            <a:r>
              <a:rPr lang="en-US" sz="825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. Typhi challenge study (10,11) to be associated with protection from developing disease, as well as from those same populations plus Granzyme B expression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B)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from the most multifunctional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A+B)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825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 clusters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.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pression of non-conventional CD8 markers ICOS, CD154 (CD40L), and CXCR5, as well as exhaustion/activation marker PD-1 among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</a:t>
            </a:r>
            <a:r>
              <a:rPr lang="en-US" sz="825" baseline="-25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MRA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lusters.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D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female (n=14) and male (n=17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E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gender/age group and vaccination status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</a:t>
            </a:r>
            <a:r>
              <a:rPr lang="en-US" sz="825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HLA-E*01:01 (n=10), HLA-E*01:03 (n=6), and HLA-E heterozygous (n=12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G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HLA-E haplotype and vaccination status. </a:t>
            </a:r>
            <a:endParaRPr lang="en-US" sz="8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DA5B5ED-CEAD-E848-BC2A-113F16AE8F7F}"/>
              </a:ext>
            </a:extLst>
          </p:cNvPr>
          <p:cNvSpPr txBox="1"/>
          <p:nvPr/>
        </p:nvSpPr>
        <p:spPr>
          <a:xfrm>
            <a:off x="4581954" y="1690964"/>
            <a:ext cx="13863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ost-Vaccination</a:t>
            </a:r>
          </a:p>
        </p:txBody>
      </p:sp>
    </p:spTree>
    <p:extLst>
      <p:ext uri="{BB962C8B-B14F-4D97-AF65-F5344CB8AC3E}">
        <p14:creationId xmlns:p14="http://schemas.microsoft.com/office/powerpoint/2010/main" val="25371971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2021" y="0"/>
            <a:ext cx="1539819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1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551840" y="1678552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56AABEF-3033-C343-95A9-29B6398F2C97}"/>
              </a:ext>
            </a:extLst>
          </p:cNvPr>
          <p:cNvSpPr txBox="1"/>
          <p:nvPr/>
        </p:nvSpPr>
        <p:spPr>
          <a:xfrm>
            <a:off x="2230855" y="1678552"/>
            <a:ext cx="303249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T</a:t>
            </a:r>
            <a:r>
              <a:rPr lang="en-US" baseline="-25000" dirty="0"/>
              <a:t>EM</a:t>
            </a:r>
            <a:r>
              <a:rPr lang="en-US" dirty="0"/>
              <a:t> (all ages)</a:t>
            </a:r>
            <a:endParaRPr lang="en-US" baseline="-250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967867FF-9E44-B44B-8C6E-438CBECD17F8}"/>
              </a:ext>
            </a:extLst>
          </p:cNvPr>
          <p:cNvSpPr txBox="1"/>
          <p:nvPr/>
        </p:nvSpPr>
        <p:spPr>
          <a:xfrm>
            <a:off x="6313582" y="1678552"/>
            <a:ext cx="314229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T</a:t>
            </a:r>
            <a:r>
              <a:rPr lang="en-US" baseline="-25000" dirty="0"/>
              <a:t>EMRA</a:t>
            </a:r>
            <a:r>
              <a:rPr lang="en-US" dirty="0"/>
              <a:t> (all ages)</a:t>
            </a:r>
            <a:endParaRPr lang="en-US" baseline="-250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5F3022CD-7447-DA45-B293-2B3FB7649049}"/>
              </a:ext>
            </a:extLst>
          </p:cNvPr>
          <p:cNvSpPr txBox="1"/>
          <p:nvPr/>
        </p:nvSpPr>
        <p:spPr>
          <a:xfrm rot="16200000">
            <a:off x="1008730" y="2855984"/>
            <a:ext cx="1858946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8+ CD62L- CD45RA- T Cells (%)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4B8ABE9-B5CB-124B-BDF8-9916951A0944}"/>
              </a:ext>
            </a:extLst>
          </p:cNvPr>
          <p:cNvSpPr txBox="1"/>
          <p:nvPr/>
        </p:nvSpPr>
        <p:spPr>
          <a:xfrm rot="16200000">
            <a:off x="5313302" y="2957881"/>
            <a:ext cx="1896799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8+ CD62L- CD45RA+ T Cells (%)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17CE63C4-BD07-6C45-98D0-78EF878F1D85}"/>
              </a:ext>
            </a:extLst>
          </p:cNvPr>
          <p:cNvSpPr txBox="1"/>
          <p:nvPr/>
        </p:nvSpPr>
        <p:spPr>
          <a:xfrm>
            <a:off x="5631573" y="1679085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03EDE95-1EFB-DB4C-9E4C-8D48819325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30855" y="2047884"/>
            <a:ext cx="3083539" cy="214793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9FC9DC7-3B4D-CC45-ACBB-33407A7998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40029" y="2122394"/>
            <a:ext cx="2977668" cy="2074188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>
            <a:off x="9517697" y="1822527"/>
            <a:ext cx="1421348" cy="612464"/>
            <a:chOff x="7355021" y="1783844"/>
            <a:chExt cx="1421348" cy="612464"/>
          </a:xfrm>
        </p:grpSpPr>
        <p:grpSp>
          <p:nvGrpSpPr>
            <p:cNvPr id="8" name="Group 7"/>
            <p:cNvGrpSpPr/>
            <p:nvPr/>
          </p:nvGrpSpPr>
          <p:grpSpPr>
            <a:xfrm>
              <a:off x="7362131" y="1783844"/>
              <a:ext cx="1414238" cy="612464"/>
              <a:chOff x="7437119" y="1671362"/>
              <a:chExt cx="1414238" cy="612464"/>
            </a:xfrm>
          </p:grpSpPr>
          <p:sp>
            <p:nvSpPr>
              <p:cNvPr id="15" name="Oval 14"/>
              <p:cNvSpPr/>
              <p:nvPr/>
            </p:nvSpPr>
            <p:spPr>
              <a:xfrm>
                <a:off x="7437119" y="1752600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rgbClr val="009193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Oval 15"/>
              <p:cNvSpPr/>
              <p:nvPr/>
            </p:nvSpPr>
            <p:spPr>
              <a:xfrm>
                <a:off x="7437119" y="1933647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rgbClr val="D883FF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528559" y="1671362"/>
                <a:ext cx="127470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LA-E*01:01 (n=10)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7528559" y="1852409"/>
                <a:ext cx="120577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LA-E*01:03 (n=6)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7528559" y="2029910"/>
                <a:ext cx="132279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eterozygous (n=12)</a:t>
                </a:r>
              </a:p>
            </p:txBody>
          </p:sp>
        </p:grpSp>
        <p:grpSp>
          <p:nvGrpSpPr>
            <p:cNvPr id="11" name="Group 10"/>
            <p:cNvGrpSpPr>
              <a:grpSpLocks noChangeAspect="1"/>
            </p:cNvGrpSpPr>
            <p:nvPr/>
          </p:nvGrpSpPr>
          <p:grpSpPr>
            <a:xfrm>
              <a:off x="7355021" y="2225593"/>
              <a:ext cx="107572" cy="100584"/>
              <a:chOff x="6717066" y="5643716"/>
              <a:chExt cx="743963" cy="685800"/>
            </a:xfrm>
          </p:grpSpPr>
          <p:sp>
            <p:nvSpPr>
              <p:cNvPr id="13" name="Chord 12"/>
              <p:cNvSpPr/>
              <p:nvPr/>
            </p:nvSpPr>
            <p:spPr>
              <a:xfrm>
                <a:off x="6717066" y="5643716"/>
                <a:ext cx="685800" cy="685800"/>
              </a:xfrm>
              <a:prstGeom prst="chord">
                <a:avLst>
                  <a:gd name="adj1" fmla="val 5438129"/>
                  <a:gd name="adj2" fmla="val 16148966"/>
                </a:avLst>
              </a:prstGeom>
              <a:solidFill>
                <a:srgbClr val="D883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Chord 13"/>
              <p:cNvSpPr/>
              <p:nvPr/>
            </p:nvSpPr>
            <p:spPr>
              <a:xfrm rot="10800000">
                <a:off x="6775231" y="5643716"/>
                <a:ext cx="685798" cy="685800"/>
              </a:xfrm>
              <a:prstGeom prst="chord">
                <a:avLst>
                  <a:gd name="adj1" fmla="val 5438129"/>
                  <a:gd name="adj2" fmla="val 16148966"/>
                </a:avLst>
              </a:prstGeom>
              <a:solidFill>
                <a:srgbClr val="00919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27" name="Shape 148">
            <a:extLst>
              <a:ext uri="{FF2B5EF4-FFF2-40B4-BE49-F238E27FC236}">
                <a16:creationId xmlns:a16="http://schemas.microsoft.com/office/drawing/2014/main" id="{E5E32A74-4160-B94E-858E-D64762E6ADB4}"/>
              </a:ext>
            </a:extLst>
          </p:cNvPr>
          <p:cNvSpPr/>
          <p:nvPr/>
        </p:nvSpPr>
        <p:spPr>
          <a:xfrm>
            <a:off x="1439757" y="4565151"/>
            <a:ext cx="8843519" cy="11182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just" defTabSz="457200">
              <a:lnSpc>
                <a:spcPct val="117999"/>
              </a:lnSpc>
              <a:defRPr sz="1800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pPr>
              <a:lnSpc>
                <a:spcPct val="100000"/>
              </a:lnSpc>
            </a:pP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Supplemental </a:t>
            </a:r>
            <a:r>
              <a:rPr sz="1100" b="1" dirty="0">
                <a:latin typeface="Arial" charset="0"/>
                <a:ea typeface="Arial" charset="0"/>
                <a:cs typeface="Arial" charset="0"/>
              </a:rPr>
              <a:t>Fig 1.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Change in CD8 T cell Populations Following Ty21a Vaccination</a:t>
            </a:r>
            <a:r>
              <a:rPr sz="1100" b="1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catter plots showing the percentages of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A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re- and post-vaccination CD3+ T cells,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B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otal T cells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, C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8+  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(CD45RA-CD62L-), and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D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8+ 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(CD45RA+ CD62L-) populations among male pediatric (ages 6-17; n=10), female pediatric (ages 11-17; n=8), male adult (n=7), and female adult (n=6) participants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 (media)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catter plots showing the percentages of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E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8+ 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(CD45RA- CD62L-), and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F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8+ 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(CD45RA+ CD62L-) populations among HLA-E*01:01 (n=10), HLA-E*01:03 (n=6), and HLA-E*01:01/03 heterozygotes (n=12) (media). 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Bar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represent 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medians with whisker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indicating 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interquartile range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. Statistic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were analyzed by unpaired t-test</a:t>
            </a:r>
            <a:r>
              <a:rPr sz="1100" dirty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(* p&lt;0.05; ** p&lt;0.01) </a:t>
            </a:r>
            <a:endParaRPr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86F29BA-9FE8-B746-B031-C5289C98AC18}"/>
              </a:ext>
            </a:extLst>
          </p:cNvPr>
          <p:cNvSpPr txBox="1"/>
          <p:nvPr/>
        </p:nvSpPr>
        <p:spPr>
          <a:xfrm>
            <a:off x="2488143" y="4173525"/>
            <a:ext cx="123216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re-Vaccinatio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D7DE5F12-EAE6-3F42-80FB-B4ECA623BF3C}"/>
              </a:ext>
            </a:extLst>
          </p:cNvPr>
          <p:cNvSpPr txBox="1"/>
          <p:nvPr/>
        </p:nvSpPr>
        <p:spPr>
          <a:xfrm>
            <a:off x="3962500" y="4183592"/>
            <a:ext cx="130084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ost- Vaccinatio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0345340-1CB3-A049-8698-DD0579CB8376}"/>
              </a:ext>
            </a:extLst>
          </p:cNvPr>
          <p:cNvSpPr txBox="1"/>
          <p:nvPr/>
        </p:nvSpPr>
        <p:spPr>
          <a:xfrm>
            <a:off x="6778591" y="4167977"/>
            <a:ext cx="123216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re-Vaccination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5F2AAB7-15A2-664A-8E43-7B7BB1B9ED6A}"/>
              </a:ext>
            </a:extLst>
          </p:cNvPr>
          <p:cNvSpPr txBox="1"/>
          <p:nvPr/>
        </p:nvSpPr>
        <p:spPr>
          <a:xfrm>
            <a:off x="8180756" y="4178044"/>
            <a:ext cx="130084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ost- Vaccination</a:t>
            </a:r>
          </a:p>
        </p:txBody>
      </p:sp>
    </p:spTree>
    <p:extLst>
      <p:ext uri="{BB962C8B-B14F-4D97-AF65-F5344CB8AC3E}">
        <p14:creationId xmlns:p14="http://schemas.microsoft.com/office/powerpoint/2010/main" val="113446888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780156" y="1169843"/>
            <a:ext cx="1640280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re-Vaccination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1798828" y="1997382"/>
            <a:ext cx="1428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HLA-E*01:01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1798828" y="3550521"/>
            <a:ext cx="14284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HLA-E*01:03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1586247" y="5137787"/>
            <a:ext cx="1853609" cy="2770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HLA-E Heterozygous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61" b="6470"/>
          <a:stretch/>
        </p:blipFill>
        <p:spPr>
          <a:xfrm>
            <a:off x="2709785" y="1421657"/>
            <a:ext cx="1714580" cy="148738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61" b="6470"/>
          <a:stretch/>
        </p:blipFill>
        <p:spPr>
          <a:xfrm>
            <a:off x="2709785" y="2974797"/>
            <a:ext cx="1714580" cy="1487384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53" b="6470"/>
          <a:stretch/>
        </p:blipFill>
        <p:spPr>
          <a:xfrm>
            <a:off x="2709786" y="4527936"/>
            <a:ext cx="1714580" cy="1481014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57" b="6274"/>
          <a:stretch/>
        </p:blipFill>
        <p:spPr>
          <a:xfrm>
            <a:off x="4519819" y="1421657"/>
            <a:ext cx="1714580" cy="1487384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57" b="6079"/>
          <a:stretch/>
        </p:blipFill>
        <p:spPr>
          <a:xfrm>
            <a:off x="4519819" y="2974796"/>
            <a:ext cx="1710916" cy="1487384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52" b="6274"/>
          <a:stretch/>
        </p:blipFill>
        <p:spPr>
          <a:xfrm>
            <a:off x="4424366" y="4510122"/>
            <a:ext cx="1806919" cy="149882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910899" y="521927"/>
            <a:ext cx="2027603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350" dirty="0"/>
              <a:t>Supplemental Figure 8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924701" y="1237031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F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329854" y="1237031"/>
            <a:ext cx="344917" cy="30008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b="1" dirty="0"/>
              <a:t>G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F381FA4-0947-9D4F-9C86-AE9792CD1D2C}"/>
              </a:ext>
            </a:extLst>
          </p:cNvPr>
          <p:cNvSpPr txBox="1"/>
          <p:nvPr/>
        </p:nvSpPr>
        <p:spPr>
          <a:xfrm>
            <a:off x="2792553" y="2642354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7341BAB-E238-DF41-AAB9-B4E025D6C58C}"/>
              </a:ext>
            </a:extLst>
          </p:cNvPr>
          <p:cNvSpPr txBox="1"/>
          <p:nvPr/>
        </p:nvSpPr>
        <p:spPr>
          <a:xfrm>
            <a:off x="4580411" y="2642354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6643B7F-FDA9-F546-A62B-F9B01BC1832D}"/>
              </a:ext>
            </a:extLst>
          </p:cNvPr>
          <p:cNvSpPr txBox="1"/>
          <p:nvPr/>
        </p:nvSpPr>
        <p:spPr>
          <a:xfrm>
            <a:off x="2792553" y="4197143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6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BABAA44-D426-BA40-BF40-BFA860EDBBDD}"/>
              </a:ext>
            </a:extLst>
          </p:cNvPr>
          <p:cNvSpPr txBox="1"/>
          <p:nvPr/>
        </p:nvSpPr>
        <p:spPr>
          <a:xfrm>
            <a:off x="4603493" y="4197142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6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F856FA7-0B8C-3A45-AA8D-F3F02D9FC149}"/>
              </a:ext>
            </a:extLst>
          </p:cNvPr>
          <p:cNvSpPr txBox="1"/>
          <p:nvPr/>
        </p:nvSpPr>
        <p:spPr>
          <a:xfrm>
            <a:off x="2792553" y="5742936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C85E170-24B2-CD42-A655-FB64C51A4DB3}"/>
              </a:ext>
            </a:extLst>
          </p:cNvPr>
          <p:cNvSpPr txBox="1"/>
          <p:nvPr/>
        </p:nvSpPr>
        <p:spPr>
          <a:xfrm>
            <a:off x="4577765" y="5742935"/>
            <a:ext cx="5160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 = 1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68A8C01-1B30-A948-8AC9-EED365A979A0}"/>
              </a:ext>
            </a:extLst>
          </p:cNvPr>
          <p:cNvSpPr txBox="1"/>
          <p:nvPr/>
        </p:nvSpPr>
        <p:spPr>
          <a:xfrm>
            <a:off x="7523601" y="1144656"/>
            <a:ext cx="2262948" cy="30218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350" dirty="0"/>
              <a:t>CD8+ CD69+ T</a:t>
            </a:r>
            <a:r>
              <a:rPr lang="en-US" sz="1350" baseline="-25000" dirty="0"/>
              <a:t>EMRA</a:t>
            </a:r>
            <a:r>
              <a:rPr lang="en-US" sz="1350" dirty="0"/>
              <a:t> cell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A1F2568-373E-8D4D-B4FA-891D2CCCA030}"/>
              </a:ext>
            </a:extLst>
          </p:cNvPr>
          <p:cNvSpPr txBox="1"/>
          <p:nvPr/>
        </p:nvSpPr>
        <p:spPr>
          <a:xfrm>
            <a:off x="7793599" y="3620410"/>
            <a:ext cx="1505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luster (#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C5FC3C6-E11E-2145-B399-1C422E68A0D4}"/>
              </a:ext>
            </a:extLst>
          </p:cNvPr>
          <p:cNvSpPr txBox="1"/>
          <p:nvPr/>
        </p:nvSpPr>
        <p:spPr>
          <a:xfrm rot="16200000">
            <a:off x="5531674" y="2323323"/>
            <a:ext cx="24757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Averaged # Cells Per Volunteer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4BB9013-620D-0748-858F-F6AFA49ECD3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917653" y="1403584"/>
            <a:ext cx="3257093" cy="2238890"/>
          </a:xfrm>
          <a:prstGeom prst="rect">
            <a:avLst/>
          </a:prstGeom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483EDDB4-C2B7-944B-A546-2F4A59AFF6AC}"/>
              </a:ext>
            </a:extLst>
          </p:cNvPr>
          <p:cNvSpPr/>
          <p:nvPr/>
        </p:nvSpPr>
        <p:spPr>
          <a:xfrm>
            <a:off x="6674770" y="3964952"/>
            <a:ext cx="3775796" cy="19967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l Fig 8. Additional </a:t>
            </a:r>
            <a:r>
              <a:rPr lang="en-US" sz="825" b="1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Analysis of CD8+CD69+ T effector memory RA populations. A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nlist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FCOM identified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multifunctional responses, shown in a previous </a:t>
            </a:r>
            <a:r>
              <a:rPr lang="en-US" sz="825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. Typhi challenge study (10,11) to be associated with protection from developing disease, as well as from those same populations plus Granzyme B expression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B)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,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from the most multifunctional </a:t>
            </a:r>
            <a:r>
              <a:rPr lang="en-US" sz="825" b="1" dirty="0">
                <a:latin typeface="Arial" charset="0"/>
                <a:ea typeface="Arial" charset="0"/>
                <a:cs typeface="Arial" charset="0"/>
              </a:rPr>
              <a:t>(A+B) 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825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825" dirty="0">
                <a:latin typeface="Arial" charset="0"/>
                <a:ea typeface="Arial" charset="0"/>
                <a:cs typeface="Arial" charset="0"/>
              </a:rPr>
              <a:t> clusters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C.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xpression of non-conventional CD8 markers ICOS, CD154 (CD40L), and CXCR5, as well as exhaustion/activation marker PD-1 among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</a:t>
            </a:r>
            <a:r>
              <a:rPr lang="en-US" sz="825" baseline="-25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MRA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clusters.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D.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female (n=14) and male (n=17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E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gender/age group and vaccination status.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F</a:t>
            </a:r>
            <a:r>
              <a:rPr lang="en-US" sz="825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825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25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tSNE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maps of pre- and post-Ty21a vaccinated HLA-E*01:01 (n=10), HLA-E*01:03 (n=6), and HLA-E heterozygous (n=12) participants. Populations represented by bar graph </a:t>
            </a:r>
            <a:r>
              <a:rPr lang="en-US" sz="825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(G) </a:t>
            </a:r>
            <a:r>
              <a:rPr lang="en-US" sz="825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identifying the average number of cells per cluster divided into HLA-E haplotype and vaccination status. </a:t>
            </a:r>
            <a:endParaRPr lang="en-US" sz="8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2F689E3-AE16-274B-BC66-1F5C29902934}"/>
              </a:ext>
            </a:extLst>
          </p:cNvPr>
          <p:cNvSpPr txBox="1"/>
          <p:nvPr/>
        </p:nvSpPr>
        <p:spPr>
          <a:xfrm>
            <a:off x="4584358" y="1144657"/>
            <a:ext cx="1510799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ost-Vaccination</a:t>
            </a:r>
          </a:p>
        </p:txBody>
      </p:sp>
    </p:spTree>
    <p:extLst>
      <p:ext uri="{BB962C8B-B14F-4D97-AF65-F5344CB8AC3E}">
        <p14:creationId xmlns:p14="http://schemas.microsoft.com/office/powerpoint/2010/main" val="30187250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extBox 78">
            <a:extLst>
              <a:ext uri="{FF2B5EF4-FFF2-40B4-BE49-F238E27FC236}">
                <a16:creationId xmlns:a16="http://schemas.microsoft.com/office/drawing/2014/main" id="{D7BD2435-1D2F-8945-8093-8B6B0E53C079}"/>
              </a:ext>
            </a:extLst>
          </p:cNvPr>
          <p:cNvSpPr txBox="1"/>
          <p:nvPr/>
        </p:nvSpPr>
        <p:spPr>
          <a:xfrm rot="17994579">
            <a:off x="5470030" y="6176260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ost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7EB1D0B9-A097-E144-A7DA-A9B23BAA21C7}"/>
              </a:ext>
            </a:extLst>
          </p:cNvPr>
          <p:cNvSpPr txBox="1"/>
          <p:nvPr/>
        </p:nvSpPr>
        <p:spPr>
          <a:xfrm rot="17994579">
            <a:off x="7108537" y="6174181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ost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61BC8980-6116-EA4B-9D8F-CB56A6465D2D}"/>
              </a:ext>
            </a:extLst>
          </p:cNvPr>
          <p:cNvSpPr txBox="1"/>
          <p:nvPr/>
        </p:nvSpPr>
        <p:spPr>
          <a:xfrm rot="17994579">
            <a:off x="4908639" y="6176260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re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BC85041-A68A-334A-9BC6-CDDDE34B0A57}"/>
              </a:ext>
            </a:extLst>
          </p:cNvPr>
          <p:cNvSpPr txBox="1"/>
          <p:nvPr/>
        </p:nvSpPr>
        <p:spPr>
          <a:xfrm rot="17994579">
            <a:off x="6562925" y="6174181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re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79AA8D96-C40E-7C4F-9CB5-A0E327DE4A93}"/>
              </a:ext>
            </a:extLst>
          </p:cNvPr>
          <p:cNvSpPr txBox="1"/>
          <p:nvPr/>
        </p:nvSpPr>
        <p:spPr>
          <a:xfrm rot="17994579">
            <a:off x="3780312" y="6174180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ost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425D013-99FC-1A45-9FB4-7258C52BF4F5}"/>
              </a:ext>
            </a:extLst>
          </p:cNvPr>
          <p:cNvSpPr txBox="1"/>
          <p:nvPr/>
        </p:nvSpPr>
        <p:spPr>
          <a:xfrm rot="17994579">
            <a:off x="3200586" y="6174181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re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A81D7EFD-7E80-BD4D-B2D2-0F52DC842B54}"/>
              </a:ext>
            </a:extLst>
          </p:cNvPr>
          <p:cNvSpPr txBox="1"/>
          <p:nvPr/>
        </p:nvSpPr>
        <p:spPr>
          <a:xfrm rot="17994579">
            <a:off x="8860903" y="6168680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ost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E1EBE324-C049-204E-9CEB-70EA26ECDB2E}"/>
              </a:ext>
            </a:extLst>
          </p:cNvPr>
          <p:cNvSpPr txBox="1"/>
          <p:nvPr/>
        </p:nvSpPr>
        <p:spPr>
          <a:xfrm rot="17994579">
            <a:off x="8315291" y="6168680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re-</a:t>
            </a:r>
            <a:r>
              <a:rPr lang="en-US" sz="1100" dirty="0" err="1"/>
              <a:t>Vacc</a:t>
            </a:r>
            <a:endParaRPr lang="en-US" sz="1100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FAD9D0C-2DFC-6942-BE9C-4325B66395A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17368" y="718630"/>
            <a:ext cx="3268933" cy="2151091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B568FDA5-AD76-DC4A-A229-A5EAACB03F8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13124" y="401765"/>
            <a:ext cx="3692425" cy="2516846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2100318" y="187178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6917833" y="184984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 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499251" y="188144"/>
            <a:ext cx="2397409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 (media)</a:t>
            </a:r>
          </a:p>
        </p:txBody>
      </p:sp>
      <p:sp>
        <p:nvSpPr>
          <p:cNvPr id="44" name="TextBox 43"/>
          <p:cNvSpPr txBox="1"/>
          <p:nvPr/>
        </p:nvSpPr>
        <p:spPr>
          <a:xfrm rot="16200000">
            <a:off x="1746175" y="1498153"/>
            <a:ext cx="186349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8+ CD69+ T cells (%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BD1CA48-F279-B34C-8650-61B524F9A5E9}"/>
              </a:ext>
            </a:extLst>
          </p:cNvPr>
          <p:cNvSpPr txBox="1"/>
          <p:nvPr/>
        </p:nvSpPr>
        <p:spPr>
          <a:xfrm>
            <a:off x="7573254" y="187178"/>
            <a:ext cx="2957160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 (stimulated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947069F-D293-6C40-A7E8-6249D6101883}"/>
              </a:ext>
            </a:extLst>
          </p:cNvPr>
          <p:cNvSpPr txBox="1"/>
          <p:nvPr/>
        </p:nvSpPr>
        <p:spPr>
          <a:xfrm>
            <a:off x="2812799" y="3389311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5ADFF5A-41CD-634A-AA14-5304BA183647}"/>
              </a:ext>
            </a:extLst>
          </p:cNvPr>
          <p:cNvSpPr txBox="1"/>
          <p:nvPr/>
        </p:nvSpPr>
        <p:spPr>
          <a:xfrm rot="16200000">
            <a:off x="2034941" y="4932338"/>
            <a:ext cx="186349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8+ CD69+ T cells (%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CF7240B-CA2D-7F4C-92B6-D15D80C77367}"/>
              </a:ext>
            </a:extLst>
          </p:cNvPr>
          <p:cNvSpPr txBox="1"/>
          <p:nvPr/>
        </p:nvSpPr>
        <p:spPr>
          <a:xfrm>
            <a:off x="6719332" y="1382546"/>
            <a:ext cx="95511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Female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EA761DC-1A80-254A-A669-062561AB7638}"/>
              </a:ext>
            </a:extLst>
          </p:cNvPr>
          <p:cNvSpPr txBox="1"/>
          <p:nvPr/>
        </p:nvSpPr>
        <p:spPr>
          <a:xfrm>
            <a:off x="6917833" y="986457"/>
            <a:ext cx="75661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al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CA02AA4-2523-014A-900B-4AB1241182CB}"/>
              </a:ext>
            </a:extLst>
          </p:cNvPr>
          <p:cNvSpPr txBox="1"/>
          <p:nvPr/>
        </p:nvSpPr>
        <p:spPr>
          <a:xfrm>
            <a:off x="6719332" y="2170898"/>
            <a:ext cx="95511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Female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AF85205-168C-E246-A18F-5234CEB43FA6}"/>
              </a:ext>
            </a:extLst>
          </p:cNvPr>
          <p:cNvSpPr txBox="1"/>
          <p:nvPr/>
        </p:nvSpPr>
        <p:spPr>
          <a:xfrm>
            <a:off x="6917833" y="1777631"/>
            <a:ext cx="756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Male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8E7F51D-3D48-CB47-A1D4-AAA125B3FEDA}"/>
              </a:ext>
            </a:extLst>
          </p:cNvPr>
          <p:cNvSpPr txBox="1"/>
          <p:nvPr/>
        </p:nvSpPr>
        <p:spPr>
          <a:xfrm rot="16200000">
            <a:off x="6481259" y="1115711"/>
            <a:ext cx="9283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Pediatric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71ACE93-E8B1-9A4B-8781-DF9915311091}"/>
              </a:ext>
            </a:extLst>
          </p:cNvPr>
          <p:cNvSpPr txBox="1"/>
          <p:nvPr/>
        </p:nvSpPr>
        <p:spPr>
          <a:xfrm rot="16200000">
            <a:off x="6500708" y="1938005"/>
            <a:ext cx="8894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Adult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7AC1329-983C-9D40-A6ED-29BFD762A80F}"/>
              </a:ext>
            </a:extLst>
          </p:cNvPr>
          <p:cNvSpPr txBox="1"/>
          <p:nvPr/>
        </p:nvSpPr>
        <p:spPr>
          <a:xfrm>
            <a:off x="7643231" y="2857921"/>
            <a:ext cx="282424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69</a:t>
            </a:r>
            <a:r>
              <a:rPr lang="en-US" sz="1400" baseline="30000" dirty="0"/>
              <a:t>+</a:t>
            </a:r>
            <a:r>
              <a:rPr lang="en-US" sz="1400" dirty="0"/>
              <a:t> Responders over Baseline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A1CE67F-0214-A746-A44C-105586861921}"/>
              </a:ext>
            </a:extLst>
          </p:cNvPr>
          <p:cNvSpPr txBox="1"/>
          <p:nvPr/>
        </p:nvSpPr>
        <p:spPr>
          <a:xfrm>
            <a:off x="3738195" y="1033223"/>
            <a:ext cx="444546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38D965C2-B7AA-7A47-993F-21DA6BE8080D}"/>
              </a:ext>
            </a:extLst>
          </p:cNvPr>
          <p:cNvCxnSpPr>
            <a:cxnSpLocks/>
          </p:cNvCxnSpPr>
          <p:nvPr/>
        </p:nvCxnSpPr>
        <p:spPr>
          <a:xfrm>
            <a:off x="3756820" y="1248720"/>
            <a:ext cx="40729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4FC1784-E8A8-D246-9359-0F2E3ADC6EDC}"/>
              </a:ext>
            </a:extLst>
          </p:cNvPr>
          <p:cNvCxnSpPr>
            <a:cxnSpLocks/>
          </p:cNvCxnSpPr>
          <p:nvPr/>
        </p:nvCxnSpPr>
        <p:spPr>
          <a:xfrm>
            <a:off x="5508683" y="768863"/>
            <a:ext cx="40729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769EE494-FF67-614C-B6B9-AE841A39C62F}"/>
              </a:ext>
            </a:extLst>
          </p:cNvPr>
          <p:cNvSpPr txBox="1"/>
          <p:nvPr/>
        </p:nvSpPr>
        <p:spPr>
          <a:xfrm>
            <a:off x="5365720" y="540163"/>
            <a:ext cx="693222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p = 0.06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893CABD-5171-4040-AC24-864E11E239CB}"/>
              </a:ext>
            </a:extLst>
          </p:cNvPr>
          <p:cNvSpPr txBox="1"/>
          <p:nvPr/>
        </p:nvSpPr>
        <p:spPr>
          <a:xfrm>
            <a:off x="7866015" y="3600271"/>
            <a:ext cx="7566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Adult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7788FAB-3959-8340-B40A-B60E29700F17}"/>
              </a:ext>
            </a:extLst>
          </p:cNvPr>
          <p:cNvSpPr txBox="1"/>
          <p:nvPr/>
        </p:nvSpPr>
        <p:spPr>
          <a:xfrm>
            <a:off x="4524673" y="3604968"/>
            <a:ext cx="8894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/>
              <a:t>Pediatric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43EEB9C-A5E2-8F46-855E-30430F3004DE}"/>
              </a:ext>
            </a:extLst>
          </p:cNvPr>
          <p:cNvSpPr txBox="1"/>
          <p:nvPr/>
        </p:nvSpPr>
        <p:spPr>
          <a:xfrm>
            <a:off x="3636440" y="3908394"/>
            <a:ext cx="95511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ale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C694387-8133-3849-9D74-E43FF1807DD7}"/>
              </a:ext>
            </a:extLst>
          </p:cNvPr>
          <p:cNvSpPr txBox="1"/>
          <p:nvPr/>
        </p:nvSpPr>
        <p:spPr>
          <a:xfrm>
            <a:off x="5352389" y="3908048"/>
            <a:ext cx="756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Female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878777C-A8CE-AD49-8512-E1D511DDD4E2}"/>
              </a:ext>
            </a:extLst>
          </p:cNvPr>
          <p:cNvSpPr txBox="1"/>
          <p:nvPr/>
        </p:nvSpPr>
        <p:spPr>
          <a:xfrm>
            <a:off x="6993959" y="3892765"/>
            <a:ext cx="95511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ale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C6110039-3D67-2D48-A533-634CCDDC44A4}"/>
              </a:ext>
            </a:extLst>
          </p:cNvPr>
          <p:cNvSpPr txBox="1"/>
          <p:nvPr/>
        </p:nvSpPr>
        <p:spPr>
          <a:xfrm>
            <a:off x="8784380" y="3892764"/>
            <a:ext cx="756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Female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9F34883A-DC67-5844-BE7A-604E367724FE}"/>
              </a:ext>
            </a:extLst>
          </p:cNvPr>
          <p:cNvSpPr txBox="1"/>
          <p:nvPr/>
        </p:nvSpPr>
        <p:spPr>
          <a:xfrm>
            <a:off x="5079181" y="3333196"/>
            <a:ext cx="37290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ated on CD8+ CD69+ T (stimulated)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679567C-1060-7C46-B0DA-CA4EED1EA543}"/>
              </a:ext>
            </a:extLst>
          </p:cNvPr>
          <p:cNvSpPr txBox="1"/>
          <p:nvPr/>
        </p:nvSpPr>
        <p:spPr>
          <a:xfrm>
            <a:off x="8942008" y="1382546"/>
            <a:ext cx="9551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37.5 %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B103440-5209-9048-B2C3-C038A6CF7A6F}"/>
              </a:ext>
            </a:extLst>
          </p:cNvPr>
          <p:cNvSpPr txBox="1"/>
          <p:nvPr/>
        </p:nvSpPr>
        <p:spPr>
          <a:xfrm>
            <a:off x="9698923" y="1001045"/>
            <a:ext cx="756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0 %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2DCC9A3-0985-E248-8428-36A1EE4E3F5F}"/>
              </a:ext>
            </a:extLst>
          </p:cNvPr>
          <p:cNvSpPr txBox="1"/>
          <p:nvPr/>
        </p:nvSpPr>
        <p:spPr>
          <a:xfrm>
            <a:off x="9942066" y="2198738"/>
            <a:ext cx="9551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7 %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772821B-AE50-2D4A-87EF-5835F754FAE8}"/>
              </a:ext>
            </a:extLst>
          </p:cNvPr>
          <p:cNvSpPr txBox="1"/>
          <p:nvPr/>
        </p:nvSpPr>
        <p:spPr>
          <a:xfrm>
            <a:off x="9639048" y="1779917"/>
            <a:ext cx="756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57 %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FBF5DBB-4429-1340-AAAF-B3D89A7C23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24054" y="4130818"/>
            <a:ext cx="1671131" cy="191081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DFE7F4F-60B4-3E4A-9144-EEF14CDF980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19004" y="4154479"/>
            <a:ext cx="1627896" cy="186137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77CA641-B251-AB4E-9869-78B800C4AF8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23125" y="4130818"/>
            <a:ext cx="1642021" cy="188504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4CE1D66-4BC5-A848-94AC-6BF05F19D48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16913" y="4130817"/>
            <a:ext cx="1644047" cy="1887366"/>
          </a:xfrm>
          <a:prstGeom prst="rect">
            <a:avLst/>
          </a:prstGeom>
        </p:spPr>
      </p:pic>
      <p:sp>
        <p:nvSpPr>
          <p:cNvPr id="80" name="Rectangle 79">
            <a:extLst>
              <a:ext uri="{FF2B5EF4-FFF2-40B4-BE49-F238E27FC236}">
                <a16:creationId xmlns:a16="http://schemas.microsoft.com/office/drawing/2014/main" id="{79D74E5E-57C4-3A43-8E25-080C5D33033A}"/>
              </a:ext>
            </a:extLst>
          </p:cNvPr>
          <p:cNvSpPr/>
          <p:nvPr/>
        </p:nvSpPr>
        <p:spPr>
          <a:xfrm>
            <a:off x="75797" y="834765"/>
            <a:ext cx="2266663" cy="58477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Supplemental Fig 2. Changes in Activated CD8 T cell Populations Following Ty21a Vaccination. A and D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catter plot showing the percentages of CD69+ CD8+ T cells among pre- and post-Ty21a unstimulated PBMC. Bars represent medians with whiskers indicating interquartile ranges.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B and E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onnected dot plot showing each participants’ pre- and post-Ty21a CD8+ CD69+ expression levels following co-culture with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. Typhi-infected HLA-E restricted antigen presenting target cells.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C and F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Bars representing the proportion of CD8+ CD69+ responders over baseline levels (cutoff of 0.1%) following co-culture with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. Typhi- infected HLA-E restricted antigen presenting target cells. Data divided among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A-C)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D-F)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HLA-E*01:01 (n=10), HLA-E*01:03 (n=6), and HLA-E heterozygous (n=12)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articipants. Statistics were analyzed by unpaired t-test (in black) or paired t-test (in red). (* p&lt;0.05; *** p&lt;0.001) </a:t>
            </a:r>
            <a:endParaRPr lang="en-US" sz="1100" dirty="0"/>
          </a:p>
        </p:txBody>
      </p:sp>
      <p:grpSp>
        <p:nvGrpSpPr>
          <p:cNvPr id="81" name="Group 80">
            <a:extLst>
              <a:ext uri="{FF2B5EF4-FFF2-40B4-BE49-F238E27FC236}">
                <a16:creationId xmlns:a16="http://schemas.microsoft.com/office/drawing/2014/main" id="{8B574068-B1BA-AB40-BD83-A31FEAD4CF58}"/>
              </a:ext>
            </a:extLst>
          </p:cNvPr>
          <p:cNvGrpSpPr/>
          <p:nvPr/>
        </p:nvGrpSpPr>
        <p:grpSpPr>
          <a:xfrm>
            <a:off x="9798032" y="3214109"/>
            <a:ext cx="1875744" cy="794966"/>
            <a:chOff x="10279866" y="1001743"/>
            <a:chExt cx="1793913" cy="794966"/>
          </a:xfrm>
        </p:grpSpPr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C4E6C01B-EB98-8D42-BAE4-671E2618FF96}"/>
                </a:ext>
              </a:extLst>
            </p:cNvPr>
            <p:cNvGrpSpPr/>
            <p:nvPr/>
          </p:nvGrpSpPr>
          <p:grpSpPr>
            <a:xfrm>
              <a:off x="10279866" y="1001743"/>
              <a:ext cx="1793913" cy="794966"/>
              <a:chOff x="10072002" y="392204"/>
              <a:chExt cx="1673319" cy="794966"/>
            </a:xfrm>
          </p:grpSpPr>
          <p:sp>
            <p:nvSpPr>
              <p:cNvPr id="92" name="Oval 91">
                <a:extLst>
                  <a:ext uri="{FF2B5EF4-FFF2-40B4-BE49-F238E27FC236}">
                    <a16:creationId xmlns:a16="http://schemas.microsoft.com/office/drawing/2014/main" id="{875E0230-8143-EA46-AC58-05DDBDC1D525}"/>
                  </a:ext>
                </a:extLst>
              </p:cNvPr>
              <p:cNvSpPr/>
              <p:nvPr/>
            </p:nvSpPr>
            <p:spPr>
              <a:xfrm>
                <a:off x="10072002" y="487297"/>
                <a:ext cx="81572" cy="91440"/>
              </a:xfrm>
              <a:prstGeom prst="ellipse">
                <a:avLst/>
              </a:prstGeom>
              <a:solidFill>
                <a:srgbClr val="76D6FF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3" name="Oval 92">
                <a:extLst>
                  <a:ext uri="{FF2B5EF4-FFF2-40B4-BE49-F238E27FC236}">
                    <a16:creationId xmlns:a16="http://schemas.microsoft.com/office/drawing/2014/main" id="{25B78C13-8264-1849-8CBB-716D01B78ABD}"/>
                  </a:ext>
                </a:extLst>
              </p:cNvPr>
              <p:cNvSpPr/>
              <p:nvPr/>
            </p:nvSpPr>
            <p:spPr>
              <a:xfrm>
                <a:off x="10072002" y="656264"/>
                <a:ext cx="81572" cy="91440"/>
              </a:xfrm>
              <a:prstGeom prst="ellipse">
                <a:avLst/>
              </a:prstGeom>
              <a:solidFill>
                <a:srgbClr val="FF7E79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7CE9B3FA-E303-1241-91AA-BBFF7754C066}"/>
                  </a:ext>
                </a:extLst>
              </p:cNvPr>
              <p:cNvSpPr txBox="1"/>
              <p:nvPr/>
            </p:nvSpPr>
            <p:spPr>
              <a:xfrm>
                <a:off x="10163442" y="574706"/>
                <a:ext cx="158187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ed Female (n=8; 11-17 </a:t>
                </a:r>
                <a:r>
                  <a:rPr lang="en-US" sz="1050" dirty="0" err="1"/>
                  <a:t>yrs</a:t>
                </a:r>
                <a:r>
                  <a:rPr lang="en-US" sz="1050" dirty="0"/>
                  <a:t>)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F289F538-A73D-0649-B4AC-153BDD0D53DD}"/>
                  </a:ext>
                </a:extLst>
              </p:cNvPr>
              <p:cNvSpPr txBox="1"/>
              <p:nvPr/>
            </p:nvSpPr>
            <p:spPr>
              <a:xfrm>
                <a:off x="10163442" y="392204"/>
                <a:ext cx="147319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ed Male (n=10; 6-17 </a:t>
                </a:r>
                <a:r>
                  <a:rPr lang="en-US" sz="1050" dirty="0" err="1"/>
                  <a:t>yrs</a:t>
                </a:r>
                <a:r>
                  <a:rPr lang="en-US" sz="1050" dirty="0"/>
                  <a:t>)</a:t>
                </a:r>
              </a:p>
            </p:txBody>
          </p:sp>
          <p:sp>
            <p:nvSpPr>
              <p:cNvPr id="96" name="TextBox 95">
                <a:extLst>
                  <a:ext uri="{FF2B5EF4-FFF2-40B4-BE49-F238E27FC236}">
                    <a16:creationId xmlns:a16="http://schemas.microsoft.com/office/drawing/2014/main" id="{FE224A14-0428-C946-A750-BB60A82AF2DC}"/>
                  </a:ext>
                </a:extLst>
              </p:cNvPr>
              <p:cNvSpPr txBox="1"/>
              <p:nvPr/>
            </p:nvSpPr>
            <p:spPr>
              <a:xfrm>
                <a:off x="10163442" y="933254"/>
                <a:ext cx="109424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Adult Female (n=6)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1B512FC7-4DE8-AA42-BDC3-43A12B21D230}"/>
                  </a:ext>
                </a:extLst>
              </p:cNvPr>
              <p:cNvSpPr txBox="1"/>
              <p:nvPr/>
            </p:nvSpPr>
            <p:spPr>
              <a:xfrm>
                <a:off x="10163442" y="745241"/>
                <a:ext cx="98556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Adult Male (n=7)</a:t>
                </a:r>
              </a:p>
            </p:txBody>
          </p:sp>
        </p:grpSp>
        <p:sp>
          <p:nvSpPr>
            <p:cNvPr id="90" name="Rectangle 89">
              <a:extLst>
                <a:ext uri="{FF2B5EF4-FFF2-40B4-BE49-F238E27FC236}">
                  <a16:creationId xmlns:a16="http://schemas.microsoft.com/office/drawing/2014/main" id="{8DE40D3B-7789-8944-93B9-F5AACB4DA6F0}"/>
                </a:ext>
              </a:extLst>
            </p:cNvPr>
            <p:cNvSpPr/>
            <p:nvPr/>
          </p:nvSpPr>
          <p:spPr>
            <a:xfrm>
              <a:off x="10285381" y="1619243"/>
              <a:ext cx="87451" cy="91440"/>
            </a:xfrm>
            <a:prstGeom prst="rect">
              <a:avLst/>
            </a:prstGeom>
            <a:solidFill>
              <a:srgbClr val="9411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1" name="Rectangle 90">
              <a:extLst>
                <a:ext uri="{FF2B5EF4-FFF2-40B4-BE49-F238E27FC236}">
                  <a16:creationId xmlns:a16="http://schemas.microsoft.com/office/drawing/2014/main" id="{D741F575-0F0E-F24D-AB82-07BD588A5900}"/>
                </a:ext>
              </a:extLst>
            </p:cNvPr>
            <p:cNvSpPr/>
            <p:nvPr/>
          </p:nvSpPr>
          <p:spPr>
            <a:xfrm>
              <a:off x="10285381" y="1448374"/>
              <a:ext cx="88700" cy="90757"/>
            </a:xfrm>
            <a:prstGeom prst="rect">
              <a:avLst/>
            </a:prstGeom>
            <a:solidFill>
              <a:srgbClr val="01189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3" name="TextBox 82">
            <a:extLst>
              <a:ext uri="{FF2B5EF4-FFF2-40B4-BE49-F238E27FC236}">
                <a16:creationId xmlns:a16="http://schemas.microsoft.com/office/drawing/2014/main" id="{4D70807D-5060-974F-8D4D-DDFCDFB3C2F6}"/>
              </a:ext>
            </a:extLst>
          </p:cNvPr>
          <p:cNvSpPr txBox="1"/>
          <p:nvPr/>
        </p:nvSpPr>
        <p:spPr>
          <a:xfrm>
            <a:off x="3046728" y="2930264"/>
            <a:ext cx="186349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Pre-Vaccination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91C30780-B88D-9444-AF2D-202DF7FD86C4}"/>
              </a:ext>
            </a:extLst>
          </p:cNvPr>
          <p:cNvSpPr txBox="1"/>
          <p:nvPr/>
        </p:nvSpPr>
        <p:spPr>
          <a:xfrm>
            <a:off x="4813965" y="2925469"/>
            <a:ext cx="186349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Post-Vaccination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FF06C5E-FC60-3D41-96F4-1B5A4A750F09}"/>
              </a:ext>
            </a:extLst>
          </p:cNvPr>
          <p:cNvSpPr txBox="1"/>
          <p:nvPr/>
        </p:nvSpPr>
        <p:spPr>
          <a:xfrm>
            <a:off x="12021" y="0"/>
            <a:ext cx="1539819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2</a:t>
            </a:r>
          </a:p>
        </p:txBody>
      </p:sp>
    </p:spTree>
    <p:extLst>
      <p:ext uri="{BB962C8B-B14F-4D97-AF65-F5344CB8AC3E}">
        <p14:creationId xmlns:p14="http://schemas.microsoft.com/office/powerpoint/2010/main" val="29129360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TextBox 69">
            <a:extLst>
              <a:ext uri="{FF2B5EF4-FFF2-40B4-BE49-F238E27FC236}">
                <a16:creationId xmlns:a16="http://schemas.microsoft.com/office/drawing/2014/main" id="{3486081F-C964-3943-9774-A1A0D8978BAA}"/>
              </a:ext>
            </a:extLst>
          </p:cNvPr>
          <p:cNvSpPr txBox="1"/>
          <p:nvPr/>
        </p:nvSpPr>
        <p:spPr>
          <a:xfrm rot="17994579">
            <a:off x="6562381" y="6414987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ost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3AD2956-F45B-0E4F-A83D-3423E0C273F0}"/>
              </a:ext>
            </a:extLst>
          </p:cNvPr>
          <p:cNvSpPr txBox="1"/>
          <p:nvPr/>
        </p:nvSpPr>
        <p:spPr>
          <a:xfrm rot="17994579">
            <a:off x="8200888" y="6412908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ost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8C9F1721-8A39-6D46-A3FE-288730540727}"/>
              </a:ext>
            </a:extLst>
          </p:cNvPr>
          <p:cNvSpPr txBox="1"/>
          <p:nvPr/>
        </p:nvSpPr>
        <p:spPr>
          <a:xfrm rot="17994579">
            <a:off x="6000990" y="6414987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re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96C007D-CB78-1A43-A1A9-1219EF0301F1}"/>
              </a:ext>
            </a:extLst>
          </p:cNvPr>
          <p:cNvSpPr txBox="1"/>
          <p:nvPr/>
        </p:nvSpPr>
        <p:spPr>
          <a:xfrm rot="17994579">
            <a:off x="7655276" y="6412908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re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E116E8D-6C6C-AC45-8463-EC96231C16A6}"/>
              </a:ext>
            </a:extLst>
          </p:cNvPr>
          <p:cNvSpPr txBox="1"/>
          <p:nvPr/>
        </p:nvSpPr>
        <p:spPr>
          <a:xfrm rot="17994579">
            <a:off x="4872663" y="6412907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ost-</a:t>
            </a:r>
            <a:r>
              <a:rPr lang="en-US" sz="1100" dirty="0" err="1"/>
              <a:t>Vacc</a:t>
            </a:r>
            <a:endParaRPr lang="en-US" sz="11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3AB1744-568C-8942-8887-5795F9C980B5}"/>
              </a:ext>
            </a:extLst>
          </p:cNvPr>
          <p:cNvSpPr txBox="1"/>
          <p:nvPr/>
        </p:nvSpPr>
        <p:spPr>
          <a:xfrm rot="17994579">
            <a:off x="4292937" y="6412908"/>
            <a:ext cx="946945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Pre-</a:t>
            </a:r>
            <a:r>
              <a:rPr lang="en-US" sz="1100" dirty="0" err="1"/>
              <a:t>Vacc</a:t>
            </a:r>
            <a:endParaRPr lang="en-US" sz="11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E0EB87D-81FD-6748-95F8-7483AB42BA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33304" y="833396"/>
            <a:ext cx="2965996" cy="199560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02E547E-2E1A-9747-BB01-194A380647F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42261" y="4380867"/>
            <a:ext cx="1638056" cy="1880488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>
            <a:off x="1633140" y="71267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D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6359840" y="187178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2257112" y="72233"/>
            <a:ext cx="392798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 (media, all ages)</a:t>
            </a:r>
          </a:p>
        </p:txBody>
      </p:sp>
      <p:sp>
        <p:nvSpPr>
          <p:cNvPr id="44" name="TextBox 43"/>
          <p:cNvSpPr txBox="1"/>
          <p:nvPr/>
        </p:nvSpPr>
        <p:spPr>
          <a:xfrm rot="16200000">
            <a:off x="896473" y="1519702"/>
            <a:ext cx="2310819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8</a:t>
            </a:r>
            <a:r>
              <a:rPr lang="en-US" sz="1400" baseline="30000" dirty="0"/>
              <a:t>+</a:t>
            </a:r>
            <a:r>
              <a:rPr lang="en-US" sz="1400" dirty="0"/>
              <a:t> CD69</a:t>
            </a:r>
            <a:r>
              <a:rPr lang="en-US" sz="1400" baseline="30000" dirty="0"/>
              <a:t>+</a:t>
            </a:r>
            <a:r>
              <a:rPr lang="en-US" sz="1400" dirty="0"/>
              <a:t> T cells (%)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1279" y="71267"/>
            <a:ext cx="1539819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b="1" dirty="0"/>
              <a:t>2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A122B351-9D9C-EA44-9B4F-76C0FD2C66B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39571" y="4387025"/>
            <a:ext cx="1631075" cy="1872474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93C77FD6-763B-A149-BFDF-D413F89606D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680317" y="4408239"/>
            <a:ext cx="1631075" cy="1872474"/>
          </a:xfrm>
          <a:prstGeom prst="rect">
            <a:avLst/>
          </a:prstGeom>
        </p:spPr>
      </p:pic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F6533045-D97E-A345-9881-40873498E922}"/>
              </a:ext>
            </a:extLst>
          </p:cNvPr>
          <p:cNvCxnSpPr>
            <a:cxnSpLocks/>
          </p:cNvCxnSpPr>
          <p:nvPr/>
        </p:nvCxnSpPr>
        <p:spPr>
          <a:xfrm>
            <a:off x="4905637" y="4523895"/>
            <a:ext cx="605397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AC7F4AED-5ED8-F745-8443-1298510F02FB}"/>
              </a:ext>
            </a:extLst>
          </p:cNvPr>
          <p:cNvSpPr txBox="1"/>
          <p:nvPr/>
        </p:nvSpPr>
        <p:spPr>
          <a:xfrm>
            <a:off x="4861724" y="4315227"/>
            <a:ext cx="69322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>
                <a:solidFill>
                  <a:srgbClr val="FF0000"/>
                </a:solidFill>
              </a:rPr>
              <a:t>p = 0.06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76AA250C-3237-BA46-B5D1-E07E4210511C}"/>
              </a:ext>
            </a:extLst>
          </p:cNvPr>
          <p:cNvCxnSpPr>
            <a:cxnSpLocks/>
          </p:cNvCxnSpPr>
          <p:nvPr/>
        </p:nvCxnSpPr>
        <p:spPr>
          <a:xfrm>
            <a:off x="6645566" y="4721451"/>
            <a:ext cx="605397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FA67A3CA-E50E-9A49-B70C-0034A4BFDFC1}"/>
              </a:ext>
            </a:extLst>
          </p:cNvPr>
          <p:cNvSpPr txBox="1"/>
          <p:nvPr/>
        </p:nvSpPr>
        <p:spPr>
          <a:xfrm>
            <a:off x="6725991" y="4501971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9322881-BAF9-1D4E-96B7-DFDFC47613DF}"/>
              </a:ext>
            </a:extLst>
          </p:cNvPr>
          <p:cNvSpPr txBox="1"/>
          <p:nvPr/>
        </p:nvSpPr>
        <p:spPr>
          <a:xfrm>
            <a:off x="3768285" y="3165473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B81D384-2BA9-214F-9445-1C71C94AAA68}"/>
              </a:ext>
            </a:extLst>
          </p:cNvPr>
          <p:cNvSpPr txBox="1"/>
          <p:nvPr/>
        </p:nvSpPr>
        <p:spPr>
          <a:xfrm rot="16200000">
            <a:off x="3039795" y="5143853"/>
            <a:ext cx="214833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8</a:t>
            </a:r>
            <a:r>
              <a:rPr lang="en-US" sz="1400" baseline="30000" dirty="0"/>
              <a:t>+</a:t>
            </a:r>
            <a:r>
              <a:rPr lang="en-US" sz="1400" dirty="0"/>
              <a:t> CD69</a:t>
            </a:r>
            <a:r>
              <a:rPr lang="en-US" sz="1400" baseline="30000" dirty="0"/>
              <a:t>+</a:t>
            </a:r>
            <a:r>
              <a:rPr lang="en-US" sz="1400" dirty="0"/>
              <a:t> T cells (%)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81E79DB-7683-334A-A0C5-7102DE14A8D3}"/>
              </a:ext>
            </a:extLst>
          </p:cNvPr>
          <p:cNvSpPr txBox="1"/>
          <p:nvPr/>
        </p:nvSpPr>
        <p:spPr>
          <a:xfrm>
            <a:off x="7227854" y="2782577"/>
            <a:ext cx="302549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CD69</a:t>
            </a:r>
            <a:r>
              <a:rPr lang="en-US" sz="1400" baseline="30000" dirty="0"/>
              <a:t>+</a:t>
            </a:r>
            <a:r>
              <a:rPr lang="en-US" sz="1400" dirty="0"/>
              <a:t> Responders over Baselin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0A20C68-8FF1-C14E-953C-8774855E880A}"/>
              </a:ext>
            </a:extLst>
          </p:cNvPr>
          <p:cNvSpPr txBox="1"/>
          <p:nvPr/>
        </p:nvSpPr>
        <p:spPr>
          <a:xfrm>
            <a:off x="6824705" y="314059"/>
            <a:ext cx="42466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 (stimulated, all ages)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7565BE6-283C-D943-A3F3-7F79B240221A}"/>
              </a:ext>
            </a:extLst>
          </p:cNvPr>
          <p:cNvSpPr txBox="1"/>
          <p:nvPr/>
        </p:nvSpPr>
        <p:spPr>
          <a:xfrm>
            <a:off x="6301726" y="1592210"/>
            <a:ext cx="11437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/>
              <a:t>HLA-E*01:0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755F82C-9C13-0243-A9B6-F95E5E59D416}"/>
              </a:ext>
            </a:extLst>
          </p:cNvPr>
          <p:cNvSpPr txBox="1"/>
          <p:nvPr/>
        </p:nvSpPr>
        <p:spPr>
          <a:xfrm>
            <a:off x="6274189" y="2060322"/>
            <a:ext cx="11988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/>
              <a:t>Heterozygous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70F28F4-AC09-5D4D-B7CF-8F5325A96290}"/>
              </a:ext>
            </a:extLst>
          </p:cNvPr>
          <p:cNvSpPr txBox="1"/>
          <p:nvPr/>
        </p:nvSpPr>
        <p:spPr>
          <a:xfrm>
            <a:off x="6329263" y="1109185"/>
            <a:ext cx="11437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/>
              <a:t>HLA-E*01:0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42087D8-AE4C-D540-9B68-4647AFF8886C}"/>
              </a:ext>
            </a:extLst>
          </p:cNvPr>
          <p:cNvSpPr txBox="1"/>
          <p:nvPr/>
        </p:nvSpPr>
        <p:spPr>
          <a:xfrm>
            <a:off x="5870370" y="3583738"/>
            <a:ext cx="1544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/>
              <a:t>HLA-E*01:03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054AA387-3D40-9640-89AC-57173DED550E}"/>
              </a:ext>
            </a:extLst>
          </p:cNvPr>
          <p:cNvSpPr txBox="1"/>
          <p:nvPr/>
        </p:nvSpPr>
        <p:spPr>
          <a:xfrm>
            <a:off x="7779275" y="3585068"/>
            <a:ext cx="14016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/>
              <a:t>Heterozygou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8595AAE-56C7-764F-98F6-AE8B651269F4}"/>
              </a:ext>
            </a:extLst>
          </p:cNvPr>
          <p:cNvSpPr txBox="1"/>
          <p:nvPr/>
        </p:nvSpPr>
        <p:spPr>
          <a:xfrm>
            <a:off x="4228174" y="3583796"/>
            <a:ext cx="1552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/>
              <a:t>HLA-E*01:01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952D2C5B-F330-3447-9362-65DEB097B48B}"/>
              </a:ext>
            </a:extLst>
          </p:cNvPr>
          <p:cNvCxnSpPr>
            <a:cxnSpLocks/>
          </p:cNvCxnSpPr>
          <p:nvPr/>
        </p:nvCxnSpPr>
        <p:spPr>
          <a:xfrm>
            <a:off x="10123002" y="1746098"/>
            <a:ext cx="0" cy="53636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739C2697-1749-BF4F-8305-302F23A0F7CF}"/>
              </a:ext>
            </a:extLst>
          </p:cNvPr>
          <p:cNvSpPr txBox="1"/>
          <p:nvPr/>
        </p:nvSpPr>
        <p:spPr>
          <a:xfrm rot="5400000">
            <a:off x="9903349" y="1885582"/>
            <a:ext cx="693222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p = 0.09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F34883A-DC67-5844-BE7A-604E367724FE}"/>
              </a:ext>
            </a:extLst>
          </p:cNvPr>
          <p:cNvSpPr txBox="1"/>
          <p:nvPr/>
        </p:nvSpPr>
        <p:spPr>
          <a:xfrm>
            <a:off x="4701143" y="3212832"/>
            <a:ext cx="435656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Gated on CD8+ T (stimulated, all ages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E62C328-EF79-6240-B354-7997A056802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83943" y="369790"/>
            <a:ext cx="3609803" cy="2459509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044C2B27-07BA-7248-AE7E-AC38AC285D33}"/>
              </a:ext>
            </a:extLst>
          </p:cNvPr>
          <p:cNvSpPr txBox="1"/>
          <p:nvPr/>
        </p:nvSpPr>
        <p:spPr>
          <a:xfrm>
            <a:off x="9543541" y="1634944"/>
            <a:ext cx="9551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85.7 %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DFEE05E4-C0FA-0543-97D4-56F705CD7692}"/>
              </a:ext>
            </a:extLst>
          </p:cNvPr>
          <p:cNvSpPr txBox="1"/>
          <p:nvPr/>
        </p:nvSpPr>
        <p:spPr>
          <a:xfrm>
            <a:off x="8977951" y="1162236"/>
            <a:ext cx="756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60 %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5B9C12F-EE20-0449-94EB-828D540A1CF4}"/>
              </a:ext>
            </a:extLst>
          </p:cNvPr>
          <p:cNvSpPr txBox="1"/>
          <p:nvPr/>
        </p:nvSpPr>
        <p:spPr>
          <a:xfrm>
            <a:off x="8565403" y="2111132"/>
            <a:ext cx="756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41.7 %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21E8C8D-4C15-A142-A0D8-5D42D800CD5F}"/>
              </a:ext>
            </a:extLst>
          </p:cNvPr>
          <p:cNvSpPr txBox="1"/>
          <p:nvPr/>
        </p:nvSpPr>
        <p:spPr>
          <a:xfrm>
            <a:off x="6286164" y="3773709"/>
            <a:ext cx="444546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*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2D1E9A86-31D2-2746-BACC-AF180769EB2A}"/>
              </a:ext>
            </a:extLst>
          </p:cNvPr>
          <p:cNvCxnSpPr>
            <a:cxnSpLocks/>
          </p:cNvCxnSpPr>
          <p:nvPr/>
        </p:nvCxnSpPr>
        <p:spPr>
          <a:xfrm flipV="1">
            <a:off x="4876865" y="4334436"/>
            <a:ext cx="1770925" cy="94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33456EA9-40B8-9047-AF43-70B74909DF71}"/>
              </a:ext>
            </a:extLst>
          </p:cNvPr>
          <p:cNvCxnSpPr>
            <a:cxnSpLocks/>
          </p:cNvCxnSpPr>
          <p:nvPr/>
        </p:nvCxnSpPr>
        <p:spPr>
          <a:xfrm>
            <a:off x="6703856" y="4258233"/>
            <a:ext cx="16235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A967BA00-0835-9D46-B318-A9FB5AA33259}"/>
              </a:ext>
            </a:extLst>
          </p:cNvPr>
          <p:cNvCxnSpPr>
            <a:cxnSpLocks/>
          </p:cNvCxnSpPr>
          <p:nvPr/>
        </p:nvCxnSpPr>
        <p:spPr>
          <a:xfrm>
            <a:off x="4873993" y="4039835"/>
            <a:ext cx="345343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DD1308A5-ACCB-0640-8BE9-ED3DD7CEDDB4}"/>
              </a:ext>
            </a:extLst>
          </p:cNvPr>
          <p:cNvSpPr txBox="1"/>
          <p:nvPr/>
        </p:nvSpPr>
        <p:spPr>
          <a:xfrm>
            <a:off x="7241662" y="4038907"/>
            <a:ext cx="54795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***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402C17D-C8E7-EF4C-AA26-B5C37174B06E}"/>
              </a:ext>
            </a:extLst>
          </p:cNvPr>
          <p:cNvSpPr txBox="1"/>
          <p:nvPr/>
        </p:nvSpPr>
        <p:spPr>
          <a:xfrm>
            <a:off x="5541241" y="4085555"/>
            <a:ext cx="444546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*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3AEDF0C3-65FF-0445-9E12-851A7CF824B6}"/>
              </a:ext>
            </a:extLst>
          </p:cNvPr>
          <p:cNvSpPr/>
          <p:nvPr/>
        </p:nvSpPr>
        <p:spPr>
          <a:xfrm>
            <a:off x="6587" y="3350139"/>
            <a:ext cx="3660856" cy="34778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Supplemental Fig 2. Changes in Activated CD8 T cell Populations Following Ty21a Vaccination. A and D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catter plot showing the percentages of CD69+ CD8+ T cells among pre- and post-Ty21a unstimulated PBMC. Bars represent medians with whiskers indicating interquartile ranges.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B and E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onnected dot plot showing each participants’ pre- and post-Ty21a CD8+ CD69+ expression levels following co-culture with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. Typhi-infected HLA-E restricted antigen presenting target cells.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C and F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Bars representing the proportion of CD8+ CD69+ responders over baseline levels (cutoff of 0.1%) following co-culture with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. Typhi- infected HLA-E restricted antigen presenting target cells. Data divided among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A-C)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(D-F)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HLA-E*01:01 (n=10), HLA-E*01:03 (n=6), and HLA-E heterozygous (n=12)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articipants. Statistics were analyzed by paired t-test (in red) or unpaired t-test (in black). (* p&lt;0.05; *** p&lt;0.001) </a:t>
            </a:r>
            <a:endParaRPr lang="en-US" sz="1100" dirty="0"/>
          </a:p>
        </p:txBody>
      </p:sp>
      <p:grpSp>
        <p:nvGrpSpPr>
          <p:cNvPr id="86" name="Group 85">
            <a:extLst>
              <a:ext uri="{FF2B5EF4-FFF2-40B4-BE49-F238E27FC236}">
                <a16:creationId xmlns:a16="http://schemas.microsoft.com/office/drawing/2014/main" id="{09725F6E-82AD-3948-8733-941836019014}"/>
              </a:ext>
            </a:extLst>
          </p:cNvPr>
          <p:cNvGrpSpPr/>
          <p:nvPr/>
        </p:nvGrpSpPr>
        <p:grpSpPr>
          <a:xfrm>
            <a:off x="9514374" y="3294901"/>
            <a:ext cx="1421348" cy="612464"/>
            <a:chOff x="7355021" y="1783844"/>
            <a:chExt cx="1421348" cy="612464"/>
          </a:xfrm>
        </p:grpSpPr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63E3A93A-0669-F14F-BF05-3B6F6C816687}"/>
                </a:ext>
              </a:extLst>
            </p:cNvPr>
            <p:cNvGrpSpPr/>
            <p:nvPr/>
          </p:nvGrpSpPr>
          <p:grpSpPr>
            <a:xfrm>
              <a:off x="7362131" y="1783844"/>
              <a:ext cx="1414238" cy="612464"/>
              <a:chOff x="7437119" y="1671362"/>
              <a:chExt cx="1414238" cy="612464"/>
            </a:xfrm>
          </p:grpSpPr>
          <p:sp>
            <p:nvSpPr>
              <p:cNvPr id="91" name="Oval 90">
                <a:extLst>
                  <a:ext uri="{FF2B5EF4-FFF2-40B4-BE49-F238E27FC236}">
                    <a16:creationId xmlns:a16="http://schemas.microsoft.com/office/drawing/2014/main" id="{4CDD3F69-13AD-6841-A496-19482EA69491}"/>
                  </a:ext>
                </a:extLst>
              </p:cNvPr>
              <p:cNvSpPr/>
              <p:nvPr/>
            </p:nvSpPr>
            <p:spPr>
              <a:xfrm>
                <a:off x="7437119" y="1752600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rgbClr val="009193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2" name="Oval 91">
                <a:extLst>
                  <a:ext uri="{FF2B5EF4-FFF2-40B4-BE49-F238E27FC236}">
                    <a16:creationId xmlns:a16="http://schemas.microsoft.com/office/drawing/2014/main" id="{8D00F4FD-9530-C84B-9CF0-AADA3B1DE62B}"/>
                  </a:ext>
                </a:extLst>
              </p:cNvPr>
              <p:cNvSpPr/>
              <p:nvPr/>
            </p:nvSpPr>
            <p:spPr>
              <a:xfrm>
                <a:off x="7437119" y="1933647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rgbClr val="D883FF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C8CD0552-87D0-FB4E-9999-DA562F638FC6}"/>
                  </a:ext>
                </a:extLst>
              </p:cNvPr>
              <p:cNvSpPr txBox="1"/>
              <p:nvPr/>
            </p:nvSpPr>
            <p:spPr>
              <a:xfrm>
                <a:off x="7528559" y="1671362"/>
                <a:ext cx="127470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LA-E*01:01 (n=10)</a:t>
                </a:r>
              </a:p>
            </p:txBody>
          </p:sp>
          <p:sp>
            <p:nvSpPr>
              <p:cNvPr id="94" name="TextBox 93">
                <a:extLst>
                  <a:ext uri="{FF2B5EF4-FFF2-40B4-BE49-F238E27FC236}">
                    <a16:creationId xmlns:a16="http://schemas.microsoft.com/office/drawing/2014/main" id="{7DFD1CFA-B095-8B4D-9BAC-A9A25C30E869}"/>
                  </a:ext>
                </a:extLst>
              </p:cNvPr>
              <p:cNvSpPr txBox="1"/>
              <p:nvPr/>
            </p:nvSpPr>
            <p:spPr>
              <a:xfrm>
                <a:off x="7528559" y="1852409"/>
                <a:ext cx="120577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LA-E*01:03 (n=6)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84E79D72-B5E6-694B-8A6A-1AB93F6D79FF}"/>
                  </a:ext>
                </a:extLst>
              </p:cNvPr>
              <p:cNvSpPr txBox="1"/>
              <p:nvPr/>
            </p:nvSpPr>
            <p:spPr>
              <a:xfrm>
                <a:off x="7528559" y="2029910"/>
                <a:ext cx="132279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eterozygous (n=12)</a:t>
                </a:r>
              </a:p>
            </p:txBody>
          </p:sp>
        </p:grpSp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640BACC9-2DE8-564B-9902-2FE08A98DE4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355021" y="2225593"/>
              <a:ext cx="107572" cy="100584"/>
              <a:chOff x="6717066" y="5643716"/>
              <a:chExt cx="743963" cy="685800"/>
            </a:xfrm>
          </p:grpSpPr>
          <p:sp>
            <p:nvSpPr>
              <p:cNvPr id="89" name="Chord 88">
                <a:extLst>
                  <a:ext uri="{FF2B5EF4-FFF2-40B4-BE49-F238E27FC236}">
                    <a16:creationId xmlns:a16="http://schemas.microsoft.com/office/drawing/2014/main" id="{FAC4DEC4-7D58-ED4F-BA90-5709108812DE}"/>
                  </a:ext>
                </a:extLst>
              </p:cNvPr>
              <p:cNvSpPr/>
              <p:nvPr/>
            </p:nvSpPr>
            <p:spPr>
              <a:xfrm>
                <a:off x="6717066" y="5643716"/>
                <a:ext cx="685800" cy="685800"/>
              </a:xfrm>
              <a:prstGeom prst="chord">
                <a:avLst>
                  <a:gd name="adj1" fmla="val 5438129"/>
                  <a:gd name="adj2" fmla="val 16148966"/>
                </a:avLst>
              </a:prstGeom>
              <a:solidFill>
                <a:srgbClr val="D883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0" name="Chord 89">
                <a:extLst>
                  <a:ext uri="{FF2B5EF4-FFF2-40B4-BE49-F238E27FC236}">
                    <a16:creationId xmlns:a16="http://schemas.microsoft.com/office/drawing/2014/main" id="{D92634F9-9E2F-6D4C-B27E-1CA73C1EF3ED}"/>
                  </a:ext>
                </a:extLst>
              </p:cNvPr>
              <p:cNvSpPr/>
              <p:nvPr/>
            </p:nvSpPr>
            <p:spPr>
              <a:xfrm rot="10800000">
                <a:off x="6775231" y="5643716"/>
                <a:ext cx="685798" cy="685800"/>
              </a:xfrm>
              <a:prstGeom prst="chord">
                <a:avLst>
                  <a:gd name="adj1" fmla="val 5438129"/>
                  <a:gd name="adj2" fmla="val 16148966"/>
                </a:avLst>
              </a:prstGeom>
              <a:solidFill>
                <a:srgbClr val="00919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65" name="TextBox 64">
            <a:extLst>
              <a:ext uri="{FF2B5EF4-FFF2-40B4-BE49-F238E27FC236}">
                <a16:creationId xmlns:a16="http://schemas.microsoft.com/office/drawing/2014/main" id="{BF786A4A-A3C5-D04E-A4A8-4E96A18A1DB2}"/>
              </a:ext>
            </a:extLst>
          </p:cNvPr>
          <p:cNvSpPr txBox="1"/>
          <p:nvPr/>
        </p:nvSpPr>
        <p:spPr>
          <a:xfrm>
            <a:off x="2479282" y="2856938"/>
            <a:ext cx="186349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Pre-Vaccinatio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CA226E6-B978-8A48-BB91-7F775E363362}"/>
              </a:ext>
            </a:extLst>
          </p:cNvPr>
          <p:cNvSpPr txBox="1"/>
          <p:nvPr/>
        </p:nvSpPr>
        <p:spPr>
          <a:xfrm>
            <a:off x="4246519" y="2852143"/>
            <a:ext cx="186349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Post-Vaccination</a:t>
            </a:r>
          </a:p>
        </p:txBody>
      </p:sp>
    </p:spTree>
    <p:extLst>
      <p:ext uri="{BB962C8B-B14F-4D97-AF65-F5344CB8AC3E}">
        <p14:creationId xmlns:p14="http://schemas.microsoft.com/office/powerpoint/2010/main" val="916111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5D7BBBF-1445-BC42-B13F-E62DB379F9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97924" y="510671"/>
            <a:ext cx="4898694" cy="274866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E9481BC-B4A9-834B-B8DE-CE6F4FF59D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54176" y="3620002"/>
            <a:ext cx="4476996" cy="286289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C63D624-32E3-784C-B23C-24DB4BE0D5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3130" y="601393"/>
            <a:ext cx="5279852" cy="2623630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1058915" y="3233506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IP-1β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744715" y="3234329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107a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2440805" y="3233505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NFα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144399" y="3234275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L-2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909344" y="3233504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L-17A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4595144" y="3233504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FN𝛾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5280944" y="3233503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/>
              <a:t>GzmB</a:t>
            </a:r>
            <a:endParaRPr lang="en-US" sz="1200" dirty="0"/>
          </a:p>
        </p:txBody>
      </p:sp>
      <p:sp>
        <p:nvSpPr>
          <p:cNvPr id="55" name="TextBox 54"/>
          <p:cNvSpPr txBox="1"/>
          <p:nvPr/>
        </p:nvSpPr>
        <p:spPr>
          <a:xfrm>
            <a:off x="1088098" y="6480070"/>
            <a:ext cx="837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 Function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2100096" y="6484256"/>
            <a:ext cx="10048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 Functions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3193820" y="6480070"/>
            <a:ext cx="954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3 Functions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4248957" y="6482901"/>
            <a:ext cx="1054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&gt;3 Functions </a:t>
            </a:r>
          </a:p>
        </p:txBody>
      </p:sp>
      <p:sp>
        <p:nvSpPr>
          <p:cNvPr id="59" name="TextBox 58"/>
          <p:cNvSpPr txBox="1"/>
          <p:nvPr/>
        </p:nvSpPr>
        <p:spPr>
          <a:xfrm rot="16200000">
            <a:off x="-912074" y="1779348"/>
            <a:ext cx="29802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171011" y="399399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165489" y="3565052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6301534" y="399399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2613CBCA-4212-F34E-A61F-6AEF73934BE8}"/>
              </a:ext>
            </a:extLst>
          </p:cNvPr>
          <p:cNvCxnSpPr>
            <a:cxnSpLocks/>
          </p:cNvCxnSpPr>
          <p:nvPr/>
        </p:nvCxnSpPr>
        <p:spPr>
          <a:xfrm>
            <a:off x="1364827" y="4786004"/>
            <a:ext cx="2837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D2318FB5-1A26-8146-AC45-F8AFE2800292}"/>
              </a:ext>
            </a:extLst>
          </p:cNvPr>
          <p:cNvCxnSpPr>
            <a:cxnSpLocks/>
          </p:cNvCxnSpPr>
          <p:nvPr/>
        </p:nvCxnSpPr>
        <p:spPr>
          <a:xfrm>
            <a:off x="1648554" y="4978598"/>
            <a:ext cx="2837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>
            <a:extLst>
              <a:ext uri="{FF2B5EF4-FFF2-40B4-BE49-F238E27FC236}">
                <a16:creationId xmlns:a16="http://schemas.microsoft.com/office/drawing/2014/main" id="{4262D1D4-561E-144C-A9A4-77D732104DEF}"/>
              </a:ext>
            </a:extLst>
          </p:cNvPr>
          <p:cNvSpPr txBox="1"/>
          <p:nvPr/>
        </p:nvSpPr>
        <p:spPr>
          <a:xfrm>
            <a:off x="1284417" y="4573123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*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E4E57C7-127F-EE44-B3A3-2DF8A5265EBD}"/>
              </a:ext>
            </a:extLst>
          </p:cNvPr>
          <p:cNvSpPr txBox="1"/>
          <p:nvPr/>
        </p:nvSpPr>
        <p:spPr>
          <a:xfrm>
            <a:off x="1568144" y="4752431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03204129-686E-854B-B0F6-CDF8882E7F7B}"/>
              </a:ext>
            </a:extLst>
          </p:cNvPr>
          <p:cNvCxnSpPr>
            <a:cxnSpLocks/>
          </p:cNvCxnSpPr>
          <p:nvPr/>
        </p:nvCxnSpPr>
        <p:spPr>
          <a:xfrm>
            <a:off x="4963096" y="1577002"/>
            <a:ext cx="2146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DACFE469-DEFE-1049-AD76-6444168B7B38}"/>
              </a:ext>
            </a:extLst>
          </p:cNvPr>
          <p:cNvCxnSpPr>
            <a:cxnSpLocks/>
          </p:cNvCxnSpPr>
          <p:nvPr/>
        </p:nvCxnSpPr>
        <p:spPr>
          <a:xfrm>
            <a:off x="4809445" y="1758161"/>
            <a:ext cx="2146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9622CD7D-D97E-A847-84FB-9959E121C2F3}"/>
              </a:ext>
            </a:extLst>
          </p:cNvPr>
          <p:cNvSpPr txBox="1"/>
          <p:nvPr/>
        </p:nvSpPr>
        <p:spPr>
          <a:xfrm>
            <a:off x="4721883" y="1354524"/>
            <a:ext cx="69322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p = 0.05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60993E94-C064-9240-ABE0-D564EE18505E}"/>
              </a:ext>
            </a:extLst>
          </p:cNvPr>
          <p:cNvSpPr txBox="1"/>
          <p:nvPr/>
        </p:nvSpPr>
        <p:spPr>
          <a:xfrm>
            <a:off x="2219007" y="218381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</a:t>
            </a:r>
            <a:r>
              <a:rPr lang="en-US" dirty="0"/>
              <a:t> cells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10273B92-D55B-594A-95F8-530FF9FDAE26}"/>
              </a:ext>
            </a:extLst>
          </p:cNvPr>
          <p:cNvSpPr txBox="1"/>
          <p:nvPr/>
        </p:nvSpPr>
        <p:spPr>
          <a:xfrm>
            <a:off x="1958965" y="3620002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</a:t>
            </a:r>
            <a:r>
              <a:rPr lang="en-US" dirty="0"/>
              <a:t> cells</a:t>
            </a:r>
          </a:p>
        </p:txBody>
      </p:sp>
      <p:graphicFrame>
        <p:nvGraphicFramePr>
          <p:cNvPr id="115" name="Table 114">
            <a:extLst>
              <a:ext uri="{FF2B5EF4-FFF2-40B4-BE49-F238E27FC236}">
                <a16:creationId xmlns:a16="http://schemas.microsoft.com/office/drawing/2014/main" id="{37582100-3A1E-5243-A823-D76EDD0B36A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262351"/>
              </p:ext>
            </p:extLst>
          </p:nvPr>
        </p:nvGraphicFramePr>
        <p:xfrm>
          <a:off x="6566840" y="3284162"/>
          <a:ext cx="5276243" cy="1524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3749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NFα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IP-1β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D107a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FN𝛾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L-2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</a:tbl>
          </a:graphicData>
        </a:graphic>
      </p:graphicFrame>
      <p:sp>
        <p:nvSpPr>
          <p:cNvPr id="116" name="TextBox 115">
            <a:extLst>
              <a:ext uri="{FF2B5EF4-FFF2-40B4-BE49-F238E27FC236}">
                <a16:creationId xmlns:a16="http://schemas.microsoft.com/office/drawing/2014/main" id="{3A7502CA-C3DB-764E-829F-7AA64B171688}"/>
              </a:ext>
            </a:extLst>
          </p:cNvPr>
          <p:cNvSpPr txBox="1"/>
          <p:nvPr/>
        </p:nvSpPr>
        <p:spPr>
          <a:xfrm rot="16200000">
            <a:off x="-783135" y="4998430"/>
            <a:ext cx="2828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8817FA24-7604-104D-9DE4-9BCB8DF1706F}"/>
              </a:ext>
            </a:extLst>
          </p:cNvPr>
          <p:cNvCxnSpPr>
            <a:cxnSpLocks/>
          </p:cNvCxnSpPr>
          <p:nvPr/>
        </p:nvCxnSpPr>
        <p:spPr>
          <a:xfrm>
            <a:off x="8125780" y="1913860"/>
            <a:ext cx="20049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26CB65FB-B04F-CD45-AA26-6CBCFCE028F3}"/>
              </a:ext>
            </a:extLst>
          </p:cNvPr>
          <p:cNvSpPr txBox="1"/>
          <p:nvPr/>
        </p:nvSpPr>
        <p:spPr>
          <a:xfrm>
            <a:off x="8003754" y="1685056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1D62F57-BAE0-D943-A34A-AD48A48DF433}"/>
              </a:ext>
            </a:extLst>
          </p:cNvPr>
          <p:cNvSpPr txBox="1"/>
          <p:nvPr/>
        </p:nvSpPr>
        <p:spPr>
          <a:xfrm>
            <a:off x="8245722" y="223988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</a:t>
            </a:r>
            <a:r>
              <a:rPr lang="en-US" dirty="0"/>
              <a:t> cells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00DE505-418F-9143-A8D8-0ECBAB18FE64}"/>
              </a:ext>
            </a:extLst>
          </p:cNvPr>
          <p:cNvSpPr txBox="1"/>
          <p:nvPr/>
        </p:nvSpPr>
        <p:spPr>
          <a:xfrm rot="16200000">
            <a:off x="5399882" y="1621062"/>
            <a:ext cx="28511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C2BDA3B0-5A0C-7442-AA3B-E374B0FC3FD7}"/>
              </a:ext>
            </a:extLst>
          </p:cNvPr>
          <p:cNvSpPr/>
          <p:nvPr/>
        </p:nvSpPr>
        <p:spPr>
          <a:xfrm>
            <a:off x="6413947" y="4906058"/>
            <a:ext cx="5582028" cy="18004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Supplemental Fig 3. CD8+ T Effector Memory Response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Scatter plots showing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+D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the increases over baseline percentages of CD8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producing MIP1β, CD107a, TNFα, IL-2, IL-17A, IFN𝛾, and Granzyme B (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;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B+E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CD8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observed mono-, bi-, tri-, and &gt;3-functional populations, and;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C+F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CD8+CD69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selected multifunctional responses  following co-culture with HLA-E restricte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. Typhi infected antigen presenting targets. These MF populations were selected based on those shown in a previous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S.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Typhi challenge study to be associated with protection from developing disease (10,11). Bars represent medians with whiskers indicating interquartile ranges. Data divided among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(A-C)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(D-F)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HLA-E*01:01 (n=10), HLA-E*01:03 (n=6), and HLA-E heterozygous (n=12)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participants. Scatter plot statistics were analyzed by unpaired t-test. (* p&lt;0.05; ** p&lt;0.01) </a:t>
            </a:r>
            <a:endParaRPr lang="en-US" sz="1000" b="1" dirty="0">
              <a:solidFill>
                <a:srgbClr val="C00000"/>
              </a:solidFill>
            </a:endParaRPr>
          </a:p>
        </p:txBody>
      </p:sp>
      <p:grpSp>
        <p:nvGrpSpPr>
          <p:cNvPr id="85" name="Group 84">
            <a:extLst>
              <a:ext uri="{FF2B5EF4-FFF2-40B4-BE49-F238E27FC236}">
                <a16:creationId xmlns:a16="http://schemas.microsoft.com/office/drawing/2014/main" id="{6E5094D0-6BA6-9E4C-9DB8-B28A36C9E02B}"/>
              </a:ext>
            </a:extLst>
          </p:cNvPr>
          <p:cNvGrpSpPr/>
          <p:nvPr/>
        </p:nvGrpSpPr>
        <p:grpSpPr>
          <a:xfrm>
            <a:off x="4776382" y="4046162"/>
            <a:ext cx="1875744" cy="794966"/>
            <a:chOff x="10279866" y="1001743"/>
            <a:chExt cx="1793913" cy="794966"/>
          </a:xfrm>
        </p:grpSpPr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093B3371-8787-BE4B-BD5F-41FB02924C1B}"/>
                </a:ext>
              </a:extLst>
            </p:cNvPr>
            <p:cNvGrpSpPr/>
            <p:nvPr/>
          </p:nvGrpSpPr>
          <p:grpSpPr>
            <a:xfrm>
              <a:off x="10279866" y="1001743"/>
              <a:ext cx="1793913" cy="794966"/>
              <a:chOff x="10072002" y="392204"/>
              <a:chExt cx="1673319" cy="794966"/>
            </a:xfrm>
          </p:grpSpPr>
          <p:sp>
            <p:nvSpPr>
              <p:cNvPr id="89" name="Oval 88">
                <a:extLst>
                  <a:ext uri="{FF2B5EF4-FFF2-40B4-BE49-F238E27FC236}">
                    <a16:creationId xmlns:a16="http://schemas.microsoft.com/office/drawing/2014/main" id="{5505D83E-E585-9741-BCE1-0FEF22354E9D}"/>
                  </a:ext>
                </a:extLst>
              </p:cNvPr>
              <p:cNvSpPr/>
              <p:nvPr/>
            </p:nvSpPr>
            <p:spPr>
              <a:xfrm>
                <a:off x="10072002" y="487297"/>
                <a:ext cx="81572" cy="91440"/>
              </a:xfrm>
              <a:prstGeom prst="ellipse">
                <a:avLst/>
              </a:prstGeom>
              <a:solidFill>
                <a:srgbClr val="76D6FF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0" name="Oval 89">
                <a:extLst>
                  <a:ext uri="{FF2B5EF4-FFF2-40B4-BE49-F238E27FC236}">
                    <a16:creationId xmlns:a16="http://schemas.microsoft.com/office/drawing/2014/main" id="{FF4AA635-3D62-C44A-9CE9-65B0D5E1AC4C}"/>
                  </a:ext>
                </a:extLst>
              </p:cNvPr>
              <p:cNvSpPr/>
              <p:nvPr/>
            </p:nvSpPr>
            <p:spPr>
              <a:xfrm>
                <a:off x="10072002" y="656264"/>
                <a:ext cx="81572" cy="91440"/>
              </a:xfrm>
              <a:prstGeom prst="ellipse">
                <a:avLst/>
              </a:prstGeom>
              <a:solidFill>
                <a:srgbClr val="FF7E79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0FD0A85F-5DF8-EF47-8547-375422C74639}"/>
                  </a:ext>
                </a:extLst>
              </p:cNvPr>
              <p:cNvSpPr txBox="1"/>
              <p:nvPr/>
            </p:nvSpPr>
            <p:spPr>
              <a:xfrm>
                <a:off x="10163442" y="574706"/>
                <a:ext cx="158187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ed Female (n=8; 11-17 </a:t>
                </a:r>
                <a:r>
                  <a:rPr lang="en-US" sz="1050" dirty="0" err="1"/>
                  <a:t>yrs</a:t>
                </a:r>
                <a:r>
                  <a:rPr lang="en-US" sz="1050" dirty="0"/>
                  <a:t>)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AA0AA705-8D0B-C74D-A0F0-34938157F7F0}"/>
                  </a:ext>
                </a:extLst>
              </p:cNvPr>
              <p:cNvSpPr txBox="1"/>
              <p:nvPr/>
            </p:nvSpPr>
            <p:spPr>
              <a:xfrm>
                <a:off x="10163442" y="392204"/>
                <a:ext cx="147319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ed Male (n=10; 6-17 </a:t>
                </a:r>
                <a:r>
                  <a:rPr lang="en-US" sz="1050" dirty="0" err="1"/>
                  <a:t>yrs</a:t>
                </a:r>
                <a:r>
                  <a:rPr lang="en-US" sz="1050" dirty="0"/>
                  <a:t>)</a:t>
                </a: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35F94334-0622-404B-8C54-8C75CEF6FAED}"/>
                  </a:ext>
                </a:extLst>
              </p:cNvPr>
              <p:cNvSpPr txBox="1"/>
              <p:nvPr/>
            </p:nvSpPr>
            <p:spPr>
              <a:xfrm>
                <a:off x="10163442" y="933254"/>
                <a:ext cx="109424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Adult Female (n=6)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4C1194F4-6339-7B48-8349-21A534984BFE}"/>
                  </a:ext>
                </a:extLst>
              </p:cNvPr>
              <p:cNvSpPr txBox="1"/>
              <p:nvPr/>
            </p:nvSpPr>
            <p:spPr>
              <a:xfrm>
                <a:off x="10163442" y="745241"/>
                <a:ext cx="98556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Adult Male (n=7)</a:t>
                </a:r>
              </a:p>
            </p:txBody>
          </p:sp>
        </p:grp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DC935332-2EC3-5A44-8FC5-9B72A9C0C86C}"/>
                </a:ext>
              </a:extLst>
            </p:cNvPr>
            <p:cNvSpPr/>
            <p:nvPr/>
          </p:nvSpPr>
          <p:spPr>
            <a:xfrm>
              <a:off x="10285381" y="1619243"/>
              <a:ext cx="87451" cy="91440"/>
            </a:xfrm>
            <a:prstGeom prst="rect">
              <a:avLst/>
            </a:prstGeom>
            <a:solidFill>
              <a:srgbClr val="9411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4205E3CE-3090-E149-96A3-97874CF0DA5E}"/>
                </a:ext>
              </a:extLst>
            </p:cNvPr>
            <p:cNvSpPr/>
            <p:nvPr/>
          </p:nvSpPr>
          <p:spPr>
            <a:xfrm>
              <a:off x="10285381" y="1448374"/>
              <a:ext cx="88700" cy="90757"/>
            </a:xfrm>
            <a:prstGeom prst="rect">
              <a:avLst/>
            </a:prstGeom>
            <a:solidFill>
              <a:srgbClr val="01189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FC45D0AE-8123-FA45-8BAF-0ED8F5D10657}"/>
              </a:ext>
            </a:extLst>
          </p:cNvPr>
          <p:cNvSpPr txBox="1"/>
          <p:nvPr/>
        </p:nvSpPr>
        <p:spPr>
          <a:xfrm>
            <a:off x="4694482" y="1543876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0BEACA84-77D9-6740-A8DF-DF3A54C634D5}"/>
              </a:ext>
            </a:extLst>
          </p:cNvPr>
          <p:cNvCxnSpPr>
            <a:cxnSpLocks/>
          </p:cNvCxnSpPr>
          <p:nvPr/>
        </p:nvCxnSpPr>
        <p:spPr>
          <a:xfrm>
            <a:off x="2205012" y="4714277"/>
            <a:ext cx="2837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246FA1D3-2669-EB4F-B147-E85BDBDF7DF0}"/>
              </a:ext>
            </a:extLst>
          </p:cNvPr>
          <p:cNvSpPr txBox="1"/>
          <p:nvPr/>
        </p:nvSpPr>
        <p:spPr>
          <a:xfrm>
            <a:off x="2124602" y="4488668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45839F0-91B0-6E44-B8C2-DD75006D49A1}"/>
              </a:ext>
            </a:extLst>
          </p:cNvPr>
          <p:cNvSpPr txBox="1"/>
          <p:nvPr/>
        </p:nvSpPr>
        <p:spPr>
          <a:xfrm>
            <a:off x="-10489" y="-5126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b="1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9058196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862ABA3-24CE-BE4E-B4C9-F58868156E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14065" y="521934"/>
            <a:ext cx="4829628" cy="270991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A98329CF-FE75-F342-A607-030E5E7B4D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79910" y="576611"/>
            <a:ext cx="5150547" cy="267447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906E576-B25A-404F-ACE9-C1C8B34BB4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39239" y="3669382"/>
            <a:ext cx="4110936" cy="2779776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1214918" y="3218802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IP-1β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930036" y="3223563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107a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2625693" y="3231502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NFα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3323012" y="3227615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L-2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4021341" y="3231502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L-17A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4736943" y="3223617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FN𝛾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5428862" y="3231502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/>
              <a:t>GzmB</a:t>
            </a:r>
            <a:endParaRPr lang="en-US" sz="1200" dirty="0"/>
          </a:p>
        </p:txBody>
      </p:sp>
      <p:sp>
        <p:nvSpPr>
          <p:cNvPr id="55" name="TextBox 54"/>
          <p:cNvSpPr txBox="1"/>
          <p:nvPr/>
        </p:nvSpPr>
        <p:spPr>
          <a:xfrm>
            <a:off x="1235026" y="6436122"/>
            <a:ext cx="837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1 Function</a:t>
            </a:r>
            <a:endParaRPr lang="en-US" sz="1200" dirty="0"/>
          </a:p>
        </p:txBody>
      </p:sp>
      <p:sp>
        <p:nvSpPr>
          <p:cNvPr id="56" name="TextBox 55"/>
          <p:cNvSpPr txBox="1"/>
          <p:nvPr/>
        </p:nvSpPr>
        <p:spPr>
          <a:xfrm>
            <a:off x="2148552" y="6435648"/>
            <a:ext cx="10048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2 Functions</a:t>
            </a:r>
            <a:endParaRPr lang="en-US" sz="1200" dirty="0"/>
          </a:p>
        </p:txBody>
      </p:sp>
      <p:sp>
        <p:nvSpPr>
          <p:cNvPr id="57" name="TextBox 56"/>
          <p:cNvSpPr txBox="1"/>
          <p:nvPr/>
        </p:nvSpPr>
        <p:spPr>
          <a:xfrm>
            <a:off x="3159706" y="6435647"/>
            <a:ext cx="954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3 Functions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4095324" y="6441230"/>
            <a:ext cx="1054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&gt;3 Functions </a:t>
            </a:r>
            <a:endParaRPr lang="en-US" sz="1200" dirty="0"/>
          </a:p>
        </p:txBody>
      </p:sp>
      <p:sp>
        <p:nvSpPr>
          <p:cNvPr id="59" name="TextBox 58"/>
          <p:cNvSpPr txBox="1"/>
          <p:nvPr/>
        </p:nvSpPr>
        <p:spPr>
          <a:xfrm rot="16200000">
            <a:off x="-721294" y="1620019"/>
            <a:ext cx="28590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146034" y="481826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D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146034" y="3558804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</a:t>
            </a:r>
          </a:p>
        </p:txBody>
      </p:sp>
      <p:sp>
        <p:nvSpPr>
          <p:cNvPr id="122" name="TextBox 121"/>
          <p:cNvSpPr txBox="1"/>
          <p:nvPr/>
        </p:nvSpPr>
        <p:spPr>
          <a:xfrm>
            <a:off x="2119849" y="359790"/>
            <a:ext cx="267890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</a:t>
            </a:r>
            <a:r>
              <a:rPr lang="en-US" dirty="0"/>
              <a:t> cells</a:t>
            </a:r>
          </a:p>
        </p:txBody>
      </p:sp>
      <p:sp>
        <p:nvSpPr>
          <p:cNvPr id="123" name="TextBox 122"/>
          <p:cNvSpPr txBox="1"/>
          <p:nvPr/>
        </p:nvSpPr>
        <p:spPr>
          <a:xfrm>
            <a:off x="1680519" y="3588445"/>
            <a:ext cx="261289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</a:t>
            </a:r>
            <a:r>
              <a:rPr lang="en-US" dirty="0"/>
              <a:t> cells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F38AF76B-7110-9B43-9566-FED9F860C708}"/>
              </a:ext>
            </a:extLst>
          </p:cNvPr>
          <p:cNvCxnSpPr>
            <a:cxnSpLocks/>
          </p:cNvCxnSpPr>
          <p:nvPr/>
        </p:nvCxnSpPr>
        <p:spPr>
          <a:xfrm>
            <a:off x="1583890" y="4583941"/>
            <a:ext cx="3026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EA12E9A7-1580-C741-A582-058F919D6798}"/>
              </a:ext>
            </a:extLst>
          </p:cNvPr>
          <p:cNvSpPr txBox="1"/>
          <p:nvPr/>
        </p:nvSpPr>
        <p:spPr>
          <a:xfrm>
            <a:off x="1512966" y="4343883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*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F9931E3-096E-3B4B-BE59-860E4621B266}"/>
              </a:ext>
            </a:extLst>
          </p:cNvPr>
          <p:cNvSpPr txBox="1"/>
          <p:nvPr/>
        </p:nvSpPr>
        <p:spPr>
          <a:xfrm rot="16200000">
            <a:off x="-714347" y="4842769"/>
            <a:ext cx="28472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graphicFrame>
        <p:nvGraphicFramePr>
          <p:cNvPr id="82" name="Table 81">
            <a:extLst>
              <a:ext uri="{FF2B5EF4-FFF2-40B4-BE49-F238E27FC236}">
                <a16:creationId xmlns:a16="http://schemas.microsoft.com/office/drawing/2014/main" id="{A3C12FD0-6501-1B40-8F40-E11EB4FC70B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45338437"/>
              </p:ext>
            </p:extLst>
          </p:nvPr>
        </p:nvGraphicFramePr>
        <p:xfrm>
          <a:off x="6467450" y="3284162"/>
          <a:ext cx="5276243" cy="1524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3749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NFα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IP-1β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D107a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FN𝛾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L-2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</a:tbl>
          </a:graphicData>
        </a:graphic>
      </p:graphicFrame>
      <p:sp>
        <p:nvSpPr>
          <p:cNvPr id="83" name="TextBox 82">
            <a:extLst>
              <a:ext uri="{FF2B5EF4-FFF2-40B4-BE49-F238E27FC236}">
                <a16:creationId xmlns:a16="http://schemas.microsoft.com/office/drawing/2014/main" id="{442C7B44-A34F-934D-A9D2-3F4F0E15B53B}"/>
              </a:ext>
            </a:extLst>
          </p:cNvPr>
          <p:cNvSpPr txBox="1"/>
          <p:nvPr/>
        </p:nvSpPr>
        <p:spPr>
          <a:xfrm>
            <a:off x="6237908" y="481052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2E29515-DB19-DA42-A403-2E8BDF0A32ED}"/>
              </a:ext>
            </a:extLst>
          </p:cNvPr>
          <p:cNvSpPr txBox="1"/>
          <p:nvPr/>
        </p:nvSpPr>
        <p:spPr>
          <a:xfrm>
            <a:off x="7880297" y="363593"/>
            <a:ext cx="267353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</a:t>
            </a:r>
            <a:r>
              <a:rPr lang="en-US" dirty="0"/>
              <a:t> cells</a:t>
            </a:r>
          </a:p>
        </p:txBody>
      </p:sp>
      <p:grpSp>
        <p:nvGrpSpPr>
          <p:cNvPr id="62" name="Group 61">
            <a:extLst>
              <a:ext uri="{FF2B5EF4-FFF2-40B4-BE49-F238E27FC236}">
                <a16:creationId xmlns:a16="http://schemas.microsoft.com/office/drawing/2014/main" id="{1F105ED5-F485-3344-8EE0-60959178609F}"/>
              </a:ext>
            </a:extLst>
          </p:cNvPr>
          <p:cNvGrpSpPr/>
          <p:nvPr/>
        </p:nvGrpSpPr>
        <p:grpSpPr>
          <a:xfrm>
            <a:off x="4970237" y="3837236"/>
            <a:ext cx="1421348" cy="612464"/>
            <a:chOff x="7355021" y="1783844"/>
            <a:chExt cx="1421348" cy="612464"/>
          </a:xfrm>
        </p:grpSpPr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96A9B5FA-510A-054F-A315-F1BB261BBD91}"/>
                </a:ext>
              </a:extLst>
            </p:cNvPr>
            <p:cNvGrpSpPr/>
            <p:nvPr/>
          </p:nvGrpSpPr>
          <p:grpSpPr>
            <a:xfrm>
              <a:off x="7362131" y="1783844"/>
              <a:ext cx="1414238" cy="612464"/>
              <a:chOff x="7437119" y="1671362"/>
              <a:chExt cx="1414238" cy="612464"/>
            </a:xfrm>
          </p:grpSpPr>
          <p:sp>
            <p:nvSpPr>
              <p:cNvPr id="69" name="Oval 68">
                <a:extLst>
                  <a:ext uri="{FF2B5EF4-FFF2-40B4-BE49-F238E27FC236}">
                    <a16:creationId xmlns:a16="http://schemas.microsoft.com/office/drawing/2014/main" id="{F028F4DA-242D-B449-969F-57F2F44F143C}"/>
                  </a:ext>
                </a:extLst>
              </p:cNvPr>
              <p:cNvSpPr/>
              <p:nvPr/>
            </p:nvSpPr>
            <p:spPr>
              <a:xfrm>
                <a:off x="7437119" y="1752600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rgbClr val="009193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0" name="Oval 69">
                <a:extLst>
                  <a:ext uri="{FF2B5EF4-FFF2-40B4-BE49-F238E27FC236}">
                    <a16:creationId xmlns:a16="http://schemas.microsoft.com/office/drawing/2014/main" id="{8AC6A24B-CA1C-314F-BE70-8CAFE12078C4}"/>
                  </a:ext>
                </a:extLst>
              </p:cNvPr>
              <p:cNvSpPr/>
              <p:nvPr/>
            </p:nvSpPr>
            <p:spPr>
              <a:xfrm>
                <a:off x="7437119" y="1933647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rgbClr val="D883FF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29B62154-3678-8B4E-98FE-E830216D0E47}"/>
                  </a:ext>
                </a:extLst>
              </p:cNvPr>
              <p:cNvSpPr txBox="1"/>
              <p:nvPr/>
            </p:nvSpPr>
            <p:spPr>
              <a:xfrm>
                <a:off x="7528559" y="1671362"/>
                <a:ext cx="127470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LA-E*01:01 (n=10)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943026D3-F29D-6448-891D-393BDD76F479}"/>
                  </a:ext>
                </a:extLst>
              </p:cNvPr>
              <p:cNvSpPr txBox="1"/>
              <p:nvPr/>
            </p:nvSpPr>
            <p:spPr>
              <a:xfrm>
                <a:off x="7528559" y="1852409"/>
                <a:ext cx="120577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LA-E*01:03 (n=6)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18982702-4FCB-C341-93BC-34895CE64F40}"/>
                  </a:ext>
                </a:extLst>
              </p:cNvPr>
              <p:cNvSpPr txBox="1"/>
              <p:nvPr/>
            </p:nvSpPr>
            <p:spPr>
              <a:xfrm>
                <a:off x="7528559" y="2029910"/>
                <a:ext cx="132279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eterozygous (n=12)</a:t>
                </a:r>
              </a:p>
            </p:txBody>
          </p: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E7E06493-6B81-BA47-9993-21067E888C3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355021" y="2225593"/>
              <a:ext cx="107572" cy="100584"/>
              <a:chOff x="6717066" y="5643716"/>
              <a:chExt cx="743963" cy="685800"/>
            </a:xfrm>
          </p:grpSpPr>
          <p:sp>
            <p:nvSpPr>
              <p:cNvPr id="65" name="Chord 64">
                <a:extLst>
                  <a:ext uri="{FF2B5EF4-FFF2-40B4-BE49-F238E27FC236}">
                    <a16:creationId xmlns:a16="http://schemas.microsoft.com/office/drawing/2014/main" id="{7354C12D-BE94-FF4F-A881-53DE8AD65805}"/>
                  </a:ext>
                </a:extLst>
              </p:cNvPr>
              <p:cNvSpPr/>
              <p:nvPr/>
            </p:nvSpPr>
            <p:spPr>
              <a:xfrm>
                <a:off x="6717066" y="5643716"/>
                <a:ext cx="685800" cy="685800"/>
              </a:xfrm>
              <a:prstGeom prst="chord">
                <a:avLst>
                  <a:gd name="adj1" fmla="val 5438129"/>
                  <a:gd name="adj2" fmla="val 16148966"/>
                </a:avLst>
              </a:prstGeom>
              <a:solidFill>
                <a:srgbClr val="D883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Chord 65">
                <a:extLst>
                  <a:ext uri="{FF2B5EF4-FFF2-40B4-BE49-F238E27FC236}">
                    <a16:creationId xmlns:a16="http://schemas.microsoft.com/office/drawing/2014/main" id="{3F207CA8-4854-3B4D-A600-45BC934A2012}"/>
                  </a:ext>
                </a:extLst>
              </p:cNvPr>
              <p:cNvSpPr/>
              <p:nvPr/>
            </p:nvSpPr>
            <p:spPr>
              <a:xfrm rot="10800000">
                <a:off x="6775231" y="5643716"/>
                <a:ext cx="685798" cy="685800"/>
              </a:xfrm>
              <a:prstGeom prst="chord">
                <a:avLst>
                  <a:gd name="adj1" fmla="val 5438129"/>
                  <a:gd name="adj2" fmla="val 16148966"/>
                </a:avLst>
              </a:prstGeom>
              <a:solidFill>
                <a:srgbClr val="00919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75" name="TextBox 74">
            <a:extLst>
              <a:ext uri="{FF2B5EF4-FFF2-40B4-BE49-F238E27FC236}">
                <a16:creationId xmlns:a16="http://schemas.microsoft.com/office/drawing/2014/main" id="{73318241-0D04-7540-A19E-837769D81BEB}"/>
              </a:ext>
            </a:extLst>
          </p:cNvPr>
          <p:cNvSpPr txBox="1"/>
          <p:nvPr/>
        </p:nvSpPr>
        <p:spPr>
          <a:xfrm rot="16200000">
            <a:off x="5289812" y="1618571"/>
            <a:ext cx="28561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3A82AC1D-1B14-DC46-BFF6-1415E7377299}"/>
              </a:ext>
            </a:extLst>
          </p:cNvPr>
          <p:cNvSpPr/>
          <p:nvPr/>
        </p:nvSpPr>
        <p:spPr>
          <a:xfrm>
            <a:off x="6413947" y="4906058"/>
            <a:ext cx="5582028" cy="18004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Supplemental Fig 3. CD8+ T Effector Memory Response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Scatter plots showing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+D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the increases over baseline percentages of CD8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producing MIP1β, CD107a, TNFα, IL-2, IL-17A, IFN𝛾, and Granzyme B (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;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B+E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CD8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observed mono-, bi-, tri-, and &gt;3-functional populations, and;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C+F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CD8+CD69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selected multifunctional responses  following co-culture with HLA-E restricte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. Typhi infected antigen presenting targets. These MF populations were selected based on those shown in a previous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S.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Typhi challenge study to be associated with protection from developing disease (10,11). Bars represent medians with whiskers indicating interquartile ranges. Data divided among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(A-C)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(D-F)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HLA-E*01:01 (n=10), HLA-E*01:03 (n=6), and HLA-E heterozygous (n=12)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participants. Scatter plot statistics were analyzed by unpaired t-test. (* p&lt;0.05; ** p&lt;0.01) </a:t>
            </a:r>
            <a:endParaRPr lang="en-US" sz="1000" b="1" dirty="0">
              <a:solidFill>
                <a:srgbClr val="C00000"/>
              </a:solidFill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EAE3248-51E3-E448-9058-9734AA0DD1CC}"/>
              </a:ext>
            </a:extLst>
          </p:cNvPr>
          <p:cNvSpPr txBox="1"/>
          <p:nvPr/>
        </p:nvSpPr>
        <p:spPr>
          <a:xfrm>
            <a:off x="-10489" y="-5126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b="1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32317386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43D6AF5-BBDA-0642-8BE6-2B7D96C323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80893" y="466218"/>
            <a:ext cx="4893573" cy="277834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472112C2-A5A6-6440-A4F4-310CFDB2BA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2850" y="458647"/>
            <a:ext cx="5329275" cy="277977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47652E9-CDA4-2640-A9C4-52A65322C78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86822" y="3886782"/>
            <a:ext cx="4218859" cy="2697829"/>
          </a:xfrm>
          <a:prstGeom prst="rect">
            <a:avLst/>
          </a:prstGeom>
        </p:spPr>
      </p:pic>
      <p:sp>
        <p:nvSpPr>
          <p:cNvPr id="59" name="TextBox 58"/>
          <p:cNvSpPr txBox="1"/>
          <p:nvPr/>
        </p:nvSpPr>
        <p:spPr>
          <a:xfrm rot="16200000">
            <a:off x="-933232" y="1823618"/>
            <a:ext cx="28845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70488" y="355361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6049605" y="349292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1992663" y="330460"/>
            <a:ext cx="262373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RA</a:t>
            </a:r>
            <a:r>
              <a:rPr lang="en-US" dirty="0"/>
              <a:t> cells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1589480" y="3659112"/>
            <a:ext cx="293615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RA</a:t>
            </a:r>
            <a:r>
              <a:rPr lang="en-US" dirty="0"/>
              <a:t> cells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8C04DFA8-2E0A-7042-9129-F803334D522B}"/>
              </a:ext>
            </a:extLst>
          </p:cNvPr>
          <p:cNvCxnSpPr>
            <a:cxnSpLocks/>
          </p:cNvCxnSpPr>
          <p:nvPr/>
        </p:nvCxnSpPr>
        <p:spPr>
          <a:xfrm>
            <a:off x="2267792" y="5348577"/>
            <a:ext cx="27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2E914FF4-8CDE-1541-AC30-4A5A80D91123}"/>
              </a:ext>
            </a:extLst>
          </p:cNvPr>
          <p:cNvCxnSpPr>
            <a:cxnSpLocks/>
          </p:cNvCxnSpPr>
          <p:nvPr/>
        </p:nvCxnSpPr>
        <p:spPr>
          <a:xfrm>
            <a:off x="1246092" y="4385973"/>
            <a:ext cx="274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49360AE-DA05-4C4E-AB29-7956A7552B77}"/>
              </a:ext>
            </a:extLst>
          </p:cNvPr>
          <p:cNvCxnSpPr>
            <a:cxnSpLocks/>
          </p:cNvCxnSpPr>
          <p:nvPr/>
        </p:nvCxnSpPr>
        <p:spPr>
          <a:xfrm>
            <a:off x="1246092" y="4172565"/>
            <a:ext cx="52933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A199E346-0B4E-B24F-9CE2-F4F721B00088}"/>
              </a:ext>
            </a:extLst>
          </p:cNvPr>
          <p:cNvSpPr txBox="1"/>
          <p:nvPr/>
        </p:nvSpPr>
        <p:spPr>
          <a:xfrm>
            <a:off x="2182519" y="5133926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EA0F91F-66EE-A449-90D1-9F970A7FED59}"/>
              </a:ext>
            </a:extLst>
          </p:cNvPr>
          <p:cNvSpPr txBox="1"/>
          <p:nvPr/>
        </p:nvSpPr>
        <p:spPr>
          <a:xfrm>
            <a:off x="1288488" y="3951103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A825192-2B5B-B943-B60B-3CFD062A9813}"/>
              </a:ext>
            </a:extLst>
          </p:cNvPr>
          <p:cNvSpPr txBox="1"/>
          <p:nvPr/>
        </p:nvSpPr>
        <p:spPr>
          <a:xfrm>
            <a:off x="96857" y="3526860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graphicFrame>
        <p:nvGraphicFramePr>
          <p:cNvPr id="58" name="Table 57">
            <a:extLst>
              <a:ext uri="{FF2B5EF4-FFF2-40B4-BE49-F238E27FC236}">
                <a16:creationId xmlns:a16="http://schemas.microsoft.com/office/drawing/2014/main" id="{2546B82A-EC13-964F-90CC-76C51D2D7D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3172545"/>
              </p:ext>
            </p:extLst>
          </p:nvPr>
        </p:nvGraphicFramePr>
        <p:xfrm>
          <a:off x="6467450" y="3284162"/>
          <a:ext cx="5276243" cy="1524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3749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NFα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IP-1β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D107a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FN𝛾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L-2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</a:tbl>
          </a:graphicData>
        </a:graphic>
      </p:graphicFrame>
      <p:sp>
        <p:nvSpPr>
          <p:cNvPr id="60" name="TextBox 59">
            <a:extLst>
              <a:ext uri="{FF2B5EF4-FFF2-40B4-BE49-F238E27FC236}">
                <a16:creationId xmlns:a16="http://schemas.microsoft.com/office/drawing/2014/main" id="{F06E9D2E-1C48-0940-B216-652F5E8F3D0F}"/>
              </a:ext>
            </a:extLst>
          </p:cNvPr>
          <p:cNvSpPr txBox="1"/>
          <p:nvPr/>
        </p:nvSpPr>
        <p:spPr>
          <a:xfrm>
            <a:off x="910144" y="6552239"/>
            <a:ext cx="998422" cy="3156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 Function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120EEBC-F8E2-464C-A52B-CB74C8FE539D}"/>
              </a:ext>
            </a:extLst>
          </p:cNvPr>
          <p:cNvSpPr txBox="1"/>
          <p:nvPr/>
        </p:nvSpPr>
        <p:spPr>
          <a:xfrm>
            <a:off x="1811689" y="6552238"/>
            <a:ext cx="1198349" cy="3156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 Functions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F825D78-9360-BB4C-AF15-17C27C8A50CF}"/>
              </a:ext>
            </a:extLst>
          </p:cNvPr>
          <p:cNvSpPr txBox="1"/>
          <p:nvPr/>
        </p:nvSpPr>
        <p:spPr>
          <a:xfrm>
            <a:off x="2834483" y="6552238"/>
            <a:ext cx="1138773" cy="3156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3 Functions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96853D2-F039-C34E-9CA7-A8B3DC85B332}"/>
              </a:ext>
            </a:extLst>
          </p:cNvPr>
          <p:cNvSpPr txBox="1"/>
          <p:nvPr/>
        </p:nvSpPr>
        <p:spPr>
          <a:xfrm>
            <a:off x="3759804" y="6552237"/>
            <a:ext cx="1258011" cy="3156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&gt;3 Functions 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DA77958-C421-D94F-BE33-4C0814BB3001}"/>
              </a:ext>
            </a:extLst>
          </p:cNvPr>
          <p:cNvSpPr txBox="1"/>
          <p:nvPr/>
        </p:nvSpPr>
        <p:spPr>
          <a:xfrm rot="16200000">
            <a:off x="-838621" y="5161999"/>
            <a:ext cx="28889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5399E80-51DF-8442-A0AC-B111FE8CB687}"/>
              </a:ext>
            </a:extLst>
          </p:cNvPr>
          <p:cNvSpPr txBox="1"/>
          <p:nvPr/>
        </p:nvSpPr>
        <p:spPr>
          <a:xfrm>
            <a:off x="973042" y="3225919"/>
            <a:ext cx="768117" cy="3156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IP-1β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C4AFECC-758A-5244-BDB8-AE52D6623001}"/>
              </a:ext>
            </a:extLst>
          </p:cNvPr>
          <p:cNvSpPr txBox="1"/>
          <p:nvPr/>
        </p:nvSpPr>
        <p:spPr>
          <a:xfrm>
            <a:off x="1694551" y="3230792"/>
            <a:ext cx="768117" cy="3156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107a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5023E98-BDDA-EE44-9A7F-1B51B2C8C34D}"/>
              </a:ext>
            </a:extLst>
          </p:cNvPr>
          <p:cNvSpPr txBox="1"/>
          <p:nvPr/>
        </p:nvSpPr>
        <p:spPr>
          <a:xfrm>
            <a:off x="2422726" y="3240859"/>
            <a:ext cx="768117" cy="3156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NFα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76DB246-9765-2F42-B6D6-824A9C1F9C79}"/>
              </a:ext>
            </a:extLst>
          </p:cNvPr>
          <p:cNvSpPr txBox="1"/>
          <p:nvPr/>
        </p:nvSpPr>
        <p:spPr>
          <a:xfrm>
            <a:off x="3148098" y="3230792"/>
            <a:ext cx="768117" cy="3156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L-2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3542868-22FD-E742-BABA-26BF0B154CB9}"/>
              </a:ext>
            </a:extLst>
          </p:cNvPr>
          <p:cNvSpPr txBox="1"/>
          <p:nvPr/>
        </p:nvSpPr>
        <p:spPr>
          <a:xfrm>
            <a:off x="3885971" y="3225919"/>
            <a:ext cx="768117" cy="3156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L-17A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8DC91FC5-6DC8-1B42-819E-90CC198E407E}"/>
              </a:ext>
            </a:extLst>
          </p:cNvPr>
          <p:cNvSpPr txBox="1"/>
          <p:nvPr/>
        </p:nvSpPr>
        <p:spPr>
          <a:xfrm>
            <a:off x="4580149" y="3221046"/>
            <a:ext cx="768117" cy="3156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FN𝛾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2330139-3E19-BA42-AB13-12ABB93CE72D}"/>
              </a:ext>
            </a:extLst>
          </p:cNvPr>
          <p:cNvSpPr txBox="1"/>
          <p:nvPr/>
        </p:nvSpPr>
        <p:spPr>
          <a:xfrm>
            <a:off x="5403338" y="3225919"/>
            <a:ext cx="768117" cy="3156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/>
              <a:t>GzmB</a:t>
            </a:r>
            <a:endParaRPr lang="en-US" sz="12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EEAC71A-4B9E-4944-861B-359E7C025C60}"/>
              </a:ext>
            </a:extLst>
          </p:cNvPr>
          <p:cNvSpPr txBox="1"/>
          <p:nvPr/>
        </p:nvSpPr>
        <p:spPr>
          <a:xfrm>
            <a:off x="9488556" y="1255396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*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C421D613-5F77-824A-8DCB-A460A702D287}"/>
              </a:ext>
            </a:extLst>
          </p:cNvPr>
          <p:cNvCxnSpPr>
            <a:cxnSpLocks/>
          </p:cNvCxnSpPr>
          <p:nvPr/>
        </p:nvCxnSpPr>
        <p:spPr>
          <a:xfrm>
            <a:off x="9501808" y="1494419"/>
            <a:ext cx="4225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50758C31-450A-504D-B036-8AD2C4BD6FD1}"/>
              </a:ext>
            </a:extLst>
          </p:cNvPr>
          <p:cNvCxnSpPr>
            <a:cxnSpLocks/>
          </p:cNvCxnSpPr>
          <p:nvPr/>
        </p:nvCxnSpPr>
        <p:spPr>
          <a:xfrm>
            <a:off x="10457469" y="2025444"/>
            <a:ext cx="248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D15F9573-23F5-B34D-9523-0027593BF194}"/>
              </a:ext>
            </a:extLst>
          </p:cNvPr>
          <p:cNvCxnSpPr>
            <a:cxnSpLocks/>
          </p:cNvCxnSpPr>
          <p:nvPr/>
        </p:nvCxnSpPr>
        <p:spPr>
          <a:xfrm>
            <a:off x="9675591" y="1984112"/>
            <a:ext cx="248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8FB15291-AB9E-0D4C-9E2A-1A77D421BCB5}"/>
              </a:ext>
            </a:extLst>
          </p:cNvPr>
          <p:cNvSpPr txBox="1"/>
          <p:nvPr/>
        </p:nvSpPr>
        <p:spPr>
          <a:xfrm>
            <a:off x="10368548" y="1792892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3E66806-318F-3949-941D-31791D92A70E}"/>
              </a:ext>
            </a:extLst>
          </p:cNvPr>
          <p:cNvSpPr txBox="1"/>
          <p:nvPr/>
        </p:nvSpPr>
        <p:spPr>
          <a:xfrm>
            <a:off x="9577678" y="1733615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4169B24A-4B67-2843-B235-B8465611DB2F}"/>
              </a:ext>
            </a:extLst>
          </p:cNvPr>
          <p:cNvCxnSpPr>
            <a:cxnSpLocks/>
          </p:cNvCxnSpPr>
          <p:nvPr/>
        </p:nvCxnSpPr>
        <p:spPr>
          <a:xfrm>
            <a:off x="3066483" y="5883216"/>
            <a:ext cx="248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2385C683-C2CA-0E48-B903-0593DA9FF5EA}"/>
              </a:ext>
            </a:extLst>
          </p:cNvPr>
          <p:cNvSpPr txBox="1"/>
          <p:nvPr/>
        </p:nvSpPr>
        <p:spPr>
          <a:xfrm>
            <a:off x="2844232" y="5679411"/>
            <a:ext cx="69322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p = 0.05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BCBB55BB-6D0C-FA4C-8488-B94971ABD83D}"/>
              </a:ext>
            </a:extLst>
          </p:cNvPr>
          <p:cNvSpPr txBox="1"/>
          <p:nvPr/>
        </p:nvSpPr>
        <p:spPr>
          <a:xfrm>
            <a:off x="7942704" y="349292"/>
            <a:ext cx="285771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RA</a:t>
            </a:r>
            <a:r>
              <a:rPr lang="en-US" dirty="0"/>
              <a:t> cells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F5E39B9B-76D1-D84B-A98A-5115E39AAB0F}"/>
              </a:ext>
            </a:extLst>
          </p:cNvPr>
          <p:cNvSpPr txBox="1"/>
          <p:nvPr/>
        </p:nvSpPr>
        <p:spPr>
          <a:xfrm rot="16200000">
            <a:off x="5119621" y="1730698"/>
            <a:ext cx="30704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5FC3947F-4BC6-F348-8A10-945BFC45626C}"/>
              </a:ext>
            </a:extLst>
          </p:cNvPr>
          <p:cNvSpPr/>
          <p:nvPr/>
        </p:nvSpPr>
        <p:spPr>
          <a:xfrm>
            <a:off x="6279550" y="4990664"/>
            <a:ext cx="5705806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Supplemental Fig 4. CD8+ T Effector Memory RA Response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Scatter plots showing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+D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the increases over baseline percentages of CD8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producing MIP1β, CD107a, TNFα, IL-2, IL-17A, IFN𝛾, and Granzyme B (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;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B+E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CD8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observed mono-, bi-, tri-, and &gt;3-functional populations, and;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C+F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CD8+CD69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selected multifunctional responses following co-culture with HLA-E restricte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Typhi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infected antigen presenting targets. These MF populations were selected based on those shown in a previous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S.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Typhi challenge study to be associated with protection from developing disease (10,11). Bars represent medians with whiskers indicating interquartile ranges. Data divided among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(A-C)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(D-F)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HLA-E*01:01 (n=10), HLA-E*01:03 (n=6), and HLA-E heterozygous (n=12)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participants. Scatter plot statistics were analyzed by unpaired t-test. (* p&lt;0.05; ** p&lt;0.01) </a:t>
            </a:r>
            <a:endParaRPr lang="en-US" sz="1000" b="1" dirty="0">
              <a:solidFill>
                <a:srgbClr val="C00000"/>
              </a:solidFill>
            </a:endParaRP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ED4FD59B-937A-C54B-A15C-F44FFD4EB6ED}"/>
              </a:ext>
            </a:extLst>
          </p:cNvPr>
          <p:cNvGrpSpPr/>
          <p:nvPr/>
        </p:nvGrpSpPr>
        <p:grpSpPr>
          <a:xfrm>
            <a:off x="4525634" y="4123362"/>
            <a:ext cx="1875744" cy="794966"/>
            <a:chOff x="10279866" y="1001743"/>
            <a:chExt cx="1793913" cy="794966"/>
          </a:xfrm>
        </p:grpSpPr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854B06CB-028B-F349-830B-461E82405B71}"/>
                </a:ext>
              </a:extLst>
            </p:cNvPr>
            <p:cNvGrpSpPr/>
            <p:nvPr/>
          </p:nvGrpSpPr>
          <p:grpSpPr>
            <a:xfrm>
              <a:off x="10279866" y="1001743"/>
              <a:ext cx="1793913" cy="794966"/>
              <a:chOff x="10072002" y="392204"/>
              <a:chExt cx="1673319" cy="794966"/>
            </a:xfrm>
          </p:grpSpPr>
          <p:sp>
            <p:nvSpPr>
              <p:cNvPr id="73" name="Oval 72">
                <a:extLst>
                  <a:ext uri="{FF2B5EF4-FFF2-40B4-BE49-F238E27FC236}">
                    <a16:creationId xmlns:a16="http://schemas.microsoft.com/office/drawing/2014/main" id="{C1CE41C6-6C97-A249-AF3C-CD1A2FA101F6}"/>
                  </a:ext>
                </a:extLst>
              </p:cNvPr>
              <p:cNvSpPr/>
              <p:nvPr/>
            </p:nvSpPr>
            <p:spPr>
              <a:xfrm>
                <a:off x="10072002" y="487297"/>
                <a:ext cx="81572" cy="91440"/>
              </a:xfrm>
              <a:prstGeom prst="ellipse">
                <a:avLst/>
              </a:prstGeom>
              <a:solidFill>
                <a:srgbClr val="76D6FF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4" name="Oval 73">
                <a:extLst>
                  <a:ext uri="{FF2B5EF4-FFF2-40B4-BE49-F238E27FC236}">
                    <a16:creationId xmlns:a16="http://schemas.microsoft.com/office/drawing/2014/main" id="{712A13A8-3EAB-1546-9E4B-6B8648ADA603}"/>
                  </a:ext>
                </a:extLst>
              </p:cNvPr>
              <p:cNvSpPr/>
              <p:nvPr/>
            </p:nvSpPr>
            <p:spPr>
              <a:xfrm>
                <a:off x="10072002" y="656264"/>
                <a:ext cx="81572" cy="91440"/>
              </a:xfrm>
              <a:prstGeom prst="ellipse">
                <a:avLst/>
              </a:prstGeom>
              <a:solidFill>
                <a:srgbClr val="FF7E79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91A4DE76-8BDB-4742-9937-5036AB68FCBA}"/>
                  </a:ext>
                </a:extLst>
              </p:cNvPr>
              <p:cNvSpPr txBox="1"/>
              <p:nvPr/>
            </p:nvSpPr>
            <p:spPr>
              <a:xfrm>
                <a:off x="10163442" y="574706"/>
                <a:ext cx="158187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ed Female (n=8; 11-17 </a:t>
                </a:r>
                <a:r>
                  <a:rPr lang="en-US" sz="1050" dirty="0" err="1"/>
                  <a:t>yrs</a:t>
                </a:r>
                <a:r>
                  <a:rPr lang="en-US" sz="1050" dirty="0"/>
                  <a:t>)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81E4E689-3211-514C-9251-869FECF7E09B}"/>
                  </a:ext>
                </a:extLst>
              </p:cNvPr>
              <p:cNvSpPr txBox="1"/>
              <p:nvPr/>
            </p:nvSpPr>
            <p:spPr>
              <a:xfrm>
                <a:off x="10163442" y="392204"/>
                <a:ext cx="147319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Ped Male (n=10; 6-17 </a:t>
                </a:r>
                <a:r>
                  <a:rPr lang="en-US" sz="1050" dirty="0" err="1"/>
                  <a:t>yrs</a:t>
                </a:r>
                <a:r>
                  <a:rPr lang="en-US" sz="1050" dirty="0"/>
                  <a:t>)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AEE4CD12-CAE0-6E4F-9623-32E40B2F49FF}"/>
                  </a:ext>
                </a:extLst>
              </p:cNvPr>
              <p:cNvSpPr txBox="1"/>
              <p:nvPr/>
            </p:nvSpPr>
            <p:spPr>
              <a:xfrm>
                <a:off x="10163442" y="933254"/>
                <a:ext cx="109424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Adult Female (n=6)</a:t>
                </a:r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210D5700-F488-BF40-85AC-7EFCBF18A0B3}"/>
                  </a:ext>
                </a:extLst>
              </p:cNvPr>
              <p:cNvSpPr txBox="1"/>
              <p:nvPr/>
            </p:nvSpPr>
            <p:spPr>
              <a:xfrm>
                <a:off x="10163442" y="745241"/>
                <a:ext cx="98556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Adult Male (n=7)</a:t>
                </a:r>
              </a:p>
            </p:txBody>
          </p:sp>
        </p:grp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8FEC40BA-57DE-4F4D-95D2-24E1D48EB465}"/>
                </a:ext>
              </a:extLst>
            </p:cNvPr>
            <p:cNvSpPr/>
            <p:nvPr/>
          </p:nvSpPr>
          <p:spPr>
            <a:xfrm>
              <a:off x="10285381" y="1619243"/>
              <a:ext cx="87451" cy="91440"/>
            </a:xfrm>
            <a:prstGeom prst="rect">
              <a:avLst/>
            </a:prstGeom>
            <a:solidFill>
              <a:srgbClr val="9411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D7D07455-70CF-4743-ADAC-CD5FE5CB8881}"/>
                </a:ext>
              </a:extLst>
            </p:cNvPr>
            <p:cNvSpPr/>
            <p:nvPr/>
          </p:nvSpPr>
          <p:spPr>
            <a:xfrm>
              <a:off x="10285381" y="1448374"/>
              <a:ext cx="88700" cy="90757"/>
            </a:xfrm>
            <a:prstGeom prst="rect">
              <a:avLst/>
            </a:prstGeom>
            <a:solidFill>
              <a:srgbClr val="011893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8" name="TextBox 87">
            <a:extLst>
              <a:ext uri="{FF2B5EF4-FFF2-40B4-BE49-F238E27FC236}">
                <a16:creationId xmlns:a16="http://schemas.microsoft.com/office/drawing/2014/main" id="{92A200BE-849C-1B4B-AF5E-1F86C31959E5}"/>
              </a:ext>
            </a:extLst>
          </p:cNvPr>
          <p:cNvSpPr txBox="1"/>
          <p:nvPr/>
        </p:nvSpPr>
        <p:spPr>
          <a:xfrm>
            <a:off x="1012914" y="4187269"/>
            <a:ext cx="69322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p = 0.05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CB7DCD8-CA8E-304F-806A-DD1F2EE11312}"/>
              </a:ext>
            </a:extLst>
          </p:cNvPr>
          <p:cNvSpPr txBox="1"/>
          <p:nvPr/>
        </p:nvSpPr>
        <p:spPr>
          <a:xfrm>
            <a:off x="-10489" y="-5126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b="1" dirty="0"/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42077853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4FDA05B-1475-8B49-82E0-794AD036B2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93286" y="496693"/>
            <a:ext cx="4865808" cy="276257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CDADE4E-65C3-254A-A7C7-09B3A9763D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8487" y="456950"/>
            <a:ext cx="5303520" cy="276208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6294DFF-08F6-3E43-BFCD-2402E22E3AB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3366" y="3723711"/>
            <a:ext cx="4110936" cy="2779776"/>
          </a:xfrm>
          <a:prstGeom prst="rect">
            <a:avLst/>
          </a:prstGeom>
        </p:spPr>
      </p:pic>
      <p:sp>
        <p:nvSpPr>
          <p:cNvPr id="70" name="TextBox 69"/>
          <p:cNvSpPr txBox="1"/>
          <p:nvPr/>
        </p:nvSpPr>
        <p:spPr>
          <a:xfrm>
            <a:off x="1019121" y="3239972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MIP-1β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1759884" y="3239972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CD107a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2453974" y="3239356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NFα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3168046" y="3239356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L-2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3910412" y="3244084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L-17A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4610548" y="3239356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IFN𝛾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5327804" y="3239355"/>
            <a:ext cx="685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/>
              <a:t>GzmB</a:t>
            </a:r>
            <a:endParaRPr lang="en-US" sz="1200" dirty="0"/>
          </a:p>
        </p:txBody>
      </p:sp>
      <p:sp>
        <p:nvSpPr>
          <p:cNvPr id="77" name="TextBox 76"/>
          <p:cNvSpPr txBox="1"/>
          <p:nvPr/>
        </p:nvSpPr>
        <p:spPr>
          <a:xfrm>
            <a:off x="1079896" y="6506088"/>
            <a:ext cx="837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1 Function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1967107" y="6506089"/>
            <a:ext cx="10048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2 Functions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2969334" y="6506088"/>
            <a:ext cx="9548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/>
              <a:t>3 Functions</a:t>
            </a:r>
            <a:endParaRPr lang="en-US" sz="1200" dirty="0"/>
          </a:p>
        </p:txBody>
      </p:sp>
      <p:sp>
        <p:nvSpPr>
          <p:cNvPr id="80" name="TextBox 79"/>
          <p:cNvSpPr txBox="1"/>
          <p:nvPr/>
        </p:nvSpPr>
        <p:spPr>
          <a:xfrm>
            <a:off x="3921606" y="6506088"/>
            <a:ext cx="10548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&gt;3 Functions </a:t>
            </a:r>
          </a:p>
        </p:txBody>
      </p:sp>
      <p:sp>
        <p:nvSpPr>
          <p:cNvPr id="81" name="TextBox 80"/>
          <p:cNvSpPr txBox="1"/>
          <p:nvPr/>
        </p:nvSpPr>
        <p:spPr>
          <a:xfrm rot="16200000">
            <a:off x="-1008125" y="1769134"/>
            <a:ext cx="315588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127" name="TextBox 126"/>
          <p:cNvSpPr txBox="1"/>
          <p:nvPr/>
        </p:nvSpPr>
        <p:spPr>
          <a:xfrm>
            <a:off x="12662" y="364771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D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6013604" y="360467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F</a:t>
            </a:r>
          </a:p>
        </p:txBody>
      </p:sp>
      <p:sp>
        <p:nvSpPr>
          <p:cNvPr id="129" name="TextBox 128"/>
          <p:cNvSpPr txBox="1"/>
          <p:nvPr/>
        </p:nvSpPr>
        <p:spPr>
          <a:xfrm>
            <a:off x="1759884" y="360467"/>
            <a:ext cx="304970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RA</a:t>
            </a:r>
            <a:r>
              <a:rPr lang="en-US" dirty="0"/>
              <a:t> cells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1645751" y="3628417"/>
            <a:ext cx="295046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RA</a:t>
            </a:r>
            <a:r>
              <a:rPr lang="en-US" dirty="0"/>
              <a:t> cells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3CE5862F-F4B8-B445-B0E2-0F7E5D4CA32A}"/>
              </a:ext>
            </a:extLst>
          </p:cNvPr>
          <p:cNvCxnSpPr>
            <a:cxnSpLocks/>
          </p:cNvCxnSpPr>
          <p:nvPr/>
        </p:nvCxnSpPr>
        <p:spPr>
          <a:xfrm>
            <a:off x="1123882" y="4057996"/>
            <a:ext cx="57624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38B87149-056F-744A-BC25-2069DFA4E9E7}"/>
              </a:ext>
            </a:extLst>
          </p:cNvPr>
          <p:cNvSpPr txBox="1"/>
          <p:nvPr/>
        </p:nvSpPr>
        <p:spPr>
          <a:xfrm>
            <a:off x="1190541" y="3830838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*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62D24BA5-89C1-6542-9267-86E8E963CA2E}"/>
              </a:ext>
            </a:extLst>
          </p:cNvPr>
          <p:cNvCxnSpPr>
            <a:cxnSpLocks/>
          </p:cNvCxnSpPr>
          <p:nvPr/>
        </p:nvCxnSpPr>
        <p:spPr>
          <a:xfrm>
            <a:off x="5639832" y="1732271"/>
            <a:ext cx="22393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9C8ADFAC-E0CB-6B4E-8609-EECD92FFC04E}"/>
              </a:ext>
            </a:extLst>
          </p:cNvPr>
          <p:cNvCxnSpPr>
            <a:cxnSpLocks/>
          </p:cNvCxnSpPr>
          <p:nvPr/>
        </p:nvCxnSpPr>
        <p:spPr>
          <a:xfrm>
            <a:off x="1444906" y="4246066"/>
            <a:ext cx="26455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7DDB6350-33AA-2C41-83B2-692EB069568D}"/>
              </a:ext>
            </a:extLst>
          </p:cNvPr>
          <p:cNvSpPr txBox="1"/>
          <p:nvPr/>
        </p:nvSpPr>
        <p:spPr>
          <a:xfrm>
            <a:off x="1355176" y="4031459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*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32B0ABF-93AD-5443-83C1-17689555F553}"/>
              </a:ext>
            </a:extLst>
          </p:cNvPr>
          <p:cNvSpPr txBox="1"/>
          <p:nvPr/>
        </p:nvSpPr>
        <p:spPr>
          <a:xfrm>
            <a:off x="12661" y="3621311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E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599997B-29CD-6346-8400-41075D720BDB}"/>
              </a:ext>
            </a:extLst>
          </p:cNvPr>
          <p:cNvSpPr txBox="1"/>
          <p:nvPr/>
        </p:nvSpPr>
        <p:spPr>
          <a:xfrm rot="16200000">
            <a:off x="-952310" y="4976784"/>
            <a:ext cx="32594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graphicFrame>
        <p:nvGraphicFramePr>
          <p:cNvPr id="59" name="Table 58">
            <a:extLst>
              <a:ext uri="{FF2B5EF4-FFF2-40B4-BE49-F238E27FC236}">
                <a16:creationId xmlns:a16="http://schemas.microsoft.com/office/drawing/2014/main" id="{C81FC4DF-D701-184E-9A09-15E0BE9E38F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2538528"/>
              </p:ext>
            </p:extLst>
          </p:nvPr>
        </p:nvGraphicFramePr>
        <p:xfrm>
          <a:off x="6467450" y="3284162"/>
          <a:ext cx="5276243" cy="15240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3749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NFα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IP-1β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D107a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FN𝛾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L-2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</a:tbl>
          </a:graphicData>
        </a:graphic>
      </p:graphicFrame>
      <p:sp>
        <p:nvSpPr>
          <p:cNvPr id="43" name="TextBox 42">
            <a:extLst>
              <a:ext uri="{FF2B5EF4-FFF2-40B4-BE49-F238E27FC236}">
                <a16:creationId xmlns:a16="http://schemas.microsoft.com/office/drawing/2014/main" id="{EF679629-DFAE-8A44-82E8-8AA4E39A4E67}"/>
              </a:ext>
            </a:extLst>
          </p:cNvPr>
          <p:cNvSpPr txBox="1"/>
          <p:nvPr/>
        </p:nvSpPr>
        <p:spPr>
          <a:xfrm>
            <a:off x="7849029" y="364771"/>
            <a:ext cx="299569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RA</a:t>
            </a:r>
            <a:r>
              <a:rPr lang="en-US" dirty="0"/>
              <a:t> cells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140CBAA-9EF2-BF4B-BAFF-6A7FD65B63C7}"/>
              </a:ext>
            </a:extLst>
          </p:cNvPr>
          <p:cNvSpPr txBox="1"/>
          <p:nvPr/>
        </p:nvSpPr>
        <p:spPr>
          <a:xfrm rot="16200000">
            <a:off x="5202456" y="1557627"/>
            <a:ext cx="29842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860D7504-2091-E34D-8D0E-A5DAD46AB481}"/>
              </a:ext>
            </a:extLst>
          </p:cNvPr>
          <p:cNvCxnSpPr>
            <a:cxnSpLocks/>
          </p:cNvCxnSpPr>
          <p:nvPr/>
        </p:nvCxnSpPr>
        <p:spPr>
          <a:xfrm>
            <a:off x="11329293" y="2472705"/>
            <a:ext cx="248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9F65DBF7-6C1D-DA4E-B63C-56EB5BED62A5}"/>
              </a:ext>
            </a:extLst>
          </p:cNvPr>
          <p:cNvSpPr txBox="1"/>
          <p:nvPr/>
        </p:nvSpPr>
        <p:spPr>
          <a:xfrm>
            <a:off x="11240372" y="2240153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B66525D6-D79A-EF48-80D3-49C695BCD9F7}"/>
              </a:ext>
            </a:extLst>
          </p:cNvPr>
          <p:cNvGrpSpPr/>
          <p:nvPr/>
        </p:nvGrpSpPr>
        <p:grpSpPr>
          <a:xfrm>
            <a:off x="4738238" y="4094559"/>
            <a:ext cx="1421348" cy="612464"/>
            <a:chOff x="7355021" y="1783844"/>
            <a:chExt cx="1421348" cy="612464"/>
          </a:xfrm>
        </p:grpSpPr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39CB84FF-B2FB-F846-A3BE-D4686FACFEF8}"/>
                </a:ext>
              </a:extLst>
            </p:cNvPr>
            <p:cNvGrpSpPr/>
            <p:nvPr/>
          </p:nvGrpSpPr>
          <p:grpSpPr>
            <a:xfrm>
              <a:off x="7362131" y="1783844"/>
              <a:ext cx="1414238" cy="612464"/>
              <a:chOff x="7437119" y="1671362"/>
              <a:chExt cx="1414238" cy="612464"/>
            </a:xfrm>
          </p:grpSpPr>
          <p:sp>
            <p:nvSpPr>
              <p:cNvPr id="85" name="Oval 84">
                <a:extLst>
                  <a:ext uri="{FF2B5EF4-FFF2-40B4-BE49-F238E27FC236}">
                    <a16:creationId xmlns:a16="http://schemas.microsoft.com/office/drawing/2014/main" id="{740D5F60-07C7-4A4D-A90C-FE2697007DF1}"/>
                  </a:ext>
                </a:extLst>
              </p:cNvPr>
              <p:cNvSpPr/>
              <p:nvPr/>
            </p:nvSpPr>
            <p:spPr>
              <a:xfrm>
                <a:off x="7437119" y="1752600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rgbClr val="009193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6" name="Oval 85">
                <a:extLst>
                  <a:ext uri="{FF2B5EF4-FFF2-40B4-BE49-F238E27FC236}">
                    <a16:creationId xmlns:a16="http://schemas.microsoft.com/office/drawing/2014/main" id="{D30B3E30-7B44-AF4E-BEE6-ABE763196EF5}"/>
                  </a:ext>
                </a:extLst>
              </p:cNvPr>
              <p:cNvSpPr/>
              <p:nvPr/>
            </p:nvSpPr>
            <p:spPr>
              <a:xfrm>
                <a:off x="7437119" y="1933647"/>
                <a:ext cx="91440" cy="91440"/>
              </a:xfrm>
              <a:prstGeom prst="ellipse">
                <a:avLst/>
              </a:prstGeom>
              <a:solidFill>
                <a:schemeClr val="bg1"/>
              </a:solidFill>
              <a:ln w="19050">
                <a:solidFill>
                  <a:srgbClr val="D883FF"/>
                </a:solidFill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CCFC05B2-3CC4-CC4B-8F52-73A5AF4C25B6}"/>
                  </a:ext>
                </a:extLst>
              </p:cNvPr>
              <p:cNvSpPr txBox="1"/>
              <p:nvPr/>
            </p:nvSpPr>
            <p:spPr>
              <a:xfrm>
                <a:off x="7528559" y="1671362"/>
                <a:ext cx="127470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LA-E*01:01 (n=10)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42EF78B1-D452-824E-9598-F8D66541DF46}"/>
                  </a:ext>
                </a:extLst>
              </p:cNvPr>
              <p:cNvSpPr txBox="1"/>
              <p:nvPr/>
            </p:nvSpPr>
            <p:spPr>
              <a:xfrm>
                <a:off x="7528559" y="1852409"/>
                <a:ext cx="120577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LA-E*01:03 (n=6)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191F34E0-834C-5C47-B547-075407E7C72C}"/>
                  </a:ext>
                </a:extLst>
              </p:cNvPr>
              <p:cNvSpPr txBox="1"/>
              <p:nvPr/>
            </p:nvSpPr>
            <p:spPr>
              <a:xfrm>
                <a:off x="7528559" y="2029910"/>
                <a:ext cx="132279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Heterozygous (n=12)</a:t>
                </a:r>
              </a:p>
            </p:txBody>
          </p:sp>
        </p:grp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9C725169-B363-5749-9431-AE1D3FE2303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7355021" y="2225593"/>
              <a:ext cx="107572" cy="100584"/>
              <a:chOff x="6717066" y="5643716"/>
              <a:chExt cx="743963" cy="685800"/>
            </a:xfrm>
          </p:grpSpPr>
          <p:sp>
            <p:nvSpPr>
              <p:cNvPr id="83" name="Chord 82">
                <a:extLst>
                  <a:ext uri="{FF2B5EF4-FFF2-40B4-BE49-F238E27FC236}">
                    <a16:creationId xmlns:a16="http://schemas.microsoft.com/office/drawing/2014/main" id="{7B7705EE-80C2-164D-BF6D-A97A46B89929}"/>
                  </a:ext>
                </a:extLst>
              </p:cNvPr>
              <p:cNvSpPr/>
              <p:nvPr/>
            </p:nvSpPr>
            <p:spPr>
              <a:xfrm>
                <a:off x="6717066" y="5643716"/>
                <a:ext cx="685800" cy="685800"/>
              </a:xfrm>
              <a:prstGeom prst="chord">
                <a:avLst>
                  <a:gd name="adj1" fmla="val 5438129"/>
                  <a:gd name="adj2" fmla="val 16148966"/>
                </a:avLst>
              </a:prstGeom>
              <a:solidFill>
                <a:srgbClr val="D883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4" name="Chord 83">
                <a:extLst>
                  <a:ext uri="{FF2B5EF4-FFF2-40B4-BE49-F238E27FC236}">
                    <a16:creationId xmlns:a16="http://schemas.microsoft.com/office/drawing/2014/main" id="{844EB8F6-0BCD-C54C-8045-AEFF25F591F6}"/>
                  </a:ext>
                </a:extLst>
              </p:cNvPr>
              <p:cNvSpPr/>
              <p:nvPr/>
            </p:nvSpPr>
            <p:spPr>
              <a:xfrm rot="10800000">
                <a:off x="6775231" y="5643716"/>
                <a:ext cx="685798" cy="685800"/>
              </a:xfrm>
              <a:prstGeom prst="chord">
                <a:avLst>
                  <a:gd name="adj1" fmla="val 5438129"/>
                  <a:gd name="adj2" fmla="val 16148966"/>
                </a:avLst>
              </a:prstGeom>
              <a:solidFill>
                <a:srgbClr val="00919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91" name="Rectangle 90">
            <a:extLst>
              <a:ext uri="{FF2B5EF4-FFF2-40B4-BE49-F238E27FC236}">
                <a16:creationId xmlns:a16="http://schemas.microsoft.com/office/drawing/2014/main" id="{64334BA7-BF2F-4844-B2DC-69255A1A11FF}"/>
              </a:ext>
            </a:extLst>
          </p:cNvPr>
          <p:cNvSpPr/>
          <p:nvPr/>
        </p:nvSpPr>
        <p:spPr>
          <a:xfrm>
            <a:off x="6279550" y="4990664"/>
            <a:ext cx="5705806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Supplemental Fig 4. CD8+ T Effector Memory RA Response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Scatter plots showing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+D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the increases over baseline percentages of CD8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producing MIP1β, CD107a, TNFα, IL-2, IL-17A, IFN𝛾, and Granzyme B (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;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B+E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CD8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observed mono-, bi-, tri-, and &gt;3-functional populations, and;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C+F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CD8+CD69+ T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selected multifunctional responses following co-culture with HLA-E restricte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Typhi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infected antigen presenting targets. These MF populations were selected based on those shown in a previous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S.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Typhi challenge study to be associated with protection from developing disease (10,11). Bars represent medians with whiskers indicating interquartile ranges. Data divided among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(A-C)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(D-F)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HLA-E*01:01 (n=10), HLA-E*01:03 (n=6), and HLA-E heterozygous (n=12)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participants. Scatter plot statistics were analyzed by unpaired t-test. (* p&lt;0.05; ** p&lt;0.01) </a:t>
            </a:r>
            <a:endParaRPr lang="en-US" sz="1000" b="1" dirty="0">
              <a:solidFill>
                <a:srgbClr val="C00000"/>
              </a:solidFill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8337D3C-8806-4543-8CD8-3A89B451F51B}"/>
              </a:ext>
            </a:extLst>
          </p:cNvPr>
          <p:cNvSpPr txBox="1"/>
          <p:nvPr/>
        </p:nvSpPr>
        <p:spPr>
          <a:xfrm>
            <a:off x="5529526" y="1508650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AF28054-563E-E146-A7B5-B956D206D423}"/>
              </a:ext>
            </a:extLst>
          </p:cNvPr>
          <p:cNvSpPr txBox="1"/>
          <p:nvPr/>
        </p:nvSpPr>
        <p:spPr>
          <a:xfrm>
            <a:off x="-10489" y="-5126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b="1" dirty="0"/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129294482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BEB3E36-F797-5D49-AC1D-35F6459CB7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5333701"/>
              </p:ext>
            </p:extLst>
          </p:nvPr>
        </p:nvGraphicFramePr>
        <p:xfrm>
          <a:off x="523850" y="3795310"/>
          <a:ext cx="5276243" cy="1828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3749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NFα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IP-1β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D107a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FN𝛾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L-2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/>
                        <a:t>GzmB</a:t>
                      </a:r>
                      <a:endParaRPr lang="en-US" sz="1400" dirty="0"/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62922051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37AC471-715A-E24C-857E-E0CF853D84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42019488"/>
              </p:ext>
            </p:extLst>
          </p:nvPr>
        </p:nvGraphicFramePr>
        <p:xfrm>
          <a:off x="6391250" y="3791060"/>
          <a:ext cx="5276243" cy="18288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53749">
                  <a:extLst>
                    <a:ext uri="{9D8B030D-6E8A-4147-A177-3AD203B41FA5}">
                      <a16:colId xmlns:a16="http://schemas.microsoft.com/office/drawing/2014/main" val="2537606572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55304865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52331593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1453105526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966826955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3225086540"/>
                    </a:ext>
                  </a:extLst>
                </a:gridCol>
                <a:gridCol w="753749">
                  <a:extLst>
                    <a:ext uri="{9D8B030D-6E8A-4147-A177-3AD203B41FA5}">
                      <a16:colId xmlns:a16="http://schemas.microsoft.com/office/drawing/2014/main" val="2606078766"/>
                    </a:ext>
                  </a:extLst>
                </a:gridCol>
              </a:tblGrid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TNFα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22499749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MIP-1β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7338383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CD107a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079076"/>
                  </a:ext>
                </a:extLst>
              </a:tr>
              <a:tr h="296480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FN𝛾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24629835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/>
                        <a:t>IL-2</a:t>
                      </a:r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en-US" sz="1400" b="1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94616210"/>
                  </a:ext>
                </a:extLst>
              </a:tr>
              <a:tr h="292419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 err="1"/>
                        <a:t>GzmB</a:t>
                      </a:r>
                      <a:endParaRPr lang="en-US" sz="1400" dirty="0"/>
                    </a:p>
                  </a:txBody>
                  <a:tcPr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/>
                        <a:t>✓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362922051"/>
                  </a:ext>
                </a:extLst>
              </a:tr>
            </a:tbl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83CB9D02-E451-2D4E-83CF-256EDA20CF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8871" y="1023731"/>
            <a:ext cx="4861100" cy="272757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8AD5D17-46A1-C44C-A045-3EB9B5E023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14889" y="1024694"/>
            <a:ext cx="4872482" cy="276636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1F29571-44F3-294E-B3D5-D37F76A870B3}"/>
              </a:ext>
            </a:extLst>
          </p:cNvPr>
          <p:cNvSpPr txBox="1"/>
          <p:nvPr/>
        </p:nvSpPr>
        <p:spPr>
          <a:xfrm>
            <a:off x="7540181" y="654399"/>
            <a:ext cx="302281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RA</a:t>
            </a:r>
            <a:r>
              <a:rPr lang="en-US" dirty="0"/>
              <a:t> cell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3F9AE42-3A7E-1C45-996C-85AFADD97FE1}"/>
              </a:ext>
            </a:extLst>
          </p:cNvPr>
          <p:cNvSpPr txBox="1"/>
          <p:nvPr/>
        </p:nvSpPr>
        <p:spPr>
          <a:xfrm>
            <a:off x="1838738" y="654399"/>
            <a:ext cx="274938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CD8+ CD69+ T</a:t>
            </a:r>
            <a:r>
              <a:rPr lang="en-US" baseline="-25000" dirty="0"/>
              <a:t>EM</a:t>
            </a:r>
            <a:r>
              <a:rPr lang="en-US" dirty="0"/>
              <a:t> cells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9A028696-3B28-994D-B59B-FA9E32CA9BD5}"/>
              </a:ext>
            </a:extLst>
          </p:cNvPr>
          <p:cNvCxnSpPr>
            <a:cxnSpLocks/>
          </p:cNvCxnSpPr>
          <p:nvPr/>
        </p:nvCxnSpPr>
        <p:spPr>
          <a:xfrm>
            <a:off x="4436402" y="1328913"/>
            <a:ext cx="24688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860B149A-0D56-B64B-B3C9-AFD651498CC9}"/>
              </a:ext>
            </a:extLst>
          </p:cNvPr>
          <p:cNvSpPr txBox="1"/>
          <p:nvPr/>
        </p:nvSpPr>
        <p:spPr>
          <a:xfrm>
            <a:off x="4925645" y="1558963"/>
            <a:ext cx="79139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p = 0.06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503C4B01-06DD-FB46-AE3A-CAE6952C7228}"/>
              </a:ext>
            </a:extLst>
          </p:cNvPr>
          <p:cNvCxnSpPr>
            <a:cxnSpLocks/>
          </p:cNvCxnSpPr>
          <p:nvPr/>
        </p:nvCxnSpPr>
        <p:spPr>
          <a:xfrm>
            <a:off x="5190216" y="1769308"/>
            <a:ext cx="248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5B43C22C-4934-0F44-9F21-27C7E4862B9A}"/>
              </a:ext>
            </a:extLst>
          </p:cNvPr>
          <p:cNvSpPr txBox="1"/>
          <p:nvPr/>
        </p:nvSpPr>
        <p:spPr>
          <a:xfrm>
            <a:off x="4337573" y="1118481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7567D24-05C6-FF4F-9816-58AE99165B93}"/>
              </a:ext>
            </a:extLst>
          </p:cNvPr>
          <p:cNvCxnSpPr>
            <a:cxnSpLocks/>
          </p:cNvCxnSpPr>
          <p:nvPr/>
        </p:nvCxnSpPr>
        <p:spPr>
          <a:xfrm flipV="1">
            <a:off x="1361660" y="2327882"/>
            <a:ext cx="477078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4425C731-F7BD-8243-95A6-B94F57A92D20}"/>
              </a:ext>
            </a:extLst>
          </p:cNvPr>
          <p:cNvCxnSpPr>
            <a:cxnSpLocks/>
          </p:cNvCxnSpPr>
          <p:nvPr/>
        </p:nvCxnSpPr>
        <p:spPr>
          <a:xfrm flipV="1">
            <a:off x="4444751" y="1023731"/>
            <a:ext cx="477078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338073CB-C3D8-6548-8132-4212576A903D}"/>
              </a:ext>
            </a:extLst>
          </p:cNvPr>
          <p:cNvSpPr txBox="1"/>
          <p:nvPr/>
        </p:nvSpPr>
        <p:spPr>
          <a:xfrm>
            <a:off x="4461017" y="801364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3070719-87CC-C546-A095-C034A4219A11}"/>
              </a:ext>
            </a:extLst>
          </p:cNvPr>
          <p:cNvSpPr txBox="1"/>
          <p:nvPr/>
        </p:nvSpPr>
        <p:spPr>
          <a:xfrm>
            <a:off x="1469183" y="2088240"/>
            <a:ext cx="262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2C500649-8954-8C49-BEF9-F02584F2963C}"/>
              </a:ext>
            </a:extLst>
          </p:cNvPr>
          <p:cNvCxnSpPr>
            <a:cxnSpLocks/>
          </p:cNvCxnSpPr>
          <p:nvPr/>
        </p:nvCxnSpPr>
        <p:spPr>
          <a:xfrm>
            <a:off x="4658675" y="1186920"/>
            <a:ext cx="24688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43BCD38D-078D-4D43-A43B-448E0CF1F13B}"/>
              </a:ext>
            </a:extLst>
          </p:cNvPr>
          <p:cNvCxnSpPr>
            <a:cxnSpLocks/>
          </p:cNvCxnSpPr>
          <p:nvPr/>
        </p:nvCxnSpPr>
        <p:spPr>
          <a:xfrm>
            <a:off x="5406534" y="1583778"/>
            <a:ext cx="24872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1FF40D18-A13B-E54F-8D5D-F042461A097A}"/>
              </a:ext>
            </a:extLst>
          </p:cNvPr>
          <p:cNvSpPr txBox="1"/>
          <p:nvPr/>
        </p:nvSpPr>
        <p:spPr>
          <a:xfrm>
            <a:off x="4382948" y="979722"/>
            <a:ext cx="803068" cy="2543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dirty="0"/>
              <a:t>p = 0.0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0A7BF68-B237-1844-AD06-5CA1CECD5AEC}"/>
              </a:ext>
            </a:extLst>
          </p:cNvPr>
          <p:cNvSpPr txBox="1"/>
          <p:nvPr/>
        </p:nvSpPr>
        <p:spPr>
          <a:xfrm>
            <a:off x="5308643" y="1358730"/>
            <a:ext cx="444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E5A09393-4B1E-664B-AFC9-91E1EB46DBAB}"/>
              </a:ext>
            </a:extLst>
          </p:cNvPr>
          <p:cNvCxnSpPr>
            <a:cxnSpLocks/>
          </p:cNvCxnSpPr>
          <p:nvPr/>
        </p:nvCxnSpPr>
        <p:spPr>
          <a:xfrm>
            <a:off x="9002824" y="1805483"/>
            <a:ext cx="248437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3C27FA0D-1B08-9749-BFF9-3B9E7343DC0B}"/>
              </a:ext>
            </a:extLst>
          </p:cNvPr>
          <p:cNvSpPr txBox="1"/>
          <p:nvPr/>
        </p:nvSpPr>
        <p:spPr>
          <a:xfrm>
            <a:off x="9041775" y="1587069"/>
            <a:ext cx="1705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CF25217-2B38-BA4B-B948-C2123A96F8C9}"/>
              </a:ext>
            </a:extLst>
          </p:cNvPr>
          <p:cNvSpPr txBox="1"/>
          <p:nvPr/>
        </p:nvSpPr>
        <p:spPr>
          <a:xfrm>
            <a:off x="161964" y="579645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53EF46D-EFAF-D340-9D4E-E327FC949F4C}"/>
              </a:ext>
            </a:extLst>
          </p:cNvPr>
          <p:cNvSpPr txBox="1"/>
          <p:nvPr/>
        </p:nvSpPr>
        <p:spPr>
          <a:xfrm>
            <a:off x="6033878" y="582188"/>
            <a:ext cx="4598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6DDFC4B4-C047-A340-94EE-92A5C37D4815}"/>
              </a:ext>
            </a:extLst>
          </p:cNvPr>
          <p:cNvSpPr/>
          <p:nvPr/>
        </p:nvSpPr>
        <p:spPr>
          <a:xfrm>
            <a:off x="0" y="5772968"/>
            <a:ext cx="1219200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Supplemental Fig 5. Protection associated multifunctional populations plus Granzyme B. A-F. </a:t>
            </a:r>
            <a:r>
              <a:rPr lang="en-US" sz="110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Winlist</a:t>
            </a:r>
            <a:r>
              <a:rPr lang="en-US" sz="1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FCOM identified selected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specific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multifunctional increases over baseline following co-culture with HLA-E restricted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Typhi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infected antigen presenting targets. These MF populations were selected based on those shown in a previous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.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yphi challenge study to be associated with protection from developing disease (10,11), plus Granzyme B expression following co-culture with HLA-E restricted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. Typhi infected antigen presenting targets. Results are shown for the following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A, C, E)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B, D, F)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100" baseline="-25000" dirty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populations: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A+B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6-15 year-old pediatric (n=10), 16-17 year-old pediatric (n=8) and adult participants;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C+D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male pediatric (ages 6-17; n=10), female pediatric (ages 11-17; n=8), male adult (n=7), and female adult (n=6) participants; as well as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F-E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HLA-E*01:01 (n=10), HLA-E*01:03 (n=6), and HLA-E heterozygous (n=12)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articipants. Bars represent medians with whiskers indicating interquartile ranges. Scatter plot statistics were analyzed by unpaired t-test. (* p&lt;0.05) </a:t>
            </a:r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DFA57EDF-785A-BD43-8A8B-ADE59FBDEDCA}"/>
              </a:ext>
            </a:extLst>
          </p:cNvPr>
          <p:cNvGrpSpPr/>
          <p:nvPr/>
        </p:nvGrpSpPr>
        <p:grpSpPr>
          <a:xfrm>
            <a:off x="10641541" y="1170696"/>
            <a:ext cx="1175391" cy="612464"/>
            <a:chOff x="7437119" y="1671362"/>
            <a:chExt cx="1175391" cy="612464"/>
          </a:xfrm>
        </p:grpSpPr>
        <p:sp>
          <p:nvSpPr>
            <p:cNvPr id="57" name="Oval 56">
              <a:extLst>
                <a:ext uri="{FF2B5EF4-FFF2-40B4-BE49-F238E27FC236}">
                  <a16:creationId xmlns:a16="http://schemas.microsoft.com/office/drawing/2014/main" id="{01AEE90F-22B3-7840-A8D5-3A2198636AD5}"/>
                </a:ext>
              </a:extLst>
            </p:cNvPr>
            <p:cNvSpPr/>
            <p:nvPr/>
          </p:nvSpPr>
          <p:spPr>
            <a:xfrm>
              <a:off x="7437119" y="1752600"/>
              <a:ext cx="91440" cy="91440"/>
            </a:xfrm>
            <a:prstGeom prst="ellipse">
              <a:avLst/>
            </a:prstGeom>
            <a:solidFill>
              <a:srgbClr val="0432FF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" name="Oval 57">
              <a:extLst>
                <a:ext uri="{FF2B5EF4-FFF2-40B4-BE49-F238E27FC236}">
                  <a16:creationId xmlns:a16="http://schemas.microsoft.com/office/drawing/2014/main" id="{3ED5EF5E-995F-5E42-8443-5758F432E077}"/>
                </a:ext>
              </a:extLst>
            </p:cNvPr>
            <p:cNvSpPr/>
            <p:nvPr/>
          </p:nvSpPr>
          <p:spPr>
            <a:xfrm>
              <a:off x="7437119" y="1933647"/>
              <a:ext cx="91440" cy="91440"/>
            </a:xfrm>
            <a:prstGeom prst="ellipse">
              <a:avLst/>
            </a:prstGeom>
            <a:solidFill>
              <a:srgbClr val="FF9300"/>
            </a:solidFill>
            <a:ln>
              <a:noFill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3F263FF-F5ED-7146-80A1-03E7F17D920A}"/>
                </a:ext>
              </a:extLst>
            </p:cNvPr>
            <p:cNvSpPr txBox="1"/>
            <p:nvPr/>
          </p:nvSpPr>
          <p:spPr>
            <a:xfrm>
              <a:off x="7528559" y="1671362"/>
              <a:ext cx="101502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err="1"/>
                <a:t>Yrs</a:t>
              </a:r>
              <a:r>
                <a:rPr lang="en-US" sz="1050" dirty="0"/>
                <a:t> 6-15 (n=10)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322AD2E-462F-D04A-BD82-11BB7E4668E8}"/>
                </a:ext>
              </a:extLst>
            </p:cNvPr>
            <p:cNvSpPr txBox="1"/>
            <p:nvPr/>
          </p:nvSpPr>
          <p:spPr>
            <a:xfrm>
              <a:off x="7528559" y="1852409"/>
              <a:ext cx="101502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err="1"/>
                <a:t>Yrs</a:t>
              </a:r>
              <a:r>
                <a:rPr lang="en-US" sz="1050" dirty="0"/>
                <a:t> 16-17 (n=8)</a:t>
              </a: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3D2DB917-8F33-614E-B7AF-0048F55A5BE1}"/>
                </a:ext>
              </a:extLst>
            </p:cNvPr>
            <p:cNvSpPr/>
            <p:nvPr/>
          </p:nvSpPr>
          <p:spPr>
            <a:xfrm>
              <a:off x="7437119" y="2106325"/>
              <a:ext cx="91440" cy="9144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ECC14E6-C644-814E-83A4-FA85ECD81347}"/>
                </a:ext>
              </a:extLst>
            </p:cNvPr>
            <p:cNvSpPr txBox="1"/>
            <p:nvPr/>
          </p:nvSpPr>
          <p:spPr>
            <a:xfrm>
              <a:off x="7528559" y="2029910"/>
              <a:ext cx="108395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 err="1"/>
                <a:t>Yrs</a:t>
              </a:r>
              <a:r>
                <a:rPr lang="en-US" sz="1050" dirty="0"/>
                <a:t> 20-65 (n=13)</a:t>
              </a: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48ADCB3A-8656-2F4B-9A41-C74D4921071F}"/>
              </a:ext>
            </a:extLst>
          </p:cNvPr>
          <p:cNvSpPr txBox="1"/>
          <p:nvPr/>
        </p:nvSpPr>
        <p:spPr>
          <a:xfrm rot="16200000">
            <a:off x="-808314" y="2087444"/>
            <a:ext cx="29107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AA8379AC-8B98-0B48-98AE-C1C5DB662806}"/>
              </a:ext>
            </a:extLst>
          </p:cNvPr>
          <p:cNvSpPr txBox="1"/>
          <p:nvPr/>
        </p:nvSpPr>
        <p:spPr>
          <a:xfrm rot="16200000">
            <a:off x="5098452" y="2087445"/>
            <a:ext cx="29107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Response Over Baseline (%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F983D43-81C9-B744-9CC6-1ACEC8FE973E}"/>
              </a:ext>
            </a:extLst>
          </p:cNvPr>
          <p:cNvSpPr txBox="1"/>
          <p:nvPr/>
        </p:nvSpPr>
        <p:spPr>
          <a:xfrm>
            <a:off x="-10489" y="-5126"/>
            <a:ext cx="239740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Supplemental Figure </a:t>
            </a:r>
            <a:r>
              <a:rPr lang="en-US" b="1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3503679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33</Words>
  <Application>Microsoft Office PowerPoint</Application>
  <PresentationFormat>Widescreen</PresentationFormat>
  <Paragraphs>809</Paragraphs>
  <Slides>20</Slides>
  <Notes>1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Frontiers Media SA</cp:lastModifiedBy>
  <cp:revision>11</cp:revision>
  <dcterms:created xsi:type="dcterms:W3CDTF">2018-07-20T16:58:32Z</dcterms:created>
  <dcterms:modified xsi:type="dcterms:W3CDTF">2019-02-12T08:03:50Z</dcterms:modified>
</cp:coreProperties>
</file>